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4" r:id="rId2"/>
    <p:sldId id="263" r:id="rId3"/>
    <p:sldId id="261" r:id="rId4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3E9F9"/>
    <a:srgbClr val="EBE3E1"/>
    <a:srgbClr val="E9DBF1"/>
    <a:srgbClr val="E1F0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13" autoAdjust="0"/>
    <p:restoredTop sz="93674"/>
  </p:normalViewPr>
  <p:slideViewPr>
    <p:cSldViewPr snapToGrid="0">
      <p:cViewPr varScale="1">
        <p:scale>
          <a:sx n="74" d="100"/>
          <a:sy n="74" d="100"/>
        </p:scale>
        <p:origin x="17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7329D9-501E-44BB-BA9A-07FFDBB320F4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8E8990-6DBB-43E3-B7CC-A8C334D3FB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98006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8E8990-6DBB-43E3-B7CC-A8C334D3FBD6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11811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201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2440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64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8320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065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3220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6748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890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919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0340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1623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57077-7C48-4255-9E79-F6E9E0E61D43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03D3E-6B1D-4B36-A2E5-0738658991F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3427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ZoneTexte 150">
            <a:extLst>
              <a:ext uri="{FF2B5EF4-FFF2-40B4-BE49-F238E27FC236}">
                <a16:creationId xmlns:a16="http://schemas.microsoft.com/office/drawing/2014/main" id="{CC64932F-AD5C-46F3-A1D9-00E92127E843}"/>
              </a:ext>
            </a:extLst>
          </p:cNvPr>
          <p:cNvSpPr txBox="1"/>
          <p:nvPr/>
        </p:nvSpPr>
        <p:spPr>
          <a:xfrm>
            <a:off x="5650576" y="476634"/>
            <a:ext cx="150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Family C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B3765087-65A0-472D-BF33-5274E1A712E5}"/>
              </a:ext>
            </a:extLst>
          </p:cNvPr>
          <p:cNvGrpSpPr/>
          <p:nvPr/>
        </p:nvGrpSpPr>
        <p:grpSpPr>
          <a:xfrm>
            <a:off x="509233" y="2123337"/>
            <a:ext cx="11783134" cy="5485511"/>
            <a:chOff x="509233" y="2123337"/>
            <a:chExt cx="11783134" cy="5485511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2775E045-2E12-416C-9482-66014335DFE1}"/>
                </a:ext>
              </a:extLst>
            </p:cNvPr>
            <p:cNvGrpSpPr/>
            <p:nvPr/>
          </p:nvGrpSpPr>
          <p:grpSpPr>
            <a:xfrm>
              <a:off x="509233" y="2123337"/>
              <a:ext cx="11783134" cy="5485511"/>
              <a:chOff x="509233" y="2123337"/>
              <a:chExt cx="11783134" cy="5485511"/>
            </a:xfrm>
          </p:grpSpPr>
          <p:cxnSp>
            <p:nvCxnSpPr>
              <p:cNvPr id="178" name="Connecteur droit 177">
                <a:extLst>
                  <a:ext uri="{FF2B5EF4-FFF2-40B4-BE49-F238E27FC236}">
                    <a16:creationId xmlns:a16="http://schemas.microsoft.com/office/drawing/2014/main" id="{43699952-EA8F-4551-95CE-FDC717B78F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7483" y="6241618"/>
                <a:ext cx="0" cy="225994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Ellipse 178">
                <a:extLst>
                  <a:ext uri="{FF2B5EF4-FFF2-40B4-BE49-F238E27FC236}">
                    <a16:creationId xmlns:a16="http://schemas.microsoft.com/office/drawing/2014/main" id="{FD026EB3-A81B-4B72-94AA-9AD199578ED2}"/>
                  </a:ext>
                </a:extLst>
              </p:cNvPr>
              <p:cNvSpPr/>
              <p:nvPr/>
            </p:nvSpPr>
            <p:spPr>
              <a:xfrm>
                <a:off x="1451650" y="6467612"/>
                <a:ext cx="431047" cy="415641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 dirty="0"/>
              </a:p>
            </p:txBody>
          </p:sp>
          <p:grpSp>
            <p:nvGrpSpPr>
              <p:cNvPr id="17" name="Groupe 16">
                <a:extLst>
                  <a:ext uri="{FF2B5EF4-FFF2-40B4-BE49-F238E27FC236}">
                    <a16:creationId xmlns:a16="http://schemas.microsoft.com/office/drawing/2014/main" id="{F18448DC-1305-4A0E-8B28-F775035C0773}"/>
                  </a:ext>
                </a:extLst>
              </p:cNvPr>
              <p:cNvGrpSpPr/>
              <p:nvPr/>
            </p:nvGrpSpPr>
            <p:grpSpPr>
              <a:xfrm>
                <a:off x="509233" y="2123337"/>
                <a:ext cx="11783134" cy="5485511"/>
                <a:chOff x="509233" y="2123337"/>
                <a:chExt cx="11783134" cy="5485511"/>
              </a:xfrm>
            </p:grpSpPr>
            <p:grpSp>
              <p:nvGrpSpPr>
                <p:cNvPr id="3" name="Groupe 2">
                  <a:extLst>
                    <a:ext uri="{FF2B5EF4-FFF2-40B4-BE49-F238E27FC236}">
                      <a16:creationId xmlns:a16="http://schemas.microsoft.com/office/drawing/2014/main" id="{F0313786-CEDD-4143-A39F-DB8CBDAA6FE1}"/>
                    </a:ext>
                  </a:extLst>
                </p:cNvPr>
                <p:cNvGrpSpPr/>
                <p:nvPr/>
              </p:nvGrpSpPr>
              <p:grpSpPr>
                <a:xfrm>
                  <a:off x="509233" y="2123337"/>
                  <a:ext cx="11783134" cy="5485511"/>
                  <a:chOff x="280652" y="3085375"/>
                  <a:chExt cx="11783134" cy="5485511"/>
                </a:xfrm>
              </p:grpSpPr>
              <p:grpSp>
                <p:nvGrpSpPr>
                  <p:cNvPr id="344" name="Groupe 343">
                    <a:extLst>
                      <a:ext uri="{FF2B5EF4-FFF2-40B4-BE49-F238E27FC236}">
                        <a16:creationId xmlns:a16="http://schemas.microsoft.com/office/drawing/2014/main" id="{2C31D3DF-C7B7-435C-BE8D-E37E88E3A350}"/>
                      </a:ext>
                    </a:extLst>
                  </p:cNvPr>
                  <p:cNvGrpSpPr/>
                  <p:nvPr/>
                </p:nvGrpSpPr>
                <p:grpSpPr>
                  <a:xfrm>
                    <a:off x="280652" y="3143407"/>
                    <a:ext cx="459714" cy="4898444"/>
                    <a:chOff x="298666" y="561660"/>
                    <a:chExt cx="459714" cy="4898444"/>
                  </a:xfrm>
                </p:grpSpPr>
                <p:sp>
                  <p:nvSpPr>
                    <p:cNvPr id="338" name="ZoneTexte 337">
                      <a:extLst>
                        <a:ext uri="{FF2B5EF4-FFF2-40B4-BE49-F238E27FC236}">
                          <a16:creationId xmlns:a16="http://schemas.microsoft.com/office/drawing/2014/main" id="{CDF40591-ED10-40B7-B907-EBD5BD3C6E1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1630" y="3537029"/>
                      <a:ext cx="45675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2000" b="1" dirty="0"/>
                        <a:t>III</a:t>
                      </a:r>
                      <a:endParaRPr lang="en-GB" sz="1400" b="1" dirty="0"/>
                    </a:p>
                  </p:txBody>
                </p:sp>
                <p:sp>
                  <p:nvSpPr>
                    <p:cNvPr id="339" name="ZoneTexte 338">
                      <a:extLst>
                        <a:ext uri="{FF2B5EF4-FFF2-40B4-BE49-F238E27FC236}">
                          <a16:creationId xmlns:a16="http://schemas.microsoft.com/office/drawing/2014/main" id="{F438A612-2874-47A9-83F7-25A1EDB8B7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8666" y="561660"/>
                      <a:ext cx="45675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2000" b="1" dirty="0"/>
                        <a:t>I</a:t>
                      </a:r>
                      <a:endParaRPr lang="en-GB" sz="1400" b="1" dirty="0"/>
                    </a:p>
                  </p:txBody>
                </p:sp>
                <p:sp>
                  <p:nvSpPr>
                    <p:cNvPr id="340" name="ZoneTexte 339">
                      <a:extLst>
                        <a:ext uri="{FF2B5EF4-FFF2-40B4-BE49-F238E27FC236}">
                          <a16:creationId xmlns:a16="http://schemas.microsoft.com/office/drawing/2014/main" id="{4C46C39D-73D6-4A10-AB80-C185BD887A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8666" y="2089390"/>
                      <a:ext cx="45675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2000" b="1" dirty="0"/>
                        <a:t>II</a:t>
                      </a:r>
                      <a:endParaRPr lang="en-GB" sz="1400" b="1" dirty="0"/>
                    </a:p>
                  </p:txBody>
                </p:sp>
                <p:sp>
                  <p:nvSpPr>
                    <p:cNvPr id="341" name="ZoneTexte 340">
                      <a:extLst>
                        <a:ext uri="{FF2B5EF4-FFF2-40B4-BE49-F238E27FC236}">
                          <a16:creationId xmlns:a16="http://schemas.microsoft.com/office/drawing/2014/main" id="{A674AC26-EF0D-498A-A24A-7501095520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8666" y="5059994"/>
                      <a:ext cx="45675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2000" b="1" dirty="0"/>
                        <a:t>IV</a:t>
                      </a:r>
                      <a:endParaRPr lang="en-GB" sz="1400" b="1" dirty="0"/>
                    </a:p>
                  </p:txBody>
                </p:sp>
              </p:grpSp>
              <p:grpSp>
                <p:nvGrpSpPr>
                  <p:cNvPr id="2" name="Groupe 1">
                    <a:extLst>
                      <a:ext uri="{FF2B5EF4-FFF2-40B4-BE49-F238E27FC236}">
                        <a16:creationId xmlns:a16="http://schemas.microsoft.com/office/drawing/2014/main" id="{71883FDE-9A3B-456A-BF50-DAEAB0B4B116}"/>
                      </a:ext>
                    </a:extLst>
                  </p:cNvPr>
                  <p:cNvGrpSpPr/>
                  <p:nvPr/>
                </p:nvGrpSpPr>
                <p:grpSpPr>
                  <a:xfrm>
                    <a:off x="914981" y="3085375"/>
                    <a:ext cx="11148805" cy="5485511"/>
                    <a:chOff x="914981" y="3085375"/>
                    <a:chExt cx="11148805" cy="5485511"/>
                  </a:xfrm>
                </p:grpSpPr>
                <p:grpSp>
                  <p:nvGrpSpPr>
                    <p:cNvPr id="345" name="Groupe 344">
                      <a:extLst>
                        <a:ext uri="{FF2B5EF4-FFF2-40B4-BE49-F238E27FC236}">
                          <a16:creationId xmlns:a16="http://schemas.microsoft.com/office/drawing/2014/main" id="{7FC193FC-ACE6-45E9-9F9A-838FB1FDFB2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14981" y="3783419"/>
                      <a:ext cx="11148805" cy="4787467"/>
                      <a:chOff x="900013" y="2738391"/>
                      <a:chExt cx="11148805" cy="4787467"/>
                    </a:xfrm>
                  </p:grpSpPr>
                  <p:grpSp>
                    <p:nvGrpSpPr>
                      <p:cNvPr id="169" name="Groupe 168">
                        <a:extLst>
                          <a:ext uri="{FF2B5EF4-FFF2-40B4-BE49-F238E27FC236}">
                            <a16:creationId xmlns:a16="http://schemas.microsoft.com/office/drawing/2014/main" id="{A71E1CA7-12F1-4AB3-BA52-D8804A235BCF}"/>
                          </a:ext>
                        </a:extLst>
                      </p:cNvPr>
                      <p:cNvGrpSpPr>
                        <a:grpSpLocks noChangeAspect="1"/>
                      </p:cNvGrpSpPr>
                      <p:nvPr/>
                    </p:nvGrpSpPr>
                    <p:grpSpPr>
                      <a:xfrm>
                        <a:off x="1159682" y="3570871"/>
                        <a:ext cx="5578630" cy="3239738"/>
                        <a:chOff x="1152731" y="3570872"/>
                        <a:chExt cx="4912679" cy="2852994"/>
                      </a:xfrm>
                    </p:grpSpPr>
                    <p:sp>
                      <p:nvSpPr>
                        <p:cNvPr id="147" name="Rectangle 146">
                          <a:extLst>
                            <a:ext uri="{FF2B5EF4-FFF2-40B4-BE49-F238E27FC236}">
                              <a16:creationId xmlns:a16="http://schemas.microsoft.com/office/drawing/2014/main" id="{E2EA83D3-8225-4A61-9BDC-525FC10A320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88012" y="4923912"/>
                          <a:ext cx="379591" cy="36602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 dirty="0"/>
                        </a:p>
                      </p:txBody>
                    </p:sp>
                    <p:cxnSp>
                      <p:nvCxnSpPr>
                        <p:cNvPr id="8" name="Connecteur droit 7">
                          <a:extLst>
                            <a:ext uri="{FF2B5EF4-FFF2-40B4-BE49-F238E27FC236}">
                              <a16:creationId xmlns:a16="http://schemas.microsoft.com/office/drawing/2014/main" id="{258304BC-9214-4638-B030-137A22A44AD2}"/>
                            </a:ext>
                          </a:extLst>
                        </p:cNvPr>
                        <p:cNvCxnSpPr>
                          <a:cxnSpLocks/>
                          <a:endCxn id="147" idx="0"/>
                        </p:cNvCxnSpPr>
                        <p:nvPr/>
                      </p:nvCxnSpPr>
                      <p:spPr>
                        <a:xfrm>
                          <a:off x="5077808" y="4682781"/>
                          <a:ext cx="0" cy="241131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" name="Connecteur droit 8">
                          <a:extLst>
                            <a:ext uri="{FF2B5EF4-FFF2-40B4-BE49-F238E27FC236}">
                              <a16:creationId xmlns:a16="http://schemas.microsoft.com/office/drawing/2014/main" id="{FEEF49C7-26BF-4DFA-8146-50C30ECEE68C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5871320" y="4671585"/>
                          <a:ext cx="0" cy="25200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0" name="Connecteur droit 9">
                          <a:extLst>
                            <a:ext uri="{FF2B5EF4-FFF2-40B4-BE49-F238E27FC236}">
                              <a16:creationId xmlns:a16="http://schemas.microsoft.com/office/drawing/2014/main" id="{617BF4BF-2B93-4AE3-B69E-EA19EEF960E0}"/>
                            </a:ext>
                          </a:extLst>
                        </p:cNvPr>
                        <p:cNvCxnSpPr>
                          <a:cxnSpLocks/>
                          <a:endCxn id="105" idx="0"/>
                        </p:cNvCxnSpPr>
                        <p:nvPr/>
                      </p:nvCxnSpPr>
                      <p:spPr>
                        <a:xfrm>
                          <a:off x="1429468" y="4671585"/>
                          <a:ext cx="0" cy="210646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1" name="Connecteur droit 10">
                          <a:extLst>
                            <a:ext uri="{FF2B5EF4-FFF2-40B4-BE49-F238E27FC236}">
                              <a16:creationId xmlns:a16="http://schemas.microsoft.com/office/drawing/2014/main" id="{7F74D278-76E2-42C9-831E-F382F767480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1429467" y="4676775"/>
                          <a:ext cx="4447458" cy="1089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" name="Connecteur droit 11">
                          <a:extLst>
                            <a:ext uri="{FF2B5EF4-FFF2-40B4-BE49-F238E27FC236}">
                              <a16:creationId xmlns:a16="http://schemas.microsoft.com/office/drawing/2014/main" id="{FD166A70-1B59-47E5-AEA8-2A453326E956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113872" y="4132904"/>
                          <a:ext cx="0" cy="538681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3" name="Connecteur droit 12">
                          <a:extLst>
                            <a:ext uri="{FF2B5EF4-FFF2-40B4-BE49-F238E27FC236}">
                              <a16:creationId xmlns:a16="http://schemas.microsoft.com/office/drawing/2014/main" id="{E204AE26-93C2-49E5-A104-465DA8312825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849985" y="4134483"/>
                          <a:ext cx="475926" cy="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34" name="Ellipse 133">
                          <a:extLst>
                            <a:ext uri="{FF2B5EF4-FFF2-40B4-BE49-F238E27FC236}">
                              <a16:creationId xmlns:a16="http://schemas.microsoft.com/office/drawing/2014/main" id="{C7B11F9F-CEED-4F46-B3E7-35812035995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31574" y="3570872"/>
                          <a:ext cx="379589" cy="366025"/>
                        </a:xfrm>
                        <a:prstGeom prst="ellipse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/>
                        </a:p>
                      </p:txBody>
                    </p:sp>
                    <p:sp>
                      <p:nvSpPr>
                        <p:cNvPr id="135" name="Rectangle 134">
                          <a:extLst>
                            <a:ext uri="{FF2B5EF4-FFF2-40B4-BE49-F238E27FC236}">
                              <a16:creationId xmlns:a16="http://schemas.microsoft.com/office/drawing/2014/main" id="{90DC6AD6-74F4-45AB-900F-B22F3E19B24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664734" y="3570872"/>
                          <a:ext cx="379589" cy="366025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 dirty="0"/>
                        </a:p>
                      </p:txBody>
                    </p:sp>
                    <p:cxnSp>
                      <p:nvCxnSpPr>
                        <p:cNvPr id="136" name="Connecteur droit 135">
                          <a:extLst>
                            <a:ext uri="{FF2B5EF4-FFF2-40B4-BE49-F238E27FC236}">
                              <a16:creationId xmlns:a16="http://schemas.microsoft.com/office/drawing/2014/main" id="{5626C62C-92D9-4BFE-AA35-3F377E8A4F5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854529" y="3936897"/>
                          <a:ext cx="0" cy="199512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37" name="Connecteur droit 136">
                          <a:extLst>
                            <a:ext uri="{FF2B5EF4-FFF2-40B4-BE49-F238E27FC236}">
                              <a16:creationId xmlns:a16="http://schemas.microsoft.com/office/drawing/2014/main" id="{44D314B2-EA87-40ED-9A9E-0562F5EF388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321369" y="3936897"/>
                          <a:ext cx="0" cy="199512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16" name="Ellipse 115">
                          <a:extLst>
                            <a:ext uri="{FF2B5EF4-FFF2-40B4-BE49-F238E27FC236}">
                              <a16:creationId xmlns:a16="http://schemas.microsoft.com/office/drawing/2014/main" id="{38DEC09E-399A-4232-834A-B6594C0AB23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685818" y="4915064"/>
                          <a:ext cx="379592" cy="366025"/>
                        </a:xfrm>
                        <a:prstGeom prst="ellipse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/>
                        </a:p>
                      </p:txBody>
                    </p:sp>
                    <p:grpSp>
                      <p:nvGrpSpPr>
                        <p:cNvPr id="87" name="Groupe 86">
                          <a:extLst>
                            <a:ext uri="{FF2B5EF4-FFF2-40B4-BE49-F238E27FC236}">
                              <a16:creationId xmlns:a16="http://schemas.microsoft.com/office/drawing/2014/main" id="{8482B8AB-79AE-4E27-9776-D3668F9A253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239671" y="4833584"/>
                          <a:ext cx="1607384" cy="1570601"/>
                          <a:chOff x="4896911" y="5670659"/>
                          <a:chExt cx="2585937" cy="2641179"/>
                        </a:xfrm>
                      </p:grpSpPr>
                      <p:grpSp>
                        <p:nvGrpSpPr>
                          <p:cNvPr id="88" name="Groupe 87">
                            <a:extLst>
                              <a:ext uri="{FF2B5EF4-FFF2-40B4-BE49-F238E27FC236}">
                                <a16:creationId xmlns:a16="http://schemas.microsoft.com/office/drawing/2014/main" id="{C584DA11-4D55-4F34-AFCD-70C0F855666D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4896911" y="5670659"/>
                            <a:ext cx="2585937" cy="1033690"/>
                            <a:chOff x="4896911" y="5670659"/>
                            <a:chExt cx="2585937" cy="1033690"/>
                          </a:xfrm>
                        </p:grpSpPr>
                        <p:sp>
                          <p:nvSpPr>
                            <p:cNvPr id="98" name="Rectangle 97">
                              <a:extLst>
                                <a:ext uri="{FF2B5EF4-FFF2-40B4-BE49-F238E27FC236}">
                                  <a16:creationId xmlns:a16="http://schemas.microsoft.com/office/drawing/2014/main" id="{FD23695E-4C20-4F3B-B6A3-1B1C5E5C3837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5719701" y="5753322"/>
                              <a:ext cx="610681" cy="615522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sp>
                          <p:nvSpPr>
                            <p:cNvPr id="99" name="Rectangle 98">
                              <a:extLst>
                                <a:ext uri="{FF2B5EF4-FFF2-40B4-BE49-F238E27FC236}">
                                  <a16:creationId xmlns:a16="http://schemas.microsoft.com/office/drawing/2014/main" id="{59F21761-7176-41FB-9A5A-F0EA29B817D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6872167" y="5759214"/>
                              <a:ext cx="610681" cy="615522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cxnSp>
                          <p:nvCxnSpPr>
                            <p:cNvPr id="100" name="Connecteur droit 99">
                              <a:extLst>
                                <a:ext uri="{FF2B5EF4-FFF2-40B4-BE49-F238E27FC236}">
                                  <a16:creationId xmlns:a16="http://schemas.microsoft.com/office/drawing/2014/main" id="{01850D2E-F76D-4908-93B9-6E9087036FFD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flipV="1">
                              <a:off x="5653808" y="5670659"/>
                              <a:ext cx="746552" cy="760775"/>
                            </a:xfrm>
                            <a:prstGeom prst="line">
                              <a:avLst/>
                            </a:prstGeom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01" name="Connecteur droit 100">
                              <a:extLst>
                                <a:ext uri="{FF2B5EF4-FFF2-40B4-BE49-F238E27FC236}">
                                  <a16:creationId xmlns:a16="http://schemas.microsoft.com/office/drawing/2014/main" id="{5C680CB3-EF32-47D5-BEF1-CAF0F0218238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5186298" y="6361867"/>
                              <a:ext cx="0" cy="335505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02" name="Connecteur droit 101">
                              <a:extLst>
                                <a:ext uri="{FF2B5EF4-FFF2-40B4-BE49-F238E27FC236}">
                                  <a16:creationId xmlns:a16="http://schemas.microsoft.com/office/drawing/2014/main" id="{D4096F7D-78F2-40C5-927B-DED844CEB2DB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6025041" y="6364431"/>
                              <a:ext cx="0" cy="335505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03" name="Connecteur droit 102">
                              <a:extLst>
                                <a:ext uri="{FF2B5EF4-FFF2-40B4-BE49-F238E27FC236}">
                                  <a16:creationId xmlns:a16="http://schemas.microsoft.com/office/drawing/2014/main" id="{EE5F6018-2852-464E-B982-713D3097D20A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7189529" y="6368844"/>
                              <a:ext cx="0" cy="335505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104" name="Connecteur droit 103">
                              <a:extLst>
                                <a:ext uri="{FF2B5EF4-FFF2-40B4-BE49-F238E27FC236}">
                                  <a16:creationId xmlns:a16="http://schemas.microsoft.com/office/drawing/2014/main" id="{EC03B32F-1DA2-44A1-9483-5CCBB9698549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5173529" y="6701891"/>
                              <a:ext cx="2016000" cy="0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105" name="Ellipse 104">
                              <a:extLst>
                                <a:ext uri="{FF2B5EF4-FFF2-40B4-BE49-F238E27FC236}">
                                  <a16:creationId xmlns:a16="http://schemas.microsoft.com/office/drawing/2014/main" id="{095F4C9E-B057-4602-AA7D-F5FB36DB189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4896911" y="5752464"/>
                              <a:ext cx="610681" cy="615522"/>
                            </a:xfrm>
                            <a:prstGeom prst="ellipse">
                              <a:avLst/>
                            </a:prstGeom>
                            <a:solidFill>
                              <a:schemeClr val="tx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</p:grpSp>
                      <p:grpSp>
                        <p:nvGrpSpPr>
                          <p:cNvPr id="89" name="Groupe 88">
                            <a:extLst>
                              <a:ext uri="{FF2B5EF4-FFF2-40B4-BE49-F238E27FC236}">
                                <a16:creationId xmlns:a16="http://schemas.microsoft.com/office/drawing/2014/main" id="{6F213110-FB08-48DA-8F0F-5C8C973B191E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5130981" y="6683724"/>
                            <a:ext cx="2113923" cy="1628114"/>
                            <a:chOff x="5130981" y="6683724"/>
                            <a:chExt cx="2113923" cy="1628114"/>
                          </a:xfrm>
                        </p:grpSpPr>
                        <p:grpSp>
                          <p:nvGrpSpPr>
                            <p:cNvPr id="90" name="Groupe 89">
                              <a:extLst>
                                <a:ext uri="{FF2B5EF4-FFF2-40B4-BE49-F238E27FC236}">
                                  <a16:creationId xmlns:a16="http://schemas.microsoft.com/office/drawing/2014/main" id="{9AE6F96F-8244-45C7-8633-EE598308EE8D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5130981" y="6713410"/>
                              <a:ext cx="1202014" cy="1593832"/>
                              <a:chOff x="5130981" y="6713410"/>
                              <a:chExt cx="1202014" cy="1593832"/>
                            </a:xfrm>
                          </p:grpSpPr>
                          <p:cxnSp>
                            <p:nvCxnSpPr>
                              <p:cNvPr id="94" name="Connecteur droit 93">
                                <a:extLst>
                                  <a:ext uri="{FF2B5EF4-FFF2-40B4-BE49-F238E27FC236}">
                                    <a16:creationId xmlns:a16="http://schemas.microsoft.com/office/drawing/2014/main" id="{15188B8E-0274-4011-A901-E2BE4BF432D0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6025041" y="7394740"/>
                                <a:ext cx="0" cy="334673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95" name="Connecteur droit 94">
                                <a:extLst>
                                  <a:ext uri="{FF2B5EF4-FFF2-40B4-BE49-F238E27FC236}">
                                    <a16:creationId xmlns:a16="http://schemas.microsoft.com/office/drawing/2014/main" id="{D1A2F0A4-2E85-48AC-B2B4-F7E31C7E61A3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130981" y="7380091"/>
                                <a:ext cx="918045" cy="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96" name="Ellipse 95">
                                <a:extLst>
                                  <a:ext uri="{FF2B5EF4-FFF2-40B4-BE49-F238E27FC236}">
                                    <a16:creationId xmlns:a16="http://schemas.microsoft.com/office/drawing/2014/main" id="{4B7CE188-268B-46B3-A531-9208B9ACDCDA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5722315" y="7691723"/>
                                <a:ext cx="610680" cy="615519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tx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2560" dirty="0"/>
                              </a:p>
                            </p:txBody>
                          </p:sp>
                          <p:cxnSp>
                            <p:nvCxnSpPr>
                              <p:cNvPr id="97" name="Connecteur droit 96">
                                <a:extLst>
                                  <a:ext uri="{FF2B5EF4-FFF2-40B4-BE49-F238E27FC236}">
                                    <a16:creationId xmlns:a16="http://schemas.microsoft.com/office/drawing/2014/main" id="{9292FF49-7C0C-4242-AD86-530670C232CB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586412" y="6713410"/>
                                <a:ext cx="0" cy="684000"/>
                              </a:xfrm>
                              <a:prstGeom prst="line">
                                <a:avLst/>
                              </a:prstGeom>
                              <a:ln w="19050"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91" name="Rectangle 90">
                              <a:extLst>
                                <a:ext uri="{FF2B5EF4-FFF2-40B4-BE49-F238E27FC236}">
                                  <a16:creationId xmlns:a16="http://schemas.microsoft.com/office/drawing/2014/main" id="{5136E4E4-A7FD-4D8B-86D3-169F6028022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6634223" y="7696316"/>
                              <a:ext cx="610681" cy="615522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cxnSp>
                          <p:nvCxnSpPr>
                            <p:cNvPr id="92" name="Connecteur droit 91">
                              <a:extLst>
                                <a:ext uri="{FF2B5EF4-FFF2-40B4-BE49-F238E27FC236}">
                                  <a16:creationId xmlns:a16="http://schemas.microsoft.com/office/drawing/2014/main" id="{81540E0E-8434-4FF9-A541-C02D2967E302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6939563" y="6683724"/>
                              <a:ext cx="0" cy="1008000"/>
                            </a:xfrm>
                            <a:prstGeom prst="line">
                              <a:avLst/>
                            </a:prstGeom>
                            <a:ln w="19050"/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</p:grpSp>
                    <p:cxnSp>
                      <p:nvCxnSpPr>
                        <p:cNvPr id="35" name="Connecteur droit 34">
                          <a:extLst>
                            <a:ext uri="{FF2B5EF4-FFF2-40B4-BE49-F238E27FC236}">
                              <a16:creationId xmlns:a16="http://schemas.microsoft.com/office/drawing/2014/main" id="{05494810-33A9-490E-8395-29A8E9E38BE6}"/>
                            </a:ext>
                          </a:extLst>
                        </p:cNvPr>
                        <p:cNvCxnSpPr>
                          <a:cxnSpLocks/>
                          <a:endCxn id="31" idx="0"/>
                        </p:cNvCxnSpPr>
                        <p:nvPr/>
                      </p:nvCxnSpPr>
                      <p:spPr>
                        <a:xfrm>
                          <a:off x="3890174" y="4682224"/>
                          <a:ext cx="0" cy="236752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157" name="Groupe 156">
                          <a:extLst>
                            <a:ext uri="{FF2B5EF4-FFF2-40B4-BE49-F238E27FC236}">
                              <a16:creationId xmlns:a16="http://schemas.microsoft.com/office/drawing/2014/main" id="{13A2ADF9-3E72-4978-B927-FD26B1B9B45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700378" y="4918976"/>
                          <a:ext cx="1873520" cy="1504890"/>
                          <a:chOff x="5700976" y="4713789"/>
                          <a:chExt cx="1873520" cy="1504890"/>
                        </a:xfrm>
                      </p:grpSpPr>
                      <p:grpSp>
                        <p:nvGrpSpPr>
                          <p:cNvPr id="156" name="Groupe 155">
                            <a:extLst>
                              <a:ext uri="{FF2B5EF4-FFF2-40B4-BE49-F238E27FC236}">
                                <a16:creationId xmlns:a16="http://schemas.microsoft.com/office/drawing/2014/main" id="{C75612D4-3B43-4240-A409-1A4BC4059F70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5700976" y="4713789"/>
                            <a:ext cx="869584" cy="367011"/>
                            <a:chOff x="5700976" y="4713789"/>
                            <a:chExt cx="869584" cy="367011"/>
                          </a:xfrm>
                        </p:grpSpPr>
                        <p:sp>
                          <p:nvSpPr>
                            <p:cNvPr id="27" name="Rectangle 26">
                              <a:extLst>
                                <a:ext uri="{FF2B5EF4-FFF2-40B4-BE49-F238E27FC236}">
                                  <a16:creationId xmlns:a16="http://schemas.microsoft.com/office/drawing/2014/main" id="{7B40EDF1-21CA-4577-A0BD-E9A021206E2E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6190969" y="4714774"/>
                              <a:ext cx="379591" cy="366026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sp>
                          <p:nvSpPr>
                            <p:cNvPr id="31" name="Ellipse 30">
                              <a:extLst>
                                <a:ext uri="{FF2B5EF4-FFF2-40B4-BE49-F238E27FC236}">
                                  <a16:creationId xmlns:a16="http://schemas.microsoft.com/office/drawing/2014/main" id="{B8DB92DA-7821-4B75-8E3E-6C71C81B4814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5700976" y="4713789"/>
                              <a:ext cx="379591" cy="366026"/>
                            </a:xfrm>
                            <a:prstGeom prst="ellipse">
                              <a:avLst/>
                            </a:prstGeom>
                            <a:solidFill>
                              <a:schemeClr val="bg2">
                                <a:lumMod val="75000"/>
                              </a:schemeClr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/>
                            </a:p>
                          </p:txBody>
                        </p:sp>
                      </p:grpSp>
                      <p:grpSp>
                        <p:nvGrpSpPr>
                          <p:cNvPr id="155" name="Groupe 154">
                            <a:extLst>
                              <a:ext uri="{FF2B5EF4-FFF2-40B4-BE49-F238E27FC236}">
                                <a16:creationId xmlns:a16="http://schemas.microsoft.com/office/drawing/2014/main" id="{D58F8FFF-A348-43FD-BD26-135D7AE52BA4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5881825" y="5077945"/>
                            <a:ext cx="1692671" cy="1140734"/>
                            <a:chOff x="5881825" y="5077945"/>
                            <a:chExt cx="1692671" cy="1140734"/>
                          </a:xfrm>
                        </p:grpSpPr>
                        <p:sp>
                          <p:nvSpPr>
                            <p:cNvPr id="39" name="Ellipse 38">
                              <a:extLst>
                                <a:ext uri="{FF2B5EF4-FFF2-40B4-BE49-F238E27FC236}">
                                  <a16:creationId xmlns:a16="http://schemas.microsoft.com/office/drawing/2014/main" id="{F3670C67-18AA-4E97-93C9-78E35009AAB3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7194905" y="5843544"/>
                              <a:ext cx="379591" cy="366024"/>
                            </a:xfrm>
                            <a:prstGeom prst="ellipse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grpSp>
                          <p:nvGrpSpPr>
                            <p:cNvPr id="154" name="Groupe 153">
                              <a:extLst>
                                <a:ext uri="{FF2B5EF4-FFF2-40B4-BE49-F238E27FC236}">
                                  <a16:creationId xmlns:a16="http://schemas.microsoft.com/office/drawing/2014/main" id="{98DD4C46-B729-4C16-8668-58E718972051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5881825" y="5077945"/>
                              <a:ext cx="1488661" cy="1140734"/>
                              <a:chOff x="5881825" y="5077945"/>
                              <a:chExt cx="1488661" cy="1140734"/>
                            </a:xfrm>
                          </p:grpSpPr>
                          <p:cxnSp>
                            <p:nvCxnSpPr>
                              <p:cNvPr id="26" name="Connecteur droit 25">
                                <a:extLst>
                                  <a:ext uri="{FF2B5EF4-FFF2-40B4-BE49-F238E27FC236}">
                                    <a16:creationId xmlns:a16="http://schemas.microsoft.com/office/drawing/2014/main" id="{3206DC8A-1E1C-4A43-AAE7-FF56B5CC7BEC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6136490" y="5649286"/>
                                <a:ext cx="1441" cy="203367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8" name="Connecteur droit 27">
                                <a:extLst>
                                  <a:ext uri="{FF2B5EF4-FFF2-40B4-BE49-F238E27FC236}">
                                    <a16:creationId xmlns:a16="http://schemas.microsoft.com/office/drawing/2014/main" id="{B76E082B-175F-4C2C-81D1-2F63C9C16E81}"/>
                                  </a:ext>
                                </a:extLst>
                              </p:cNvPr>
                              <p:cNvCxnSpPr>
                                <a:cxnSpLocks/>
                                <a:stCxn id="31" idx="4"/>
                              </p:cNvCxnSpPr>
                              <p:nvPr/>
                            </p:nvCxnSpPr>
                            <p:spPr>
                              <a:xfrm>
                                <a:off x="5890772" y="5079815"/>
                                <a:ext cx="0" cy="197641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9" name="Connecteur droit 28">
                                <a:extLst>
                                  <a:ext uri="{FF2B5EF4-FFF2-40B4-BE49-F238E27FC236}">
                                    <a16:creationId xmlns:a16="http://schemas.microsoft.com/office/drawing/2014/main" id="{D70526DA-7C31-4F9A-81CC-F9B8950C42DE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6382725" y="5077945"/>
                                <a:ext cx="0" cy="570645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0" name="Connecteur droit 29">
                                <a:extLst>
                                  <a:ext uri="{FF2B5EF4-FFF2-40B4-BE49-F238E27FC236}">
                                    <a16:creationId xmlns:a16="http://schemas.microsoft.com/office/drawing/2014/main" id="{41A9A882-3D08-4FCC-971D-B19A0B4849F6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881825" y="5277456"/>
                                <a:ext cx="507240" cy="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2" name="Connecteur droit 31">
                                <a:extLst>
                                  <a:ext uri="{FF2B5EF4-FFF2-40B4-BE49-F238E27FC236}">
                                    <a16:creationId xmlns:a16="http://schemas.microsoft.com/office/drawing/2014/main" id="{93C08808-1E75-4939-BE09-C887CBD2C501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6136490" y="5652867"/>
                                <a:ext cx="840115" cy="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33" name="Ellipse 32">
                                <a:extLst>
                                  <a:ext uri="{FF2B5EF4-FFF2-40B4-BE49-F238E27FC236}">
                                    <a16:creationId xmlns:a16="http://schemas.microsoft.com/office/drawing/2014/main" id="{0A13A58B-EF3F-44B5-AD30-01992B706BDE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6355029" y="5843854"/>
                                <a:ext cx="379591" cy="366024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2560" dirty="0"/>
                              </a:p>
                            </p:txBody>
                          </p:sp>
                          <p:sp>
                            <p:nvSpPr>
                              <p:cNvPr id="36" name="Ellipse 35">
                                <a:extLst>
                                  <a:ext uri="{FF2B5EF4-FFF2-40B4-BE49-F238E27FC236}">
                                    <a16:creationId xmlns:a16="http://schemas.microsoft.com/office/drawing/2014/main" id="{1C183CD7-2811-4CA6-96EA-593012174F2D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6775721" y="5852655"/>
                                <a:ext cx="379591" cy="366024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2560" dirty="0"/>
                              </a:p>
                            </p:txBody>
                          </p:sp>
                          <p:cxnSp>
                            <p:nvCxnSpPr>
                              <p:cNvPr id="37" name="Connecteur droit 36">
                                <a:extLst>
                                  <a:ext uri="{FF2B5EF4-FFF2-40B4-BE49-F238E27FC236}">
                                    <a16:creationId xmlns:a16="http://schemas.microsoft.com/office/drawing/2014/main" id="{97281117-E93E-4229-A57C-D8DD8177FFBA}"/>
                                  </a:ext>
                                </a:extLst>
                              </p:cNvPr>
                              <p:cNvCxnSpPr>
                                <a:cxnSpLocks/>
                                <a:stCxn id="33" idx="0"/>
                              </p:cNvCxnSpPr>
                              <p:nvPr/>
                            </p:nvCxnSpPr>
                            <p:spPr>
                              <a:xfrm flipV="1">
                                <a:off x="6544826" y="5655229"/>
                                <a:ext cx="406893" cy="188626"/>
                              </a:xfrm>
                              <a:prstGeom prst="line">
                                <a:avLst/>
                              </a:prstGeom>
                              <a:ln w="19050"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8" name="Connecteur droit 37">
                                <a:extLst>
                                  <a:ext uri="{FF2B5EF4-FFF2-40B4-BE49-F238E27FC236}">
                                    <a16:creationId xmlns:a16="http://schemas.microsoft.com/office/drawing/2014/main" id="{87158C42-591D-49E4-BB5C-B9D2C9845316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6963593" y="5650518"/>
                                <a:ext cx="406893" cy="188626"/>
                              </a:xfrm>
                              <a:prstGeom prst="line">
                                <a:avLst/>
                              </a:prstGeom>
                              <a:ln w="19050"/>
                            </p:spPr>
                            <p:style>
                              <a:lnRef idx="1">
                                <a:schemeClr val="dk1"/>
                              </a:lnRef>
                              <a:fillRef idx="0">
                                <a:schemeClr val="dk1"/>
                              </a:fillRef>
                              <a:effectRef idx="0">
                                <a:schemeClr val="dk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40" name="Connecteur droit 39">
                                <a:extLst>
                                  <a:ext uri="{FF2B5EF4-FFF2-40B4-BE49-F238E27FC236}">
                                    <a16:creationId xmlns:a16="http://schemas.microsoft.com/office/drawing/2014/main" id="{D7300926-46FB-4DDA-9FF0-C41CE9D83FD8}"/>
                                  </a:ext>
                                </a:extLst>
                              </p:cNvPr>
                              <p:cNvCxnSpPr>
                                <a:cxnSpLocks/>
                                <a:endCxn id="36" idx="0"/>
                              </p:cNvCxnSpPr>
                              <p:nvPr/>
                            </p:nvCxnSpPr>
                            <p:spPr>
                              <a:xfrm>
                                <a:off x="6965518" y="5655226"/>
                                <a:ext cx="0" cy="197427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41" name="Rectangle 40">
                                <a:extLst>
                                  <a:ext uri="{FF2B5EF4-FFF2-40B4-BE49-F238E27FC236}">
                                    <a16:creationId xmlns:a16="http://schemas.microsoft.com/office/drawing/2014/main" id="{644827BF-353A-488E-A2A0-5EE1E4A5E74C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5945650" y="5832973"/>
                                <a:ext cx="379590" cy="366024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2560" dirty="0"/>
                              </a:p>
                            </p:txBody>
                          </p:sp>
                        </p:grpSp>
                      </p:grpSp>
                    </p:grpSp>
                    <p:cxnSp>
                      <p:nvCxnSpPr>
                        <p:cNvPr id="152" name="Connecteur droit avec flèche 151">
                          <a:extLst>
                            <a:ext uri="{FF2B5EF4-FFF2-40B4-BE49-F238E27FC236}">
                              <a16:creationId xmlns:a16="http://schemas.microsoft.com/office/drawing/2014/main" id="{29AE1D93-D8DC-426C-80F9-B2CFD075EDE7}"/>
                            </a:ext>
                          </a:extLst>
                        </p:cNvPr>
                        <p:cNvCxnSpPr>
                          <a:cxnSpLocks/>
                          <a:endCxn id="105" idx="3"/>
                        </p:cNvCxnSpPr>
                        <p:nvPr/>
                      </p:nvCxnSpPr>
                      <p:spPr>
                        <a:xfrm flipV="1">
                          <a:off x="1152731" y="5194653"/>
                          <a:ext cx="142532" cy="153870"/>
                        </a:xfrm>
                        <a:prstGeom prst="straightConnector1">
                          <a:avLst/>
                        </a:prstGeom>
                        <a:ln w="28575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6" name="ZoneTexte 165">
                          <a:extLst>
                            <a:ext uri="{FF2B5EF4-FFF2-40B4-BE49-F238E27FC236}">
                              <a16:creationId xmlns:a16="http://schemas.microsoft.com/office/drawing/2014/main" id="{15D8540C-6353-48AE-8C0B-1E29CC00D33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44026" y="4943993"/>
                          <a:ext cx="275753" cy="32524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fr-FR" dirty="0"/>
                            <a:t>5</a:t>
                          </a:r>
                        </a:p>
                      </p:txBody>
                    </p:sp>
                    <p:sp>
                      <p:nvSpPr>
                        <p:cNvPr id="167" name="ZoneTexte 166">
                          <a:extLst>
                            <a:ext uri="{FF2B5EF4-FFF2-40B4-BE49-F238E27FC236}">
                              <a16:creationId xmlns:a16="http://schemas.microsoft.com/office/drawing/2014/main" id="{041BE268-B6F1-4573-AEDA-14D0C981B72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37735" y="4929720"/>
                          <a:ext cx="275753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fr-FR" dirty="0"/>
                            <a:t>2</a:t>
                          </a:r>
                        </a:p>
                      </p:txBody>
                    </p:sp>
                  </p:grpSp>
                  <p:sp>
                    <p:nvSpPr>
                      <p:cNvPr id="168" name="ZoneTexte 167">
                        <a:extLst>
                          <a:ext uri="{FF2B5EF4-FFF2-40B4-BE49-F238E27FC236}">
                            <a16:creationId xmlns:a16="http://schemas.microsoft.com/office/drawing/2014/main" id="{5858428A-9E17-462F-BCA5-DC0E9E30F70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62041" y="5734227"/>
                        <a:ext cx="1328979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Multinodular goitre</a:t>
                        </a:r>
                      </a:p>
                    </p:txBody>
                  </p:sp>
                  <p:sp>
                    <p:nvSpPr>
                      <p:cNvPr id="174" name="ZoneTexte 173">
                        <a:extLst>
                          <a:ext uri="{FF2B5EF4-FFF2-40B4-BE49-F238E27FC236}">
                            <a16:creationId xmlns:a16="http://schemas.microsoft.com/office/drawing/2014/main" id="{796E2EA9-EAAE-4C4D-B1E9-FBAE25DFC48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00013" y="5597244"/>
                        <a:ext cx="572873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PTC</a:t>
                        </a:r>
                      </a:p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(49)</a:t>
                        </a:r>
                      </a:p>
                    </p:txBody>
                  </p:sp>
                  <p:sp>
                    <p:nvSpPr>
                      <p:cNvPr id="175" name="ZoneTexte 174">
                        <a:extLst>
                          <a:ext uri="{FF2B5EF4-FFF2-40B4-BE49-F238E27FC236}">
                            <a16:creationId xmlns:a16="http://schemas.microsoft.com/office/drawing/2014/main" id="{06539A7F-EAB9-4D1A-BB51-AA5433DC7F0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42100" y="7034698"/>
                        <a:ext cx="572873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PTC</a:t>
                        </a:r>
                      </a:p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(26)</a:t>
                        </a:r>
                      </a:p>
                    </p:txBody>
                  </p:sp>
                  <p:sp>
                    <p:nvSpPr>
                      <p:cNvPr id="176" name="ZoneTexte 175">
                        <a:extLst>
                          <a:ext uri="{FF2B5EF4-FFF2-40B4-BE49-F238E27FC236}">
                            <a16:creationId xmlns:a16="http://schemas.microsoft.com/office/drawing/2014/main" id="{165AF8B4-5DA5-41B1-9B3E-B1E82EF7967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97346" y="7034698"/>
                        <a:ext cx="572873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PTC</a:t>
                        </a:r>
                      </a:p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(29)</a:t>
                        </a:r>
                      </a:p>
                    </p:txBody>
                  </p:sp>
                  <p:cxnSp>
                    <p:nvCxnSpPr>
                      <p:cNvPr id="177" name="Connecteur droit 176">
                        <a:extLst>
                          <a:ext uri="{FF2B5EF4-FFF2-40B4-BE49-F238E27FC236}">
                            <a16:creationId xmlns:a16="http://schemas.microsoft.com/office/drawing/2014/main" id="{AED0A88C-55C3-4E1B-84E8-2C751FF03A3B}"/>
                          </a:ext>
                        </a:extLst>
                      </p:cNvPr>
                      <p:cNvCxnSpPr>
                        <a:cxnSpLocks/>
                        <a:endCxn id="134" idx="0"/>
                      </p:cNvCxnSpPr>
                      <p:nvPr/>
                    </p:nvCxnSpPr>
                    <p:spPr>
                      <a:xfrm>
                        <a:off x="3622294" y="3359137"/>
                        <a:ext cx="1" cy="21173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4" name="Connecteur droit 193">
                        <a:extLst>
                          <a:ext uri="{FF2B5EF4-FFF2-40B4-BE49-F238E27FC236}">
                            <a16:creationId xmlns:a16="http://schemas.microsoft.com/office/drawing/2014/main" id="{A65D0F42-2857-4DB5-9D69-6227E98AD73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617136" y="3367637"/>
                        <a:ext cx="81720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56" name="Ellipse 255">
                        <a:extLst>
                          <a:ext uri="{FF2B5EF4-FFF2-40B4-BE49-F238E27FC236}">
                            <a16:creationId xmlns:a16="http://schemas.microsoft.com/office/drawing/2014/main" id="{EE6A148F-8617-4F26-A780-88B657C49B1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052803" y="3577161"/>
                        <a:ext cx="431045" cy="415642"/>
                      </a:xfrm>
                      <a:prstGeom prst="ellips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/>
                      </a:p>
                    </p:txBody>
                  </p:sp>
                  <p:cxnSp>
                    <p:nvCxnSpPr>
                      <p:cNvPr id="257" name="Connecteur droit 256">
                        <a:extLst>
                          <a:ext uri="{FF2B5EF4-FFF2-40B4-BE49-F238E27FC236}">
                            <a16:creationId xmlns:a16="http://schemas.microsoft.com/office/drawing/2014/main" id="{53B2B0F5-923D-487C-95A6-3C8FD266F21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7268326" y="3365427"/>
                        <a:ext cx="1" cy="21173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59" name="Connecteur droit 258">
                        <a:extLst>
                          <a:ext uri="{FF2B5EF4-FFF2-40B4-BE49-F238E27FC236}">
                            <a16:creationId xmlns:a16="http://schemas.microsoft.com/office/drawing/2014/main" id="{CF9823C0-88BD-4037-AE10-5F60BAEFBDA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8925684" y="3368847"/>
                        <a:ext cx="1" cy="21173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1" name="Connecteur droit 260">
                        <a:extLst>
                          <a:ext uri="{FF2B5EF4-FFF2-40B4-BE49-F238E27FC236}">
                            <a16:creationId xmlns:a16="http://schemas.microsoft.com/office/drawing/2014/main" id="{BF416F44-913D-4279-8664-529A9F9261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559028" y="3368847"/>
                        <a:ext cx="1" cy="21173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62" name="Rectangle 261">
                        <a:extLst>
                          <a:ext uri="{FF2B5EF4-FFF2-40B4-BE49-F238E27FC236}">
                            <a16:creationId xmlns:a16="http://schemas.microsoft.com/office/drawing/2014/main" id="{3B7362DD-F2ED-4881-969B-B8437E75212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1569822" y="3570871"/>
                        <a:ext cx="431045" cy="41564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 dirty="0"/>
                      </a:p>
                    </p:txBody>
                  </p:sp>
                  <p:cxnSp>
                    <p:nvCxnSpPr>
                      <p:cNvPr id="263" name="Connecteur droit 262">
                        <a:extLst>
                          <a:ext uri="{FF2B5EF4-FFF2-40B4-BE49-F238E27FC236}">
                            <a16:creationId xmlns:a16="http://schemas.microsoft.com/office/drawing/2014/main" id="{9F787501-06BF-4FE1-864D-A890C03F3E80}"/>
                          </a:ext>
                        </a:extLst>
                      </p:cNvPr>
                      <p:cNvCxnSpPr>
                        <a:cxnSpLocks/>
                        <a:endCxn id="262" idx="0"/>
                      </p:cNvCxnSpPr>
                      <p:nvPr/>
                    </p:nvCxnSpPr>
                    <p:spPr>
                      <a:xfrm>
                        <a:off x="11785342" y="3368847"/>
                        <a:ext cx="3" cy="20202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68" name="Ellipse 267">
                        <a:extLst>
                          <a:ext uri="{FF2B5EF4-FFF2-40B4-BE49-F238E27FC236}">
                            <a16:creationId xmlns:a16="http://schemas.microsoft.com/office/drawing/2014/main" id="{A845FD8E-21C6-4509-A3D0-C7EC71CA0CE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255638" y="3570871"/>
                        <a:ext cx="431045" cy="415642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/>
                      </a:p>
                    </p:txBody>
                  </p:sp>
                  <p:cxnSp>
                    <p:nvCxnSpPr>
                      <p:cNvPr id="269" name="Connecteur droit 268">
                        <a:extLst>
                          <a:ext uri="{FF2B5EF4-FFF2-40B4-BE49-F238E27FC236}">
                            <a16:creationId xmlns:a16="http://schemas.microsoft.com/office/drawing/2014/main" id="{54E019AA-66A7-4003-A134-34C9E88FE7E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471161" y="3359137"/>
                        <a:ext cx="1" cy="21173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0" name="Connecteur droit 269">
                        <a:extLst>
                          <a:ext uri="{FF2B5EF4-FFF2-40B4-BE49-F238E27FC236}">
                            <a16:creationId xmlns:a16="http://schemas.microsoft.com/office/drawing/2014/main" id="{1402061E-11AE-4A09-9C8E-C0C10856063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5193211" y="3537029"/>
                        <a:ext cx="526952" cy="513728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1" name="Connecteur droit 270">
                        <a:extLst>
                          <a:ext uri="{FF2B5EF4-FFF2-40B4-BE49-F238E27FC236}">
                            <a16:creationId xmlns:a16="http://schemas.microsoft.com/office/drawing/2014/main" id="{0F3AB8EF-CF03-4BF9-9291-E96D0A24D57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11521866" y="3526683"/>
                        <a:ext cx="526952" cy="513728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281" name="Groupe 280">
                        <a:extLst>
                          <a:ext uri="{FF2B5EF4-FFF2-40B4-BE49-F238E27FC236}">
                            <a16:creationId xmlns:a16="http://schemas.microsoft.com/office/drawing/2014/main" id="{C8F3619E-A0E4-4404-B8B6-2EBF6C43030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0343505" y="3580581"/>
                        <a:ext cx="974236" cy="1246106"/>
                        <a:chOff x="10343505" y="3580581"/>
                        <a:chExt cx="974236" cy="1246106"/>
                      </a:xfrm>
                    </p:grpSpPr>
                    <p:sp>
                      <p:nvSpPr>
                        <p:cNvPr id="260" name="Ellipse 259">
                          <a:extLst>
                            <a:ext uri="{FF2B5EF4-FFF2-40B4-BE49-F238E27FC236}">
                              <a16:creationId xmlns:a16="http://schemas.microsoft.com/office/drawing/2014/main" id="{FF15B620-F2B2-4E1A-B31C-DD31F188E714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0343505" y="3580581"/>
                          <a:ext cx="431045" cy="415642"/>
                        </a:xfrm>
                        <a:prstGeom prst="ellipse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/>
                        </a:p>
                      </p:txBody>
                    </p:sp>
                    <p:grpSp>
                      <p:nvGrpSpPr>
                        <p:cNvPr id="280" name="Groupe 279">
                          <a:extLst>
                            <a:ext uri="{FF2B5EF4-FFF2-40B4-BE49-F238E27FC236}">
                              <a16:creationId xmlns:a16="http://schemas.microsoft.com/office/drawing/2014/main" id="{BD8F3F72-5F4E-4617-AEA1-76C3BC5AD09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0561777" y="3581661"/>
                          <a:ext cx="755964" cy="1245026"/>
                          <a:chOff x="10569931" y="3566409"/>
                          <a:chExt cx="755964" cy="1245026"/>
                        </a:xfrm>
                      </p:grpSpPr>
                      <p:sp>
                        <p:nvSpPr>
                          <p:cNvPr id="267" name="Rectangle 266">
                            <a:extLst>
                              <a:ext uri="{FF2B5EF4-FFF2-40B4-BE49-F238E27FC236}">
                                <a16:creationId xmlns:a16="http://schemas.microsoft.com/office/drawing/2014/main" id="{FEC360EC-7BF4-4E26-AF45-AA962627FF2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0894850" y="3566409"/>
                            <a:ext cx="431045" cy="415642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fr-FR" sz="2560" dirty="0"/>
                          </a:p>
                        </p:txBody>
                      </p:sp>
                      <p:cxnSp>
                        <p:nvCxnSpPr>
                          <p:cNvPr id="276" name="Connecteur droit 275">
                            <a:extLst>
                              <a:ext uri="{FF2B5EF4-FFF2-40B4-BE49-F238E27FC236}">
                                <a16:creationId xmlns:a16="http://schemas.microsoft.com/office/drawing/2014/main" id="{453E9688-84C2-48A8-99F1-FABB4DDB9BA4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0987131" y="4199732"/>
                            <a:ext cx="0" cy="611703"/>
                          </a:xfrm>
                          <a:prstGeom prst="line">
                            <a:avLst/>
                          </a:prstGeom>
                          <a:solidFill>
                            <a:schemeClr val="tx1"/>
                          </a:solidFill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77" name="Connecteur droit 276">
                            <a:extLst>
                              <a:ext uri="{FF2B5EF4-FFF2-40B4-BE49-F238E27FC236}">
                                <a16:creationId xmlns:a16="http://schemas.microsoft.com/office/drawing/2014/main" id="{898AFE4E-E112-44E2-8E66-A1AA3BB4DBF4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0569931" y="4209090"/>
                            <a:ext cx="540441" cy="0"/>
                          </a:xfrm>
                          <a:prstGeom prst="line">
                            <a:avLst/>
                          </a:prstGeom>
                          <a:solidFill>
                            <a:schemeClr val="tx1"/>
                          </a:solidFill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78" name="Connecteur droit 277">
                            <a:extLst>
                              <a:ext uri="{FF2B5EF4-FFF2-40B4-BE49-F238E27FC236}">
                                <a16:creationId xmlns:a16="http://schemas.microsoft.com/office/drawing/2014/main" id="{F438443B-A219-463F-B499-4E1789AC7111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0575091" y="3984720"/>
                            <a:ext cx="0" cy="226557"/>
                          </a:xfrm>
                          <a:prstGeom prst="line">
                            <a:avLst/>
                          </a:prstGeom>
                          <a:solidFill>
                            <a:schemeClr val="tx1"/>
                          </a:solidFill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79" name="Connecteur droit 278">
                            <a:extLst>
                              <a:ext uri="{FF2B5EF4-FFF2-40B4-BE49-F238E27FC236}">
                                <a16:creationId xmlns:a16="http://schemas.microsoft.com/office/drawing/2014/main" id="{1BE11308-209C-4FAF-975E-C9F379FBE39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11105214" y="3984720"/>
                            <a:ext cx="0" cy="226557"/>
                          </a:xfrm>
                          <a:prstGeom prst="line">
                            <a:avLst/>
                          </a:prstGeom>
                          <a:solidFill>
                            <a:schemeClr val="tx1"/>
                          </a:solidFill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307" name="Groupe 306">
                        <a:extLst>
                          <a:ext uri="{FF2B5EF4-FFF2-40B4-BE49-F238E27FC236}">
                            <a16:creationId xmlns:a16="http://schemas.microsoft.com/office/drawing/2014/main" id="{03C0BE99-40CD-4665-8A75-8658CDFD445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576340" y="3580581"/>
                        <a:ext cx="2082684" cy="1933466"/>
                        <a:chOff x="7576340" y="3580581"/>
                        <a:chExt cx="2082684" cy="1933466"/>
                      </a:xfrm>
                    </p:grpSpPr>
                    <p:grpSp>
                      <p:nvGrpSpPr>
                        <p:cNvPr id="284" name="Groupe 283">
                          <a:extLst>
                            <a:ext uri="{FF2B5EF4-FFF2-40B4-BE49-F238E27FC236}">
                              <a16:creationId xmlns:a16="http://schemas.microsoft.com/office/drawing/2014/main" id="{1B28D0E9-D98D-46E8-82A3-1D7CFBBB0D8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8710161" y="3580581"/>
                          <a:ext cx="948863" cy="1252926"/>
                          <a:chOff x="8710161" y="3580581"/>
                          <a:chExt cx="948863" cy="1252926"/>
                        </a:xfrm>
                      </p:grpSpPr>
                      <p:sp>
                        <p:nvSpPr>
                          <p:cNvPr id="258" name="Ellipse 257">
                            <a:extLst>
                              <a:ext uri="{FF2B5EF4-FFF2-40B4-BE49-F238E27FC236}">
                                <a16:creationId xmlns:a16="http://schemas.microsoft.com/office/drawing/2014/main" id="{1C648C71-2D57-40F3-9667-757B8EA08D8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8710161" y="3580581"/>
                            <a:ext cx="431045" cy="415642"/>
                          </a:xfrm>
                          <a:prstGeom prst="ellipse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fr-FR" sz="2560"/>
                          </a:p>
                        </p:txBody>
                      </p:sp>
                      <p:grpSp>
                        <p:nvGrpSpPr>
                          <p:cNvPr id="282" name="Groupe 281">
                            <a:extLst>
                              <a:ext uri="{FF2B5EF4-FFF2-40B4-BE49-F238E27FC236}">
                                <a16:creationId xmlns:a16="http://schemas.microsoft.com/office/drawing/2014/main" id="{5B4D2C15-0A49-4184-A902-0CB03100343C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8914566" y="3580581"/>
                            <a:ext cx="744458" cy="1252926"/>
                            <a:chOff x="8953695" y="3570871"/>
                            <a:chExt cx="744458" cy="1252926"/>
                          </a:xfrm>
                        </p:grpSpPr>
                        <p:sp>
                          <p:nvSpPr>
                            <p:cNvPr id="266" name="Rectangle 265">
                              <a:extLst>
                                <a:ext uri="{FF2B5EF4-FFF2-40B4-BE49-F238E27FC236}">
                                  <a16:creationId xmlns:a16="http://schemas.microsoft.com/office/drawing/2014/main" id="{4315D575-7D67-4D8A-A133-3B71D188862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9267108" y="3570871"/>
                              <a:ext cx="431045" cy="415642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2560" dirty="0"/>
                            </a:p>
                          </p:txBody>
                        </p:sp>
                        <p:cxnSp>
                          <p:nvCxnSpPr>
                            <p:cNvPr id="272" name="Connecteur droit 271">
                              <a:extLst>
                                <a:ext uri="{FF2B5EF4-FFF2-40B4-BE49-F238E27FC236}">
                                  <a16:creationId xmlns:a16="http://schemas.microsoft.com/office/drawing/2014/main" id="{B13A2C0E-8180-4CE5-A7B7-2A5B1C3F0E7F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9263559" y="4212839"/>
                              <a:ext cx="0" cy="610958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73" name="Connecteur droit 272">
                              <a:extLst>
                                <a:ext uri="{FF2B5EF4-FFF2-40B4-BE49-F238E27FC236}">
                                  <a16:creationId xmlns:a16="http://schemas.microsoft.com/office/drawing/2014/main" id="{860013B9-C161-4D01-A99F-B578E848C701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8953695" y="4217395"/>
                              <a:ext cx="540441" cy="0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74" name="Connecteur droit 273">
                              <a:extLst>
                                <a:ext uri="{FF2B5EF4-FFF2-40B4-BE49-F238E27FC236}">
                                  <a16:creationId xmlns:a16="http://schemas.microsoft.com/office/drawing/2014/main" id="{A2FC9AC4-E1C0-4E42-9141-9D20AB6B955A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8958855" y="3993025"/>
                              <a:ext cx="0" cy="226557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75" name="Connecteur droit 274">
                              <a:extLst>
                                <a:ext uri="{FF2B5EF4-FFF2-40B4-BE49-F238E27FC236}">
                                  <a16:creationId xmlns:a16="http://schemas.microsoft.com/office/drawing/2014/main" id="{365FAC7E-2EF6-4340-9881-582C7D8BE5D9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9488978" y="3993025"/>
                              <a:ext cx="0" cy="226557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</p:grpSp>
                    <p:cxnSp>
                      <p:nvCxnSpPr>
                        <p:cNvPr id="285" name="Connecteur droit 284">
                          <a:extLst>
                            <a:ext uri="{FF2B5EF4-FFF2-40B4-BE49-F238E27FC236}">
                              <a16:creationId xmlns:a16="http://schemas.microsoft.com/office/drawing/2014/main" id="{F8F1FB82-A891-4E96-B498-3E30A5D67F9D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7790659" y="4827924"/>
                          <a:ext cx="1422989" cy="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290" name="Groupe 289">
                          <a:extLst>
                            <a:ext uri="{FF2B5EF4-FFF2-40B4-BE49-F238E27FC236}">
                              <a16:creationId xmlns:a16="http://schemas.microsoft.com/office/drawing/2014/main" id="{17F1C564-C46A-4D0F-BC19-20B35C691A9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576340" y="5090949"/>
                          <a:ext cx="1857268" cy="423098"/>
                          <a:chOff x="7801759" y="5097277"/>
                          <a:chExt cx="1857268" cy="423098"/>
                        </a:xfrm>
                      </p:grpSpPr>
                      <p:sp>
                        <p:nvSpPr>
                          <p:cNvPr id="287" name="Rectangle 286">
                            <a:extLst>
                              <a:ext uri="{FF2B5EF4-FFF2-40B4-BE49-F238E27FC236}">
                                <a16:creationId xmlns:a16="http://schemas.microsoft.com/office/drawing/2014/main" id="{307FBAC9-FB25-43F1-8B6D-C60B1C7A14A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9227979" y="5097277"/>
                            <a:ext cx="431048" cy="415643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fr-FR" sz="2560" dirty="0"/>
                          </a:p>
                        </p:txBody>
                      </p:sp>
                      <p:sp>
                        <p:nvSpPr>
                          <p:cNvPr id="288" name="Ellipse 287">
                            <a:extLst>
                              <a:ext uri="{FF2B5EF4-FFF2-40B4-BE49-F238E27FC236}">
                                <a16:creationId xmlns:a16="http://schemas.microsoft.com/office/drawing/2014/main" id="{0CD39F83-3D98-4967-B282-A63D4DC2C51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8512051" y="5104733"/>
                            <a:ext cx="431045" cy="415642"/>
                          </a:xfrm>
                          <a:prstGeom prst="ellipse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fr-FR" sz="2560"/>
                          </a:p>
                        </p:txBody>
                      </p:sp>
                      <p:sp>
                        <p:nvSpPr>
                          <p:cNvPr id="289" name="Ellipse 288">
                            <a:extLst>
                              <a:ext uri="{FF2B5EF4-FFF2-40B4-BE49-F238E27FC236}">
                                <a16:creationId xmlns:a16="http://schemas.microsoft.com/office/drawing/2014/main" id="{96AA3C7D-0CC4-4B7F-B5D8-56AE0A93A3F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7801759" y="5097277"/>
                            <a:ext cx="431045" cy="415642"/>
                          </a:xfrm>
                          <a:prstGeom prst="ellipse">
                            <a:avLst/>
                          </a:prstGeom>
                          <a:solidFill>
                            <a:schemeClr val="bg2">
                              <a:lumMod val="90000"/>
                            </a:schemeClr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endParaRPr lang="fr-FR" sz="2560"/>
                          </a:p>
                        </p:txBody>
                      </p:sp>
                    </p:grpSp>
                    <p:cxnSp>
                      <p:nvCxnSpPr>
                        <p:cNvPr id="291" name="Connecteur droit 290">
                          <a:extLst>
                            <a:ext uri="{FF2B5EF4-FFF2-40B4-BE49-F238E27FC236}">
                              <a16:creationId xmlns:a16="http://schemas.microsoft.com/office/drawing/2014/main" id="{D0E14C25-43A0-46C4-927A-EE2F7F22926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790659" y="4819303"/>
                          <a:ext cx="0" cy="276484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94" name="Connecteur droit 293">
                          <a:extLst>
                            <a:ext uri="{FF2B5EF4-FFF2-40B4-BE49-F238E27FC236}">
                              <a16:creationId xmlns:a16="http://schemas.microsoft.com/office/drawing/2014/main" id="{1F18E2DA-6069-40BE-A938-968A8C1A1E0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8502153" y="4827924"/>
                          <a:ext cx="0" cy="276484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95" name="Connecteur droit 294">
                          <a:extLst>
                            <a:ext uri="{FF2B5EF4-FFF2-40B4-BE49-F238E27FC236}">
                              <a16:creationId xmlns:a16="http://schemas.microsoft.com/office/drawing/2014/main" id="{3DD83423-AB7E-450B-983C-8754B7E6E28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9224430" y="4819303"/>
                          <a:ext cx="0" cy="276484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296" name="ZoneTexte 295">
                        <a:extLst>
                          <a:ext uri="{FF2B5EF4-FFF2-40B4-BE49-F238E27FC236}">
                            <a16:creationId xmlns:a16="http://schemas.microsoft.com/office/drawing/2014/main" id="{97091CB6-92BA-4E77-8D20-2121EDCDD58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189146" y="5589495"/>
                        <a:ext cx="1269667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Multinodular goitre</a:t>
                        </a:r>
                      </a:p>
                    </p:txBody>
                  </p:sp>
                  <p:grpSp>
                    <p:nvGrpSpPr>
                      <p:cNvPr id="298" name="Groupe 297">
                        <a:extLst>
                          <a:ext uri="{FF2B5EF4-FFF2-40B4-BE49-F238E27FC236}">
                            <a16:creationId xmlns:a16="http://schemas.microsoft.com/office/drawing/2014/main" id="{A12D2F26-686E-4A54-827F-D20AB92BE66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932511" y="5083818"/>
                        <a:ext cx="2111671" cy="429102"/>
                        <a:chOff x="7801756" y="5097277"/>
                        <a:chExt cx="2111671" cy="429102"/>
                      </a:xfrm>
                    </p:grpSpPr>
                    <p:sp>
                      <p:nvSpPr>
                        <p:cNvPr id="299" name="Rectangle 298">
                          <a:extLst>
                            <a:ext uri="{FF2B5EF4-FFF2-40B4-BE49-F238E27FC236}">
                              <a16:creationId xmlns:a16="http://schemas.microsoft.com/office/drawing/2014/main" id="{3237DA44-C55F-4CE0-B3C0-F17BB720CDC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482379" y="5104407"/>
                          <a:ext cx="431048" cy="415643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 dirty="0"/>
                        </a:p>
                      </p:txBody>
                    </p:sp>
                    <p:sp>
                      <p:nvSpPr>
                        <p:cNvPr id="300" name="Ellipse 299">
                          <a:extLst>
                            <a:ext uri="{FF2B5EF4-FFF2-40B4-BE49-F238E27FC236}">
                              <a16:creationId xmlns:a16="http://schemas.microsoft.com/office/drawing/2014/main" id="{3118636C-6045-441E-B0A1-5007D5F7EE9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8639423" y="5110737"/>
                          <a:ext cx="431045" cy="415642"/>
                        </a:xfrm>
                        <a:prstGeom prst="ellipse">
                          <a:avLst/>
                        </a:prstGeom>
                        <a:solidFill>
                          <a:schemeClr val="bg2">
                            <a:lumMod val="90000"/>
                          </a:schemeClr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/>
                        </a:p>
                      </p:txBody>
                    </p:sp>
                    <p:sp>
                      <p:nvSpPr>
                        <p:cNvPr id="301" name="Ellipse 300">
                          <a:extLst>
                            <a:ext uri="{FF2B5EF4-FFF2-40B4-BE49-F238E27FC236}">
                              <a16:creationId xmlns:a16="http://schemas.microsoft.com/office/drawing/2014/main" id="{C8111C65-00D5-4A0C-BB9A-928932DEB4C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7801756" y="5097277"/>
                          <a:ext cx="431045" cy="415642"/>
                        </a:xfrm>
                        <a:prstGeom prst="ellipse">
                          <a:avLst/>
                        </a:prstGeom>
                        <a:solidFill>
                          <a:schemeClr val="bg2">
                            <a:lumMod val="90000"/>
                          </a:schemeClr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2560"/>
                        </a:p>
                      </p:txBody>
                    </p:sp>
                  </p:grpSp>
                  <p:cxnSp>
                    <p:nvCxnSpPr>
                      <p:cNvPr id="302" name="Connecteur droit 301">
                        <a:extLst>
                          <a:ext uri="{FF2B5EF4-FFF2-40B4-BE49-F238E27FC236}">
                            <a16:creationId xmlns:a16="http://schemas.microsoft.com/office/drawing/2014/main" id="{5036F9B6-0445-4762-9B25-A0E06D6360B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146833" y="4812172"/>
                        <a:ext cx="0" cy="27648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3" name="Connecteur droit 302">
                        <a:extLst>
                          <a:ext uri="{FF2B5EF4-FFF2-40B4-BE49-F238E27FC236}">
                            <a16:creationId xmlns:a16="http://schemas.microsoft.com/office/drawing/2014/main" id="{26E89FF5-F054-4A82-BD0E-5F6249BC2C4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978977" y="4814465"/>
                        <a:ext cx="0" cy="276484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04" name="Connecteur droit 303">
                        <a:extLst>
                          <a:ext uri="{FF2B5EF4-FFF2-40B4-BE49-F238E27FC236}">
                            <a16:creationId xmlns:a16="http://schemas.microsoft.com/office/drawing/2014/main" id="{7F7DB5E2-EA2D-4745-AD39-CF31F44CADED}"/>
                          </a:ext>
                        </a:extLst>
                      </p:cNvPr>
                      <p:cNvCxnSpPr>
                        <a:cxnSpLocks/>
                        <a:endCxn id="299" idx="0"/>
                      </p:cNvCxnSpPr>
                      <p:nvPr/>
                    </p:nvCxnSpPr>
                    <p:spPr>
                      <a:xfrm>
                        <a:off x="11828658" y="4812172"/>
                        <a:ext cx="0" cy="278776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05" name="ZoneTexte 304">
                        <a:extLst>
                          <a:ext uri="{FF2B5EF4-FFF2-40B4-BE49-F238E27FC236}">
                            <a16:creationId xmlns:a16="http://schemas.microsoft.com/office/drawing/2014/main" id="{52EA7EC9-7692-4821-8A8C-219D8958669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804216" y="5519305"/>
                        <a:ext cx="968006" cy="49116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>
                          <a:lnSpc>
                            <a:spcPct val="80000"/>
                          </a:lnSpc>
                        </a:pPr>
                        <a:r>
                          <a:rPr lang="en-GB" sz="1600" dirty="0"/>
                          <a:t>Thyroid problems</a:t>
                        </a:r>
                      </a:p>
                    </p:txBody>
                  </p:sp>
                  <p:sp>
                    <p:nvSpPr>
                      <p:cNvPr id="306" name="ZoneTexte 305">
                        <a:extLst>
                          <a:ext uri="{FF2B5EF4-FFF2-40B4-BE49-F238E27FC236}">
                            <a16:creationId xmlns:a16="http://schemas.microsoft.com/office/drawing/2014/main" id="{4D879054-86CB-44A1-9E3B-C38D12F09F4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394341" y="5498094"/>
                        <a:ext cx="150209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600" dirty="0"/>
                          <a:t>Hypothyroidism</a:t>
                        </a:r>
                      </a:p>
                    </p:txBody>
                  </p:sp>
                  <p:cxnSp>
                    <p:nvCxnSpPr>
                      <p:cNvPr id="308" name="Connecteur droit 307">
                        <a:extLst>
                          <a:ext uri="{FF2B5EF4-FFF2-40B4-BE49-F238E27FC236}">
                            <a16:creationId xmlns:a16="http://schemas.microsoft.com/office/drawing/2014/main" id="{627241AD-131F-48D3-97E0-4477EE979FF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622294" y="2738391"/>
                        <a:ext cx="0" cy="629246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309" name="Connecteur droit 308">
                      <a:extLst>
                        <a:ext uri="{FF2B5EF4-FFF2-40B4-BE49-F238E27FC236}">
                          <a16:creationId xmlns:a16="http://schemas.microsoft.com/office/drawing/2014/main" id="{DBB13321-999C-4781-AB0D-128355C4C6A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356147" y="3783419"/>
                      <a:ext cx="54044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0" name="Ellipse 309">
                      <a:extLst>
                        <a:ext uri="{FF2B5EF4-FFF2-40B4-BE49-F238E27FC236}">
                          <a16:creationId xmlns:a16="http://schemas.microsoft.com/office/drawing/2014/main" id="{C469CE95-5538-4D2A-962F-13C7B448573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75907" y="3143407"/>
                      <a:ext cx="431045" cy="415642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sp>
                  <p:nvSpPr>
                    <p:cNvPr id="311" name="Rectangle 310">
                      <a:extLst>
                        <a:ext uri="{FF2B5EF4-FFF2-40B4-BE49-F238E27FC236}">
                          <a16:creationId xmlns:a16="http://schemas.microsoft.com/office/drawing/2014/main" id="{B67BFDE1-3380-40FE-B1FF-578E0574FA7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45783" y="3143407"/>
                      <a:ext cx="431045" cy="41564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cxnSp>
                  <p:nvCxnSpPr>
                    <p:cNvPr id="312" name="Connecteur droit 311">
                      <a:extLst>
                        <a:ext uri="{FF2B5EF4-FFF2-40B4-BE49-F238E27FC236}">
                          <a16:creationId xmlns:a16="http://schemas.microsoft.com/office/drawing/2014/main" id="{2DB9F859-15EA-404E-8B27-81AC5DE88F4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361307" y="3559049"/>
                      <a:ext cx="0" cy="226557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3" name="Connecteur droit 312">
                      <a:extLst>
                        <a:ext uri="{FF2B5EF4-FFF2-40B4-BE49-F238E27FC236}">
                          <a16:creationId xmlns:a16="http://schemas.microsoft.com/office/drawing/2014/main" id="{26CA9974-1436-4F53-B171-B276ABDEBD3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91430" y="3559049"/>
                      <a:ext cx="0" cy="226557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4" name="Connecteur droit 323">
                      <a:extLst>
                        <a:ext uri="{FF2B5EF4-FFF2-40B4-BE49-F238E27FC236}">
                          <a16:creationId xmlns:a16="http://schemas.microsoft.com/office/drawing/2014/main" id="{5A81109C-3FF1-4C76-9FF5-06BAD312B9B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626367" y="3102014"/>
                      <a:ext cx="526952" cy="513728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5" name="Connecteur droit 324">
                      <a:extLst>
                        <a:ext uri="{FF2B5EF4-FFF2-40B4-BE49-F238E27FC236}">
                          <a16:creationId xmlns:a16="http://schemas.microsoft.com/office/drawing/2014/main" id="{568CDE52-1718-4CBC-8638-8B289AFC4CE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086942" y="3085375"/>
                      <a:ext cx="526952" cy="513728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54" name="ZoneTexte 353">
                      <a:extLst>
                        <a:ext uri="{FF2B5EF4-FFF2-40B4-BE49-F238E27FC236}">
                          <a16:creationId xmlns:a16="http://schemas.microsoft.com/office/drawing/2014/main" id="{1C234B31-1E2C-4F76-8735-BDCC5EB802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56837" y="4819724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1</a:t>
                      </a:r>
                    </a:p>
                  </p:txBody>
                </p:sp>
                <p:sp>
                  <p:nvSpPr>
                    <p:cNvPr id="355" name="ZoneTexte 354">
                      <a:extLst>
                        <a:ext uri="{FF2B5EF4-FFF2-40B4-BE49-F238E27FC236}">
                          <a16:creationId xmlns:a16="http://schemas.microsoft.com/office/drawing/2014/main" id="{DF787248-B2F7-43E5-9BF2-7D2BE396100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47327" y="6377882"/>
                      <a:ext cx="256988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2</a:t>
                      </a:r>
                    </a:p>
                  </p:txBody>
                </p:sp>
                <p:sp>
                  <p:nvSpPr>
                    <p:cNvPr id="356" name="ZoneTexte 355">
                      <a:extLst>
                        <a:ext uri="{FF2B5EF4-FFF2-40B4-BE49-F238E27FC236}">
                          <a16:creationId xmlns:a16="http://schemas.microsoft.com/office/drawing/2014/main" id="{A270585D-8118-4D42-BDE3-0477093E0C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1130" y="6369305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3</a:t>
                      </a:r>
                    </a:p>
                  </p:txBody>
                </p:sp>
                <p:sp>
                  <p:nvSpPr>
                    <p:cNvPr id="359" name="ZoneTexte 358">
                      <a:extLst>
                        <a:ext uri="{FF2B5EF4-FFF2-40B4-BE49-F238E27FC236}">
                          <a16:creationId xmlns:a16="http://schemas.microsoft.com/office/drawing/2014/main" id="{0638722E-C6B3-4B8D-8FCA-B75E1497DC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01772" y="6369305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4</a:t>
                      </a:r>
                    </a:p>
                  </p:txBody>
                </p:sp>
                <p:sp>
                  <p:nvSpPr>
                    <p:cNvPr id="360" name="ZoneTexte 359">
                      <a:extLst>
                        <a:ext uri="{FF2B5EF4-FFF2-40B4-BE49-F238E27FC236}">
                          <a16:creationId xmlns:a16="http://schemas.microsoft.com/office/drawing/2014/main" id="{18DF4AAA-0B8B-47C2-ABAF-A18D2C90BE1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82145" y="6369305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5</a:t>
                      </a:r>
                    </a:p>
                  </p:txBody>
                </p:sp>
                <p:sp>
                  <p:nvSpPr>
                    <p:cNvPr id="361" name="ZoneTexte 360">
                      <a:extLst>
                        <a:ext uri="{FF2B5EF4-FFF2-40B4-BE49-F238E27FC236}">
                          <a16:creationId xmlns:a16="http://schemas.microsoft.com/office/drawing/2014/main" id="{DD03C8C7-075D-4F59-A707-9A44E07AEE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618063" y="6368648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6</a:t>
                      </a:r>
                    </a:p>
                  </p:txBody>
                </p:sp>
                <p:sp>
                  <p:nvSpPr>
                    <p:cNvPr id="363" name="ZoneTexte 362">
                      <a:extLst>
                        <a:ext uri="{FF2B5EF4-FFF2-40B4-BE49-F238E27FC236}">
                          <a16:creationId xmlns:a16="http://schemas.microsoft.com/office/drawing/2014/main" id="{2288E6E9-88CF-4928-AFE6-33DC3ECF41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7068" y="7855635"/>
                      <a:ext cx="431048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7</a:t>
                      </a:r>
                    </a:p>
                  </p:txBody>
                </p:sp>
                <p:sp>
                  <p:nvSpPr>
                    <p:cNvPr id="364" name="ZoneTexte 363">
                      <a:extLst>
                        <a:ext uri="{FF2B5EF4-FFF2-40B4-BE49-F238E27FC236}">
                          <a16:creationId xmlns:a16="http://schemas.microsoft.com/office/drawing/2014/main" id="{8559B991-5F09-4803-91F1-77C383195FF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9068" y="7855635"/>
                      <a:ext cx="431048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8</a:t>
                      </a:r>
                    </a:p>
                  </p:txBody>
                </p:sp>
                <p:sp>
                  <p:nvSpPr>
                    <p:cNvPr id="162" name="ZoneTexte 161">
                      <a:extLst>
                        <a:ext uri="{FF2B5EF4-FFF2-40B4-BE49-F238E27FC236}">
                          <a16:creationId xmlns:a16="http://schemas.microsoft.com/office/drawing/2014/main" id="{13AD7348-C745-4722-90C7-96337255460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64049" y="5081261"/>
                      <a:ext cx="1708109" cy="68813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>
                        <a:lnSpc>
                          <a:spcPct val="80000"/>
                        </a:lnSpc>
                      </a:pPr>
                      <a:r>
                        <a:rPr lang="en-GB" sz="1600" dirty="0"/>
                        <a:t>Thyroidectomy (benign pathology)</a:t>
                      </a:r>
                    </a:p>
                  </p:txBody>
                </p:sp>
              </p:grpSp>
            </p:grpSp>
            <p:sp>
              <p:nvSpPr>
                <p:cNvPr id="165" name="ZoneTexte 164">
                  <a:extLst>
                    <a:ext uri="{FF2B5EF4-FFF2-40B4-BE49-F238E27FC236}">
                      <a16:creationId xmlns:a16="http://schemas.microsoft.com/office/drawing/2014/main" id="{6A81E5B6-9DD6-4723-8094-8BEEB2F44D03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465875" y="5111014"/>
                  <a:ext cx="504000" cy="504000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fr-FR" sz="3600" dirty="0"/>
                </a:p>
              </p:txBody>
            </p:sp>
            <p:sp>
              <p:nvSpPr>
                <p:cNvPr id="180" name="ZoneTexte 179">
                  <a:extLst>
                    <a:ext uri="{FF2B5EF4-FFF2-40B4-BE49-F238E27FC236}">
                      <a16:creationId xmlns:a16="http://schemas.microsoft.com/office/drawing/2014/main" id="{401F8709-0F3B-4C9E-BA0B-3C99A4C6CEC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415173" y="6431814"/>
                  <a:ext cx="504000" cy="504000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fr-FR" sz="3600" dirty="0"/>
                </a:p>
              </p:txBody>
            </p:sp>
            <p:sp>
              <p:nvSpPr>
                <p:cNvPr id="181" name="ZoneTexte 180">
                  <a:extLst>
                    <a:ext uri="{FF2B5EF4-FFF2-40B4-BE49-F238E27FC236}">
                      <a16:creationId xmlns:a16="http://schemas.microsoft.com/office/drawing/2014/main" id="{C27ECCA6-3ACE-4371-A807-CFDB9AAF3A4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040693" y="6421051"/>
                  <a:ext cx="504000" cy="504000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lang="fr-FR" sz="3600" dirty="0"/>
                </a:p>
              </p:txBody>
            </p:sp>
          </p:grpSp>
        </p:grpSp>
        <p:cxnSp>
          <p:nvCxnSpPr>
            <p:cNvPr id="144" name="Connecteur droit 143">
              <a:extLst>
                <a:ext uri="{FF2B5EF4-FFF2-40B4-BE49-F238E27FC236}">
                  <a16:creationId xmlns:a16="http://schemas.microsoft.com/office/drawing/2014/main" id="{A3A75DCA-305C-4C4C-A2F7-AA6B1C76928B}"/>
                </a:ext>
              </a:extLst>
            </p:cNvPr>
            <p:cNvCxnSpPr/>
            <p:nvPr/>
          </p:nvCxnSpPr>
          <p:spPr>
            <a:xfrm>
              <a:off x="10390381" y="4895162"/>
              <a:ext cx="1692000" cy="0"/>
            </a:xfrm>
            <a:prstGeom prst="line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09888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ZoneTexte 149">
            <a:extLst>
              <a:ext uri="{FF2B5EF4-FFF2-40B4-BE49-F238E27FC236}">
                <a16:creationId xmlns:a16="http://schemas.microsoft.com/office/drawing/2014/main" id="{5A496E91-B04E-433C-93DA-EC5D6E94CD94}"/>
              </a:ext>
            </a:extLst>
          </p:cNvPr>
          <p:cNvSpPr txBox="1"/>
          <p:nvPr/>
        </p:nvSpPr>
        <p:spPr>
          <a:xfrm>
            <a:off x="5651040" y="483892"/>
            <a:ext cx="150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Family D</a:t>
            </a:r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975D9852-94E3-4610-AC06-D6D3C99D28F9}"/>
              </a:ext>
            </a:extLst>
          </p:cNvPr>
          <p:cNvGrpSpPr/>
          <p:nvPr/>
        </p:nvGrpSpPr>
        <p:grpSpPr>
          <a:xfrm>
            <a:off x="437751" y="1358601"/>
            <a:ext cx="11926098" cy="7646533"/>
            <a:chOff x="437751" y="1358601"/>
            <a:chExt cx="11926098" cy="7646533"/>
          </a:xfrm>
        </p:grpSpPr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EE024161-4F7B-4F08-9A2A-4773FEC23B38}"/>
                </a:ext>
              </a:extLst>
            </p:cNvPr>
            <p:cNvGrpSpPr/>
            <p:nvPr/>
          </p:nvGrpSpPr>
          <p:grpSpPr>
            <a:xfrm>
              <a:off x="437751" y="1587134"/>
              <a:ext cx="11926098" cy="7418000"/>
              <a:chOff x="437751" y="1587134"/>
              <a:chExt cx="11926098" cy="7418000"/>
            </a:xfrm>
          </p:grpSpPr>
          <p:grpSp>
            <p:nvGrpSpPr>
              <p:cNvPr id="17" name="Groupe 16">
                <a:extLst>
                  <a:ext uri="{FF2B5EF4-FFF2-40B4-BE49-F238E27FC236}">
                    <a16:creationId xmlns:a16="http://schemas.microsoft.com/office/drawing/2014/main" id="{CBA081EE-B131-46D8-B303-95E73EC83817}"/>
                  </a:ext>
                </a:extLst>
              </p:cNvPr>
              <p:cNvGrpSpPr/>
              <p:nvPr/>
            </p:nvGrpSpPr>
            <p:grpSpPr>
              <a:xfrm>
                <a:off x="1371505" y="1998926"/>
                <a:ext cx="10992344" cy="7006208"/>
                <a:chOff x="533305" y="1859226"/>
                <a:chExt cx="10992344" cy="7006208"/>
              </a:xfrm>
            </p:grpSpPr>
            <p:sp>
              <p:nvSpPr>
                <p:cNvPr id="135" name="ZoneTexte 134">
                  <a:extLst>
                    <a:ext uri="{FF2B5EF4-FFF2-40B4-BE49-F238E27FC236}">
                      <a16:creationId xmlns:a16="http://schemas.microsoft.com/office/drawing/2014/main" id="{98557B52-B114-4F6F-8595-144F309B0FD2}"/>
                    </a:ext>
                  </a:extLst>
                </p:cNvPr>
                <p:cNvSpPr txBox="1"/>
                <p:nvPr/>
              </p:nvSpPr>
              <p:spPr>
                <a:xfrm>
                  <a:off x="3402636" y="8324388"/>
                  <a:ext cx="1844654" cy="54104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lnSpc>
                      <a:spcPct val="80000"/>
                    </a:lnSpc>
                  </a:pPr>
                  <a:r>
                    <a:rPr lang="fr-FR" dirty="0" err="1"/>
                    <a:t>Thyroid</a:t>
                  </a:r>
                  <a:r>
                    <a:rPr lang="fr-FR" dirty="0"/>
                    <a:t> tract </a:t>
                  </a:r>
                  <a:r>
                    <a:rPr lang="fr-FR" dirty="0" err="1"/>
                    <a:t>cyst</a:t>
                  </a:r>
                  <a:r>
                    <a:rPr lang="fr-FR" dirty="0"/>
                    <a:t> - </a:t>
                  </a:r>
                  <a:r>
                    <a:rPr lang="fr-FR" dirty="0" err="1"/>
                    <a:t>thyroglossus</a:t>
                  </a:r>
                  <a:endParaRPr lang="fr-FR" dirty="0"/>
                </a:p>
              </p:txBody>
            </p:sp>
            <p:grpSp>
              <p:nvGrpSpPr>
                <p:cNvPr id="16" name="Groupe 15">
                  <a:extLst>
                    <a:ext uri="{FF2B5EF4-FFF2-40B4-BE49-F238E27FC236}">
                      <a16:creationId xmlns:a16="http://schemas.microsoft.com/office/drawing/2014/main" id="{7444C47D-6FEC-4CC2-94F5-061A46A8A000}"/>
                    </a:ext>
                  </a:extLst>
                </p:cNvPr>
                <p:cNvGrpSpPr/>
                <p:nvPr/>
              </p:nvGrpSpPr>
              <p:grpSpPr>
                <a:xfrm>
                  <a:off x="533305" y="1859226"/>
                  <a:ext cx="10992344" cy="6538633"/>
                  <a:chOff x="533305" y="1859226"/>
                  <a:chExt cx="10992344" cy="6538633"/>
                </a:xfrm>
              </p:grpSpPr>
              <p:grpSp>
                <p:nvGrpSpPr>
                  <p:cNvPr id="2" name="Groupe 1">
                    <a:extLst>
                      <a:ext uri="{FF2B5EF4-FFF2-40B4-BE49-F238E27FC236}">
                        <a16:creationId xmlns:a16="http://schemas.microsoft.com/office/drawing/2014/main" id="{535575BA-C332-48A9-860A-0FE4C7C30570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895189" y="3465146"/>
                    <a:ext cx="8749428" cy="4870738"/>
                    <a:chOff x="2215965" y="3360371"/>
                    <a:chExt cx="6548351" cy="3645411"/>
                  </a:xfrm>
                </p:grpSpPr>
                <p:sp>
                  <p:nvSpPr>
                    <p:cNvPr id="103" name="Ellipse 102">
                      <a:extLst>
                        <a:ext uri="{FF2B5EF4-FFF2-40B4-BE49-F238E27FC236}">
                          <a16:creationId xmlns:a16="http://schemas.microsoft.com/office/drawing/2014/main" id="{7A8503F0-A8C1-4869-9F3F-1198691E643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15965" y="6527171"/>
                      <a:ext cx="469654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cxnSp>
                  <p:nvCxnSpPr>
                    <p:cNvPr id="104" name="Connecteur droit 103">
                      <a:extLst>
                        <a:ext uri="{FF2B5EF4-FFF2-40B4-BE49-F238E27FC236}">
                          <a16:creationId xmlns:a16="http://schemas.microsoft.com/office/drawing/2014/main" id="{39AA5EBB-67A1-4404-A133-9E106B5C0A0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9549" y="6271148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5" name="Connecteur droit 104">
                      <a:extLst>
                        <a:ext uri="{FF2B5EF4-FFF2-40B4-BE49-F238E27FC236}">
                          <a16:creationId xmlns:a16="http://schemas.microsoft.com/office/drawing/2014/main" id="{8DC26BF1-B910-4BE0-A384-8427BFCB665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733974" y="5759103"/>
                      <a:ext cx="0" cy="512045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6" name="Ellipse 105">
                      <a:extLst>
                        <a:ext uri="{FF2B5EF4-FFF2-40B4-BE49-F238E27FC236}">
                          <a16:creationId xmlns:a16="http://schemas.microsoft.com/office/drawing/2014/main" id="{0AA02293-9A0D-4D81-B1F1-0DFD9DC7599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93572" y="6527171"/>
                      <a:ext cx="469654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cxnSp>
                  <p:nvCxnSpPr>
                    <p:cNvPr id="107" name="Connecteur droit 106">
                      <a:extLst>
                        <a:ext uri="{FF2B5EF4-FFF2-40B4-BE49-F238E27FC236}">
                          <a16:creationId xmlns:a16="http://schemas.microsoft.com/office/drawing/2014/main" id="{73D95B50-401D-474E-B8C8-6355FA8B7F8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17156" y="6271148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8" name="Connecteur droit 107">
                      <a:extLst>
                        <a:ext uri="{FF2B5EF4-FFF2-40B4-BE49-F238E27FC236}">
                          <a16:creationId xmlns:a16="http://schemas.microsoft.com/office/drawing/2014/main" id="{F7B69D70-493C-41C3-856D-41467246975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9550" y="6271147"/>
                      <a:ext cx="58885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9" name="Ellipse 108">
                      <a:extLst>
                        <a:ext uri="{FF2B5EF4-FFF2-40B4-BE49-F238E27FC236}">
                          <a16:creationId xmlns:a16="http://schemas.microsoft.com/office/drawing/2014/main" id="{EC187A34-CD8B-4BAA-9921-27DBA745492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93572" y="5033379"/>
                      <a:ext cx="469654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sp>
                  <p:nvSpPr>
                    <p:cNvPr id="110" name="Rectangle 109">
                      <a:extLst>
                        <a:ext uri="{FF2B5EF4-FFF2-40B4-BE49-F238E27FC236}">
                          <a16:creationId xmlns:a16="http://schemas.microsoft.com/office/drawing/2014/main" id="{6D505532-A10C-4B98-AF67-17F8B0F73AC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15965" y="5033379"/>
                      <a:ext cx="469654" cy="469701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cxnSp>
                  <p:nvCxnSpPr>
                    <p:cNvPr id="111" name="Connecteur droit 110">
                      <a:extLst>
                        <a:ext uri="{FF2B5EF4-FFF2-40B4-BE49-F238E27FC236}">
                          <a16:creationId xmlns:a16="http://schemas.microsoft.com/office/drawing/2014/main" id="{BAE4C611-226E-416B-BED0-0439F7D01E8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9550" y="5759102"/>
                      <a:ext cx="58885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Connecteur droit 111">
                      <a:extLst>
                        <a:ext uri="{FF2B5EF4-FFF2-40B4-BE49-F238E27FC236}">
                          <a16:creationId xmlns:a16="http://schemas.microsoft.com/office/drawing/2014/main" id="{1B1296EF-472E-48C2-B8A3-E6BB2F43AAC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9549" y="5505295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3" name="Connecteur droit 112">
                      <a:extLst>
                        <a:ext uri="{FF2B5EF4-FFF2-40B4-BE49-F238E27FC236}">
                          <a16:creationId xmlns:a16="http://schemas.microsoft.com/office/drawing/2014/main" id="{C7963F58-A725-4DB7-981A-3D11E352AF7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28399" y="5503080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84" name="Groupe 83">
                      <a:extLst>
                        <a:ext uri="{FF2B5EF4-FFF2-40B4-BE49-F238E27FC236}">
                          <a16:creationId xmlns:a16="http://schemas.microsoft.com/office/drawing/2014/main" id="{44DBAAE0-FA1D-40C5-B13A-6E94D38382F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77752" y="5041782"/>
                      <a:ext cx="1047262" cy="1963493"/>
                      <a:chOff x="763027" y="3768133"/>
                      <a:chExt cx="1472585" cy="2760919"/>
                    </a:xfrm>
                  </p:grpSpPr>
                  <p:sp>
                    <p:nvSpPr>
                      <p:cNvPr id="86" name="Ellipse 85">
                        <a:extLst>
                          <a:ext uri="{FF2B5EF4-FFF2-40B4-BE49-F238E27FC236}">
                            <a16:creationId xmlns:a16="http://schemas.microsoft.com/office/drawing/2014/main" id="{E557BB23-6050-4A25-ADEF-690C229853D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63027" y="5868594"/>
                        <a:ext cx="660395" cy="660458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/>
                      </a:p>
                    </p:txBody>
                  </p:sp>
                  <p:cxnSp>
                    <p:nvCxnSpPr>
                      <p:cNvPr id="88" name="Connecteur droit 87">
                        <a:extLst>
                          <a:ext uri="{FF2B5EF4-FFF2-40B4-BE49-F238E27FC236}">
                            <a16:creationId xmlns:a16="http://schemas.microsoft.com/office/drawing/2014/main" id="{06F55B9B-CFF2-4A06-9BDE-6E384C2E95D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91416" y="4788592"/>
                        <a:ext cx="0" cy="72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1" name="Ellipse 90">
                        <a:extLst>
                          <a:ext uri="{FF2B5EF4-FFF2-40B4-BE49-F238E27FC236}">
                            <a16:creationId xmlns:a16="http://schemas.microsoft.com/office/drawing/2014/main" id="{E455450B-95D2-40EE-A45F-C304A6689B2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575217" y="3768133"/>
                        <a:ext cx="660395" cy="660458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/>
                      </a:p>
                    </p:txBody>
                  </p:sp>
                  <p:sp>
                    <p:nvSpPr>
                      <p:cNvPr id="92" name="Rectangle 91">
                        <a:extLst>
                          <a:ext uri="{FF2B5EF4-FFF2-40B4-BE49-F238E27FC236}">
                            <a16:creationId xmlns:a16="http://schemas.microsoft.com/office/drawing/2014/main" id="{B4474E96-DF0A-4F5E-9D8C-700036FBBDD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63027" y="3768133"/>
                        <a:ext cx="660395" cy="660458"/>
                      </a:xfrm>
                      <a:prstGeom prst="rect">
                        <a:avLst/>
                      </a:prstGeom>
                      <a:solidFill>
                        <a:schemeClr val="bg2">
                          <a:lumMod val="90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 dirty="0"/>
                      </a:p>
                    </p:txBody>
                  </p:sp>
                  <p:cxnSp>
                    <p:nvCxnSpPr>
                      <p:cNvPr id="93" name="Connecteur droit 92">
                        <a:extLst>
                          <a:ext uri="{FF2B5EF4-FFF2-40B4-BE49-F238E27FC236}">
                            <a16:creationId xmlns:a16="http://schemas.microsoft.com/office/drawing/2014/main" id="{8DA750BC-ACC0-4BA6-B7F5-6959DC27AF2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077415" y="4788590"/>
                        <a:ext cx="828001" cy="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4" name="Connecteur droit 93">
                        <a:extLst>
                          <a:ext uri="{FF2B5EF4-FFF2-40B4-BE49-F238E27FC236}">
                            <a16:creationId xmlns:a16="http://schemas.microsoft.com/office/drawing/2014/main" id="{B9C15DE8-7A78-4041-B400-EAF2416759D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089197" y="4428590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5" name="Connecteur droit 94">
                        <a:extLst>
                          <a:ext uri="{FF2B5EF4-FFF2-40B4-BE49-F238E27FC236}">
                            <a16:creationId xmlns:a16="http://schemas.microsoft.com/office/drawing/2014/main" id="{4012F86C-F6B8-4171-A7F7-4CFE5AEC1A3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905414" y="4428590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73" name="Groupe 72">
                      <a:extLst>
                        <a:ext uri="{FF2B5EF4-FFF2-40B4-BE49-F238E27FC236}">
                          <a16:creationId xmlns:a16="http://schemas.microsoft.com/office/drawing/2014/main" id="{8D960D88-A8DD-409D-A9D5-C689C5EA35C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084432" y="5036987"/>
                      <a:ext cx="1047263" cy="1493792"/>
                      <a:chOff x="1174131" y="3767616"/>
                      <a:chExt cx="1472588" cy="2100461"/>
                    </a:xfrm>
                  </p:grpSpPr>
                  <p:cxnSp>
                    <p:nvCxnSpPr>
                      <p:cNvPr id="75" name="Connecteur droit 74">
                        <a:extLst>
                          <a:ext uri="{FF2B5EF4-FFF2-40B4-BE49-F238E27FC236}">
                            <a16:creationId xmlns:a16="http://schemas.microsoft.com/office/drawing/2014/main" id="{E09BEBC5-D310-4E20-9419-155CF065F4C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88522" y="5508077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6" name="Connecteur droit 75">
                        <a:extLst>
                          <a:ext uri="{FF2B5EF4-FFF2-40B4-BE49-F238E27FC236}">
                            <a16:creationId xmlns:a16="http://schemas.microsoft.com/office/drawing/2014/main" id="{3F986AC4-565B-4C58-BEE0-ED69947145F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902522" y="4788075"/>
                        <a:ext cx="0" cy="72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7" name="Connecteur droit 76">
                        <a:extLst>
                          <a:ext uri="{FF2B5EF4-FFF2-40B4-BE49-F238E27FC236}">
                            <a16:creationId xmlns:a16="http://schemas.microsoft.com/office/drawing/2014/main" id="{AE45F881-CA10-40BB-9CFB-E948D46CD58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316520" y="5501719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8" name="Connecteur droit 77">
                        <a:extLst>
                          <a:ext uri="{FF2B5EF4-FFF2-40B4-BE49-F238E27FC236}">
                            <a16:creationId xmlns:a16="http://schemas.microsoft.com/office/drawing/2014/main" id="{3BF0DDD8-F179-4587-87CD-F9B7DC0DB9C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488522" y="5508076"/>
                        <a:ext cx="828001" cy="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9" name="Ellipse 78">
                        <a:extLst>
                          <a:ext uri="{FF2B5EF4-FFF2-40B4-BE49-F238E27FC236}">
                            <a16:creationId xmlns:a16="http://schemas.microsoft.com/office/drawing/2014/main" id="{659D1C18-5F63-4FB7-B40F-49046C9DCC0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86324" y="3767616"/>
                        <a:ext cx="660395" cy="660458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/>
                      </a:p>
                    </p:txBody>
                  </p:sp>
                  <p:sp>
                    <p:nvSpPr>
                      <p:cNvPr id="80" name="Rectangle 79">
                        <a:extLst>
                          <a:ext uri="{FF2B5EF4-FFF2-40B4-BE49-F238E27FC236}">
                            <a16:creationId xmlns:a16="http://schemas.microsoft.com/office/drawing/2014/main" id="{1454FF88-08B5-4754-AC78-BA70758CF48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174131" y="3767616"/>
                        <a:ext cx="660395" cy="660458"/>
                      </a:xfrm>
                      <a:prstGeom prst="rect">
                        <a:avLst/>
                      </a:prstGeom>
                      <a:solidFill>
                        <a:schemeClr val="bg2">
                          <a:lumMod val="90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endParaRPr lang="fr-FR" sz="2560" dirty="0"/>
                      </a:p>
                    </p:txBody>
                  </p:sp>
                  <p:cxnSp>
                    <p:nvCxnSpPr>
                      <p:cNvPr id="81" name="Connecteur droit 80">
                        <a:extLst>
                          <a:ext uri="{FF2B5EF4-FFF2-40B4-BE49-F238E27FC236}">
                            <a16:creationId xmlns:a16="http://schemas.microsoft.com/office/drawing/2014/main" id="{5C01F9A8-5B95-4620-B473-C57337A1111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500301" y="4788075"/>
                        <a:ext cx="828001" cy="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2" name="Connecteur droit 81">
                        <a:extLst>
                          <a:ext uri="{FF2B5EF4-FFF2-40B4-BE49-F238E27FC236}">
                            <a16:creationId xmlns:a16="http://schemas.microsoft.com/office/drawing/2014/main" id="{EBB34FA0-3EDB-4A0E-81D7-7C8C09044E7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504331" y="4428075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3" name="Connecteur droit 82">
                        <a:extLst>
                          <a:ext uri="{FF2B5EF4-FFF2-40B4-BE49-F238E27FC236}">
                            <a16:creationId xmlns:a16="http://schemas.microsoft.com/office/drawing/2014/main" id="{1941997A-C5E4-4121-BAE8-2CCCE1F52C5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316522" y="4428075"/>
                        <a:ext cx="0" cy="360000"/>
                      </a:xfrm>
                      <a:prstGeom prst="line">
                        <a:avLst/>
                      </a:prstGeom>
                      <a:solidFill>
                        <a:schemeClr val="tx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57" name="Connecteur droit 56">
                      <a:extLst>
                        <a:ext uri="{FF2B5EF4-FFF2-40B4-BE49-F238E27FC236}">
                          <a16:creationId xmlns:a16="http://schemas.microsoft.com/office/drawing/2014/main" id="{69F555FC-1F60-4F05-8B7A-9E84F32208E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6685" y="4777356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Connecteur droit 57">
                      <a:extLst>
                        <a:ext uri="{FF2B5EF4-FFF2-40B4-BE49-F238E27FC236}">
                          <a16:creationId xmlns:a16="http://schemas.microsoft.com/office/drawing/2014/main" id="{4EC8A677-8E1B-4801-A18A-BB1B62D0A57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03897" y="4779572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" name="Connecteur droit 58">
                      <a:extLst>
                        <a:ext uri="{FF2B5EF4-FFF2-40B4-BE49-F238E27FC236}">
                          <a16:creationId xmlns:a16="http://schemas.microsoft.com/office/drawing/2014/main" id="{0A6AB8DB-4027-4C87-B3BE-8B878E95EDC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609715" y="4785761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0" name="Connecteur droit 59">
                      <a:extLst>
                        <a:ext uri="{FF2B5EF4-FFF2-40B4-BE49-F238E27FC236}">
                          <a16:creationId xmlns:a16="http://schemas.microsoft.com/office/drawing/2014/main" id="{2F3234AF-B115-4D2D-B82E-3A26BC5433F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325008" y="4779572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1" name="Connecteur droit 60">
                      <a:extLst>
                        <a:ext uri="{FF2B5EF4-FFF2-40B4-BE49-F238E27FC236}">
                          <a16:creationId xmlns:a16="http://schemas.microsoft.com/office/drawing/2014/main" id="{9B3B6334-0AA8-4EE3-84E7-C7A82B5963C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439549" y="4777355"/>
                      <a:ext cx="6089242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2" name="Connecteur droit 61">
                      <a:extLst>
                        <a:ext uri="{FF2B5EF4-FFF2-40B4-BE49-F238E27FC236}">
                          <a16:creationId xmlns:a16="http://schemas.microsoft.com/office/drawing/2014/main" id="{A74F1870-D366-4AA1-8A35-630F404A0DF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119406" y="4086095"/>
                      <a:ext cx="0" cy="691261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" name="Connecteur droit 62">
                      <a:extLst>
                        <a:ext uri="{FF2B5EF4-FFF2-40B4-BE49-F238E27FC236}">
                          <a16:creationId xmlns:a16="http://schemas.microsoft.com/office/drawing/2014/main" id="{2BD7B66A-7147-4442-B38A-4E14B6B76D9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824982" y="4083622"/>
                      <a:ext cx="58885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5" name="Ellipse 64">
                      <a:extLst>
                        <a:ext uri="{FF2B5EF4-FFF2-40B4-BE49-F238E27FC236}">
                          <a16:creationId xmlns:a16="http://schemas.microsoft.com/office/drawing/2014/main" id="{1357A940-7663-4C3E-B007-5BB18690847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73383" y="3360371"/>
                      <a:ext cx="469654" cy="469701"/>
                    </a:xfrm>
                    <a:prstGeom prst="ellipse">
                      <a:avLst/>
                    </a:prstGeom>
                    <a:solidFill>
                      <a:srgbClr val="EBE3E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sp>
                  <p:nvSpPr>
                    <p:cNvPr id="66" name="Rectangle 65">
                      <a:extLst>
                        <a:ext uri="{FF2B5EF4-FFF2-40B4-BE49-F238E27FC236}">
                          <a16:creationId xmlns:a16="http://schemas.microsoft.com/office/drawing/2014/main" id="{40F3E3F9-B2E5-4C1B-9848-F4622FB3A7D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95776" y="3360371"/>
                      <a:ext cx="469654" cy="46970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cxnSp>
                  <p:nvCxnSpPr>
                    <p:cNvPr id="67" name="Connecteur droit 66">
                      <a:extLst>
                        <a:ext uri="{FF2B5EF4-FFF2-40B4-BE49-F238E27FC236}">
                          <a16:creationId xmlns:a16="http://schemas.microsoft.com/office/drawing/2014/main" id="{8618DC1F-962D-4CD6-B7E9-AD59F12FAA4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830603" y="3830072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8" name="Connecteur droit 67">
                      <a:extLst>
                        <a:ext uri="{FF2B5EF4-FFF2-40B4-BE49-F238E27FC236}">
                          <a16:creationId xmlns:a16="http://schemas.microsoft.com/office/drawing/2014/main" id="{F481C443-3F08-4BD1-B781-4D3AD52F018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408210" y="3830072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2" name="Rectangle 121">
                      <a:extLst>
                        <a:ext uri="{FF2B5EF4-FFF2-40B4-BE49-F238E27FC236}">
                          <a16:creationId xmlns:a16="http://schemas.microsoft.com/office/drawing/2014/main" id="{900ADFD4-E494-4B7F-8A0D-BD297F46C28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294662" y="5037256"/>
                      <a:ext cx="469654" cy="46970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cxnSp>
                  <p:nvCxnSpPr>
                    <p:cNvPr id="126" name="Connecteur droit 125">
                      <a:extLst>
                        <a:ext uri="{FF2B5EF4-FFF2-40B4-BE49-F238E27FC236}">
                          <a16:creationId xmlns:a16="http://schemas.microsoft.com/office/drawing/2014/main" id="{F6CF1ED5-A446-44E8-8ACC-6DA905F71CA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526623" y="4789679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7" name="Ellipse 126">
                      <a:extLst>
                        <a:ext uri="{FF2B5EF4-FFF2-40B4-BE49-F238E27FC236}">
                          <a16:creationId xmlns:a16="http://schemas.microsoft.com/office/drawing/2014/main" id="{9C045F91-A81E-4A54-8FC9-46D61F243FE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62801" y="5028950"/>
                      <a:ext cx="469654" cy="469701"/>
                    </a:xfrm>
                    <a:prstGeom prst="ellips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sp>
                  <p:nvSpPr>
                    <p:cNvPr id="128" name="Rectangle 127">
                      <a:extLst>
                        <a:ext uri="{FF2B5EF4-FFF2-40B4-BE49-F238E27FC236}">
                          <a16:creationId xmlns:a16="http://schemas.microsoft.com/office/drawing/2014/main" id="{813D32D0-CCE5-4D0B-BC48-7CACF9405F3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30598" y="5028950"/>
                      <a:ext cx="469654" cy="46970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sp>
                  <p:nvSpPr>
                    <p:cNvPr id="129" name="Ellipse 128">
                      <a:extLst>
                        <a:ext uri="{FF2B5EF4-FFF2-40B4-BE49-F238E27FC236}">
                          <a16:creationId xmlns:a16="http://schemas.microsoft.com/office/drawing/2014/main" id="{B4735903-37EB-4AD1-B22C-D4A64FD1D7E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081310" y="6536081"/>
                      <a:ext cx="469655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sp>
                  <p:nvSpPr>
                    <p:cNvPr id="130" name="Ellipse 129">
                      <a:extLst>
                        <a:ext uri="{FF2B5EF4-FFF2-40B4-BE49-F238E27FC236}">
                          <a16:creationId xmlns:a16="http://schemas.microsoft.com/office/drawing/2014/main" id="{57273922-344A-405D-B865-C641D8A37B2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658918" y="6518221"/>
                      <a:ext cx="469655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cxnSp>
                  <p:nvCxnSpPr>
                    <p:cNvPr id="133" name="Connecteur droit 132">
                      <a:extLst>
                        <a:ext uri="{FF2B5EF4-FFF2-40B4-BE49-F238E27FC236}">
                          <a16:creationId xmlns:a16="http://schemas.microsoft.com/office/drawing/2014/main" id="{D410B0D7-7C07-49B6-B54B-0BBDECDF983B}"/>
                        </a:ext>
                      </a:extLst>
                    </p:cNvPr>
                    <p:cNvCxnSpPr>
                      <a:cxnSpLocks/>
                      <a:stCxn id="86" idx="0"/>
                    </p:cNvCxnSpPr>
                    <p:nvPr/>
                  </p:nvCxnSpPr>
                  <p:spPr>
                    <a:xfrm flipV="1">
                      <a:off x="5612581" y="6270604"/>
                      <a:ext cx="283183" cy="264971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" name="Connecteur droit 137">
                      <a:extLst>
                        <a:ext uri="{FF2B5EF4-FFF2-40B4-BE49-F238E27FC236}">
                          <a16:creationId xmlns:a16="http://schemas.microsoft.com/office/drawing/2014/main" id="{29617225-72CA-4EE1-AB25-64BD11687CA1}"/>
                        </a:ext>
                      </a:extLst>
                    </p:cNvPr>
                    <p:cNvCxnSpPr>
                      <a:cxnSpLocks/>
                      <a:endCxn id="139" idx="0"/>
                    </p:cNvCxnSpPr>
                    <p:nvPr/>
                  </p:nvCxnSpPr>
                  <p:spPr>
                    <a:xfrm>
                      <a:off x="5895762" y="6279553"/>
                      <a:ext cx="294426" cy="247074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9" name="Ellipse 138">
                      <a:extLst>
                        <a:ext uri="{FF2B5EF4-FFF2-40B4-BE49-F238E27FC236}">
                          <a16:creationId xmlns:a16="http://schemas.microsoft.com/office/drawing/2014/main" id="{80A42DB8-F234-46C6-8870-5EB8684D0B8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55360" y="6526627"/>
                      <a:ext cx="469655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cxnSp>
                  <p:nvCxnSpPr>
                    <p:cNvPr id="141" name="Connecteur droit 140">
                      <a:extLst>
                        <a:ext uri="{FF2B5EF4-FFF2-40B4-BE49-F238E27FC236}">
                          <a16:creationId xmlns:a16="http://schemas.microsoft.com/office/drawing/2014/main" id="{3D78E5F2-4FFE-490A-A366-36B8D735650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34487" y="6271148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2" name="Connecteur droit 141">
                      <a:extLst>
                        <a:ext uri="{FF2B5EF4-FFF2-40B4-BE49-F238E27FC236}">
                          <a16:creationId xmlns:a16="http://schemas.microsoft.com/office/drawing/2014/main" id="{0B7B57D4-4269-402B-8701-B3373AF05C0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28912" y="5759103"/>
                      <a:ext cx="0" cy="512045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3" name="Connecteur droit 142">
                      <a:extLst>
                        <a:ext uri="{FF2B5EF4-FFF2-40B4-BE49-F238E27FC236}">
                          <a16:creationId xmlns:a16="http://schemas.microsoft.com/office/drawing/2014/main" id="{43C538DD-857D-4DD4-8512-A3C353574C8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423336" y="6266627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4" name="Connecteur droit 143">
                      <a:extLst>
                        <a:ext uri="{FF2B5EF4-FFF2-40B4-BE49-F238E27FC236}">
                          <a16:creationId xmlns:a16="http://schemas.microsoft.com/office/drawing/2014/main" id="{F897AFA7-9C7E-4CB2-BF60-226102F1C04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34487" y="6271147"/>
                      <a:ext cx="58885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5" name="Connecteur droit 144">
                      <a:extLst>
                        <a:ext uri="{FF2B5EF4-FFF2-40B4-BE49-F238E27FC236}">
                          <a16:creationId xmlns:a16="http://schemas.microsoft.com/office/drawing/2014/main" id="{FAE03F54-6F92-411D-B9B6-2A38FD59494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40494" y="5761319"/>
                      <a:ext cx="588851" cy="0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6" name="Connecteur droit 145">
                      <a:extLst>
                        <a:ext uri="{FF2B5EF4-FFF2-40B4-BE49-F238E27FC236}">
                          <a16:creationId xmlns:a16="http://schemas.microsoft.com/office/drawing/2014/main" id="{DFF16060-7BFB-4AD3-8D73-3E11E1B739A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45730" y="5503080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7" name="Connecteur droit 146">
                      <a:extLst>
                        <a:ext uri="{FF2B5EF4-FFF2-40B4-BE49-F238E27FC236}">
                          <a16:creationId xmlns:a16="http://schemas.microsoft.com/office/drawing/2014/main" id="{653EFF36-F899-4741-8174-488B05A7094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423337" y="5503080"/>
                      <a:ext cx="0" cy="256023"/>
                    </a:xfrm>
                    <a:prstGeom prst="line">
                      <a:avLst/>
                    </a:prstGeom>
                    <a:solidFill>
                      <a:schemeClr val="tx1"/>
                    </a:solidFill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8" name="Rectangle 147">
                      <a:extLst>
                        <a:ext uri="{FF2B5EF4-FFF2-40B4-BE49-F238E27FC236}">
                          <a16:creationId xmlns:a16="http://schemas.microsoft.com/office/drawing/2014/main" id="{C24133F7-D883-4FBA-A81E-48C2DDE27A0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86882" y="6510513"/>
                      <a:ext cx="469654" cy="469701"/>
                    </a:xfrm>
                    <a:prstGeom prst="rect">
                      <a:avLst/>
                    </a:prstGeom>
                    <a:solidFill>
                      <a:schemeClr val="bg2">
                        <a:lumMod val="90000"/>
                      </a:schemeClr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 dirty="0"/>
                    </a:p>
                  </p:txBody>
                </p:sp>
                <p:sp>
                  <p:nvSpPr>
                    <p:cNvPr id="149" name="Ellipse 148">
                      <a:extLst>
                        <a:ext uri="{FF2B5EF4-FFF2-40B4-BE49-F238E27FC236}">
                          <a16:creationId xmlns:a16="http://schemas.microsoft.com/office/drawing/2014/main" id="{FDF251EE-99B2-4BE4-A9E5-B34D2060343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69070" y="6518221"/>
                      <a:ext cx="469655" cy="469701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endParaRPr lang="fr-FR" sz="2560"/>
                    </a:p>
                  </p:txBody>
                </p:sp>
                <p:cxnSp>
                  <p:nvCxnSpPr>
                    <p:cNvPr id="64" name="Connecteur droit avec flèche 63">
                      <a:extLst>
                        <a:ext uri="{FF2B5EF4-FFF2-40B4-BE49-F238E27FC236}">
                          <a16:creationId xmlns:a16="http://schemas.microsoft.com/office/drawing/2014/main" id="{A881E5B5-BCAC-4AB3-A60F-4012C08C563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499978" y="5448074"/>
                      <a:ext cx="128377" cy="176799"/>
                    </a:xfrm>
                    <a:prstGeom prst="straightConnector1">
                      <a:avLst/>
                    </a:prstGeom>
                    <a:ln w="28575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9" name="Connecteur droit 68">
                    <a:extLst>
                      <a:ext uri="{FF2B5EF4-FFF2-40B4-BE49-F238E27FC236}">
                        <a16:creationId xmlns:a16="http://schemas.microsoft.com/office/drawing/2014/main" id="{E5D07F48-EC52-494E-8BDA-368FAA0548E3}"/>
                      </a:ext>
                    </a:extLst>
                  </p:cNvPr>
                  <p:cNvCxnSpPr>
                    <a:cxnSpLocks/>
                    <a:endCxn id="70" idx="0"/>
                  </p:cNvCxnSpPr>
                  <p:nvPr/>
                </p:nvCxnSpPr>
                <p:spPr>
                  <a:xfrm>
                    <a:off x="7177587" y="3119763"/>
                    <a:ext cx="0" cy="345383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" name="Ellipse 69">
                    <a:extLst>
                      <a:ext uri="{FF2B5EF4-FFF2-40B4-BE49-F238E27FC236}">
                        <a16:creationId xmlns:a16="http://schemas.microsoft.com/office/drawing/2014/main" id="{1740E3A3-9BEE-4218-AFAB-C986770BF985}"/>
                      </a:ext>
                    </a:extLst>
                  </p:cNvPr>
                  <p:cNvSpPr/>
                  <p:nvPr/>
                </p:nvSpPr>
                <p:spPr>
                  <a:xfrm>
                    <a:off x="6863828" y="3465146"/>
                    <a:ext cx="627517" cy="627581"/>
                  </a:xfrm>
                  <a:prstGeom prst="ellipse">
                    <a:avLst/>
                  </a:prstGeom>
                  <a:solidFill>
                    <a:srgbClr val="D3E9F9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endParaRPr lang="fr-FR" sz="2560"/>
                  </a:p>
                </p:txBody>
              </p:sp>
              <p:cxnSp>
                <p:nvCxnSpPr>
                  <p:cNvPr id="71" name="Connecteur droit 70">
                    <a:extLst>
                      <a:ext uri="{FF2B5EF4-FFF2-40B4-BE49-F238E27FC236}">
                        <a16:creationId xmlns:a16="http://schemas.microsoft.com/office/drawing/2014/main" id="{1E4EAC8C-7ED4-4B44-A869-0F66599E1722}"/>
                      </a:ext>
                    </a:extLst>
                  </p:cNvPr>
                  <p:cNvCxnSpPr>
                    <a:cxnSpLocks/>
                    <a:endCxn id="65" idx="0"/>
                  </p:cNvCxnSpPr>
                  <p:nvPr/>
                </p:nvCxnSpPr>
                <p:spPr>
                  <a:xfrm>
                    <a:off x="5160434" y="3119763"/>
                    <a:ext cx="0" cy="345383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Connecteur droit 71">
                    <a:extLst>
                      <a:ext uri="{FF2B5EF4-FFF2-40B4-BE49-F238E27FC236}">
                        <a16:creationId xmlns:a16="http://schemas.microsoft.com/office/drawing/2014/main" id="{C08E1BB2-4313-4FB4-9B7B-54D5BEC4EC53}"/>
                      </a:ext>
                    </a:extLst>
                  </p:cNvPr>
                  <p:cNvCxnSpPr>
                    <a:cxnSpLocks/>
                    <a:endCxn id="74" idx="0"/>
                  </p:cNvCxnSpPr>
                  <p:nvPr/>
                </p:nvCxnSpPr>
                <p:spPr>
                  <a:xfrm>
                    <a:off x="9194739" y="3119763"/>
                    <a:ext cx="0" cy="345383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4" name="Ellipse 73">
                    <a:extLst>
                      <a:ext uri="{FF2B5EF4-FFF2-40B4-BE49-F238E27FC236}">
                        <a16:creationId xmlns:a16="http://schemas.microsoft.com/office/drawing/2014/main" id="{B9D34DD9-868C-4202-8560-41D2AC6498EE}"/>
                      </a:ext>
                    </a:extLst>
                  </p:cNvPr>
                  <p:cNvSpPr/>
                  <p:nvPr/>
                </p:nvSpPr>
                <p:spPr>
                  <a:xfrm>
                    <a:off x="8880980" y="3465146"/>
                    <a:ext cx="627517" cy="627581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endParaRPr lang="fr-FR" sz="2560"/>
                  </a:p>
                </p:txBody>
              </p:sp>
              <p:sp>
                <p:nvSpPr>
                  <p:cNvPr id="85" name="Rectangle 84">
                    <a:extLst>
                      <a:ext uri="{FF2B5EF4-FFF2-40B4-BE49-F238E27FC236}">
                        <a16:creationId xmlns:a16="http://schemas.microsoft.com/office/drawing/2014/main" id="{9436BE35-43A4-40D4-BF51-5E1F30BD249A}"/>
                      </a:ext>
                    </a:extLst>
                  </p:cNvPr>
                  <p:cNvSpPr/>
                  <p:nvPr/>
                </p:nvSpPr>
                <p:spPr>
                  <a:xfrm>
                    <a:off x="10898132" y="3465145"/>
                    <a:ext cx="627517" cy="62758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endParaRPr lang="fr-FR" sz="2560" dirty="0"/>
                  </a:p>
                </p:txBody>
              </p:sp>
              <p:cxnSp>
                <p:nvCxnSpPr>
                  <p:cNvPr id="87" name="Connecteur droit 86">
                    <a:extLst>
                      <a:ext uri="{FF2B5EF4-FFF2-40B4-BE49-F238E27FC236}">
                        <a16:creationId xmlns:a16="http://schemas.microsoft.com/office/drawing/2014/main" id="{1F3C89C5-CE9C-4CBA-805E-352270FED21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11890" y="3119763"/>
                    <a:ext cx="0" cy="345383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Connecteur droit 88">
                    <a:extLst>
                      <a:ext uri="{FF2B5EF4-FFF2-40B4-BE49-F238E27FC236}">
                        <a16:creationId xmlns:a16="http://schemas.microsoft.com/office/drawing/2014/main" id="{CA81FD71-9734-4930-BCF1-B6F3F1F3935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60433" y="3119763"/>
                    <a:ext cx="6048000" cy="0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Connecteur droit 98">
                    <a:extLst>
                      <a:ext uri="{FF2B5EF4-FFF2-40B4-BE49-F238E27FC236}">
                        <a16:creationId xmlns:a16="http://schemas.microsoft.com/office/drawing/2014/main" id="{90DD14EC-AAA8-4959-9B3C-616DB8E2E023}"/>
                      </a:ext>
                    </a:extLst>
                  </p:cNvPr>
                  <p:cNvCxnSpPr/>
                  <p:nvPr/>
                </p:nvCxnSpPr>
                <p:spPr>
                  <a:xfrm>
                    <a:off x="4749874" y="1876380"/>
                    <a:ext cx="0" cy="342080"/>
                  </a:xfrm>
                  <a:prstGeom prst="line">
                    <a:avLst/>
                  </a:prstGeom>
                  <a:solidFill>
                    <a:schemeClr val="tx1"/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1" name="ZoneTexte 100">
                    <a:extLst>
                      <a:ext uri="{FF2B5EF4-FFF2-40B4-BE49-F238E27FC236}">
                        <a16:creationId xmlns:a16="http://schemas.microsoft.com/office/drawing/2014/main" id="{4774B499-C9D6-4F28-B771-71937BD93DF1}"/>
                      </a:ext>
                    </a:extLst>
                  </p:cNvPr>
                  <p:cNvSpPr txBox="1"/>
                  <p:nvPr/>
                </p:nvSpPr>
                <p:spPr>
                  <a:xfrm>
                    <a:off x="1025524" y="1859226"/>
                    <a:ext cx="997282" cy="7626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Prostate cancer</a:t>
                    </a:r>
                  </a:p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(72)</a:t>
                    </a:r>
                  </a:p>
                </p:txBody>
              </p:sp>
              <p:sp>
                <p:nvSpPr>
                  <p:cNvPr id="114" name="ZoneTexte 113">
                    <a:extLst>
                      <a:ext uri="{FF2B5EF4-FFF2-40B4-BE49-F238E27FC236}">
                        <a16:creationId xmlns:a16="http://schemas.microsoft.com/office/drawing/2014/main" id="{D0FEF08D-C6E4-4A6F-B794-6FD8D90AF802}"/>
                      </a:ext>
                    </a:extLst>
                  </p:cNvPr>
                  <p:cNvSpPr txBox="1"/>
                  <p:nvPr/>
                </p:nvSpPr>
                <p:spPr>
                  <a:xfrm>
                    <a:off x="5176687" y="4088633"/>
                    <a:ext cx="1528911" cy="7626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Small-cell lung cancer</a:t>
                    </a:r>
                  </a:p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(77)</a:t>
                    </a:r>
                  </a:p>
                </p:txBody>
              </p:sp>
              <p:sp>
                <p:nvSpPr>
                  <p:cNvPr id="116" name="ZoneTexte 115">
                    <a:extLst>
                      <a:ext uri="{FF2B5EF4-FFF2-40B4-BE49-F238E27FC236}">
                        <a16:creationId xmlns:a16="http://schemas.microsoft.com/office/drawing/2014/main" id="{2BAF1ECC-9BF0-4609-85E1-B3EC99418FE2}"/>
                      </a:ext>
                    </a:extLst>
                  </p:cNvPr>
                  <p:cNvSpPr txBox="1"/>
                  <p:nvPr/>
                </p:nvSpPr>
                <p:spPr>
                  <a:xfrm>
                    <a:off x="7019104" y="4089344"/>
                    <a:ext cx="1646275" cy="64633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rPr>
                      <a:t>Breast cancer</a:t>
                    </a:r>
                  </a:p>
                  <a:p>
                    <a:r>
                      <a:rPr lang="en-GB" dirty="0">
                        <a:latin typeface="Calibri" panose="020F0502020204030204" pitchFamily="34" charset="0"/>
                      </a:rPr>
                      <a:t>Uterine cancer</a:t>
                    </a:r>
                    <a:endParaRPr lang="fr-FR" dirty="0"/>
                  </a:p>
                </p:txBody>
              </p:sp>
              <p:sp>
                <p:nvSpPr>
                  <p:cNvPr id="118" name="ZoneTexte 117">
                    <a:extLst>
                      <a:ext uri="{FF2B5EF4-FFF2-40B4-BE49-F238E27FC236}">
                        <a16:creationId xmlns:a16="http://schemas.microsoft.com/office/drawing/2014/main" id="{349E8D92-5DC1-4FBF-B81E-4A131D65347B}"/>
                      </a:ext>
                    </a:extLst>
                  </p:cNvPr>
                  <p:cNvSpPr txBox="1"/>
                  <p:nvPr/>
                </p:nvSpPr>
                <p:spPr>
                  <a:xfrm>
                    <a:off x="11053281" y="3554119"/>
                    <a:ext cx="310304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2000" dirty="0"/>
                      <a:t>3</a:t>
                    </a:r>
                  </a:p>
                </p:txBody>
              </p:sp>
              <p:sp>
                <p:nvSpPr>
                  <p:cNvPr id="119" name="ZoneTexte 118">
                    <a:extLst>
                      <a:ext uri="{FF2B5EF4-FFF2-40B4-BE49-F238E27FC236}">
                        <a16:creationId xmlns:a16="http://schemas.microsoft.com/office/drawing/2014/main" id="{565E2E1C-3038-40C2-A6D8-DEE05F3E0FB4}"/>
                      </a:ext>
                    </a:extLst>
                  </p:cNvPr>
                  <p:cNvSpPr txBox="1"/>
                  <p:nvPr/>
                </p:nvSpPr>
                <p:spPr>
                  <a:xfrm>
                    <a:off x="9045948" y="3551359"/>
                    <a:ext cx="298077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2000" dirty="0"/>
                      <a:t>5</a:t>
                    </a:r>
                    <a:endParaRPr lang="fr-FR" dirty="0"/>
                  </a:p>
                </p:txBody>
              </p:sp>
              <p:sp>
                <p:nvSpPr>
                  <p:cNvPr id="120" name="ZoneTexte 119">
                    <a:extLst>
                      <a:ext uri="{FF2B5EF4-FFF2-40B4-BE49-F238E27FC236}">
                        <a16:creationId xmlns:a16="http://schemas.microsoft.com/office/drawing/2014/main" id="{C44FFA81-2952-4AF2-B276-E843DAFCE02A}"/>
                      </a:ext>
                    </a:extLst>
                  </p:cNvPr>
                  <p:cNvSpPr txBox="1"/>
                  <p:nvPr/>
                </p:nvSpPr>
                <p:spPr>
                  <a:xfrm>
                    <a:off x="2516875" y="6503225"/>
                    <a:ext cx="949277" cy="5410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fr-FR" dirty="0"/>
                      <a:t>PTC</a:t>
                    </a:r>
                  </a:p>
                  <a:p>
                    <a:pPr>
                      <a:lnSpc>
                        <a:spcPct val="80000"/>
                      </a:lnSpc>
                    </a:pPr>
                    <a:r>
                      <a:rPr lang="fr-FR" dirty="0"/>
                      <a:t>(52)</a:t>
                    </a:r>
                  </a:p>
                </p:txBody>
              </p:sp>
              <p:sp>
                <p:nvSpPr>
                  <p:cNvPr id="121" name="ZoneTexte 120">
                    <a:extLst>
                      <a:ext uri="{FF2B5EF4-FFF2-40B4-BE49-F238E27FC236}">
                        <a16:creationId xmlns:a16="http://schemas.microsoft.com/office/drawing/2014/main" id="{31CC669B-758B-4027-BEAF-952D5E985842}"/>
                      </a:ext>
                    </a:extLst>
                  </p:cNvPr>
                  <p:cNvSpPr txBox="1"/>
                  <p:nvPr/>
                </p:nvSpPr>
                <p:spPr>
                  <a:xfrm>
                    <a:off x="650808" y="6499119"/>
                    <a:ext cx="949277" cy="5410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fr-FR" dirty="0"/>
                      <a:t>PTC</a:t>
                    </a:r>
                  </a:p>
                  <a:p>
                    <a:pPr>
                      <a:lnSpc>
                        <a:spcPct val="80000"/>
                      </a:lnSpc>
                    </a:pPr>
                    <a:r>
                      <a:rPr lang="fr-FR" dirty="0"/>
                      <a:t>(55)</a:t>
                    </a:r>
                  </a:p>
                </p:txBody>
              </p:sp>
              <p:sp>
                <p:nvSpPr>
                  <p:cNvPr id="123" name="ZoneTexte 122">
                    <a:extLst>
                      <a:ext uri="{FF2B5EF4-FFF2-40B4-BE49-F238E27FC236}">
                        <a16:creationId xmlns:a16="http://schemas.microsoft.com/office/drawing/2014/main" id="{00DD2D64-6AF7-4D83-800F-B335E0A64E61}"/>
                      </a:ext>
                    </a:extLst>
                  </p:cNvPr>
                  <p:cNvSpPr txBox="1"/>
                  <p:nvPr/>
                </p:nvSpPr>
                <p:spPr>
                  <a:xfrm>
                    <a:off x="533305" y="6246688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1</a:t>
                    </a:r>
                  </a:p>
                </p:txBody>
              </p:sp>
              <p:sp>
                <p:nvSpPr>
                  <p:cNvPr id="124" name="ZoneTexte 123">
                    <a:extLst>
                      <a:ext uri="{FF2B5EF4-FFF2-40B4-BE49-F238E27FC236}">
                        <a16:creationId xmlns:a16="http://schemas.microsoft.com/office/drawing/2014/main" id="{42279A9C-1A11-498B-887A-BBC7D42D8DFB}"/>
                      </a:ext>
                    </a:extLst>
                  </p:cNvPr>
                  <p:cNvSpPr txBox="1"/>
                  <p:nvPr/>
                </p:nvSpPr>
                <p:spPr>
                  <a:xfrm>
                    <a:off x="2325950" y="6338286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2</a:t>
                    </a:r>
                  </a:p>
                </p:txBody>
              </p:sp>
              <p:sp>
                <p:nvSpPr>
                  <p:cNvPr id="125" name="ZoneTexte 124">
                    <a:extLst>
                      <a:ext uri="{FF2B5EF4-FFF2-40B4-BE49-F238E27FC236}">
                        <a16:creationId xmlns:a16="http://schemas.microsoft.com/office/drawing/2014/main" id="{76B8BAF3-931A-44F5-8778-DD69D05A022A}"/>
                      </a:ext>
                    </a:extLst>
                  </p:cNvPr>
                  <p:cNvSpPr txBox="1"/>
                  <p:nvPr/>
                </p:nvSpPr>
                <p:spPr>
                  <a:xfrm>
                    <a:off x="4812840" y="6338286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3</a:t>
                    </a:r>
                  </a:p>
                </p:txBody>
              </p:sp>
              <p:sp>
                <p:nvSpPr>
                  <p:cNvPr id="131" name="ZoneTexte 130">
                    <a:extLst>
                      <a:ext uri="{FF2B5EF4-FFF2-40B4-BE49-F238E27FC236}">
                        <a16:creationId xmlns:a16="http://schemas.microsoft.com/office/drawing/2014/main" id="{B6FBE0D6-B99D-4ADF-8D0E-25014A783512}"/>
                      </a:ext>
                    </a:extLst>
                  </p:cNvPr>
                  <p:cNvSpPr txBox="1"/>
                  <p:nvPr/>
                </p:nvSpPr>
                <p:spPr>
                  <a:xfrm>
                    <a:off x="7128003" y="6338286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4</a:t>
                    </a:r>
                  </a:p>
                </p:txBody>
              </p:sp>
              <p:sp>
                <p:nvSpPr>
                  <p:cNvPr id="132" name="ZoneTexte 131">
                    <a:extLst>
                      <a:ext uri="{FF2B5EF4-FFF2-40B4-BE49-F238E27FC236}">
                        <a16:creationId xmlns:a16="http://schemas.microsoft.com/office/drawing/2014/main" id="{A992968A-2DE6-4E93-8F18-7566A5D75585}"/>
                      </a:ext>
                    </a:extLst>
                  </p:cNvPr>
                  <p:cNvSpPr txBox="1"/>
                  <p:nvPr/>
                </p:nvSpPr>
                <p:spPr>
                  <a:xfrm>
                    <a:off x="4292566" y="6673120"/>
                    <a:ext cx="1406575" cy="5410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Multinodular goitre</a:t>
                    </a:r>
                  </a:p>
                </p:txBody>
              </p:sp>
              <p:sp>
                <p:nvSpPr>
                  <p:cNvPr id="136" name="ZoneTexte 135">
                    <a:extLst>
                      <a:ext uri="{FF2B5EF4-FFF2-40B4-BE49-F238E27FC236}">
                        <a16:creationId xmlns:a16="http://schemas.microsoft.com/office/drawing/2014/main" id="{D0C15DE6-0FB7-44F3-A820-158AD4F6E171}"/>
                      </a:ext>
                    </a:extLst>
                  </p:cNvPr>
                  <p:cNvSpPr txBox="1"/>
                  <p:nvPr/>
                </p:nvSpPr>
                <p:spPr>
                  <a:xfrm>
                    <a:off x="3290725" y="8059305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5</a:t>
                    </a:r>
                  </a:p>
                </p:txBody>
              </p:sp>
              <p:sp>
                <p:nvSpPr>
                  <p:cNvPr id="137" name="ZoneTexte 136">
                    <a:extLst>
                      <a:ext uri="{FF2B5EF4-FFF2-40B4-BE49-F238E27FC236}">
                        <a16:creationId xmlns:a16="http://schemas.microsoft.com/office/drawing/2014/main" id="{751B8480-7593-4CF4-BF85-C703407D7FD3}"/>
                      </a:ext>
                    </a:extLst>
                  </p:cNvPr>
                  <p:cNvSpPr txBox="1"/>
                  <p:nvPr/>
                </p:nvSpPr>
                <p:spPr>
                  <a:xfrm>
                    <a:off x="6705598" y="6688958"/>
                    <a:ext cx="1406575" cy="5410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GB" dirty="0"/>
                      <a:t>Multinodular goitre</a:t>
                    </a:r>
                  </a:p>
                </p:txBody>
              </p:sp>
            </p:grpSp>
          </p:grpSp>
          <p:grpSp>
            <p:nvGrpSpPr>
              <p:cNvPr id="18" name="Groupe 17">
                <a:extLst>
                  <a:ext uri="{FF2B5EF4-FFF2-40B4-BE49-F238E27FC236}">
                    <a16:creationId xmlns:a16="http://schemas.microsoft.com/office/drawing/2014/main" id="{7185F0A8-F985-45A1-AFAA-CB0E5EE4753E}"/>
                  </a:ext>
                </a:extLst>
              </p:cNvPr>
              <p:cNvGrpSpPr/>
              <p:nvPr/>
            </p:nvGrpSpPr>
            <p:grpSpPr>
              <a:xfrm>
                <a:off x="437751" y="1587134"/>
                <a:ext cx="473460" cy="6762082"/>
                <a:chOff x="437751" y="1587134"/>
                <a:chExt cx="473460" cy="6762082"/>
              </a:xfrm>
            </p:grpSpPr>
            <p:sp>
              <p:nvSpPr>
                <p:cNvPr id="140" name="ZoneTexte 139">
                  <a:extLst>
                    <a:ext uri="{FF2B5EF4-FFF2-40B4-BE49-F238E27FC236}">
                      <a16:creationId xmlns:a16="http://schemas.microsoft.com/office/drawing/2014/main" id="{1648E80B-AF3A-4733-9F94-E3F3E0A6A3A9}"/>
                    </a:ext>
                  </a:extLst>
                </p:cNvPr>
                <p:cNvSpPr txBox="1"/>
                <p:nvPr/>
              </p:nvSpPr>
              <p:spPr>
                <a:xfrm>
                  <a:off x="451355" y="5812370"/>
                  <a:ext cx="45675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b="1" dirty="0"/>
                    <a:t>III</a:t>
                  </a:r>
                  <a:endParaRPr lang="en-GB" sz="1400" b="1" dirty="0"/>
                </a:p>
              </p:txBody>
            </p:sp>
            <p:sp>
              <p:nvSpPr>
                <p:cNvPr id="151" name="ZoneTexte 150">
                  <a:extLst>
                    <a:ext uri="{FF2B5EF4-FFF2-40B4-BE49-F238E27FC236}">
                      <a16:creationId xmlns:a16="http://schemas.microsoft.com/office/drawing/2014/main" id="{B36F058B-DBBC-46ED-9532-0317E6450756}"/>
                    </a:ext>
                  </a:extLst>
                </p:cNvPr>
                <p:cNvSpPr txBox="1"/>
                <p:nvPr/>
              </p:nvSpPr>
              <p:spPr>
                <a:xfrm>
                  <a:off x="454461" y="1587134"/>
                  <a:ext cx="45675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b="1" dirty="0"/>
                    <a:t>I</a:t>
                  </a:r>
                  <a:endParaRPr lang="en-GB" sz="1400" b="1" dirty="0"/>
                </a:p>
              </p:txBody>
            </p:sp>
            <p:sp>
              <p:nvSpPr>
                <p:cNvPr id="152" name="ZoneTexte 151">
                  <a:extLst>
                    <a:ext uri="{FF2B5EF4-FFF2-40B4-BE49-F238E27FC236}">
                      <a16:creationId xmlns:a16="http://schemas.microsoft.com/office/drawing/2014/main" id="{AF51E21C-4425-4B6D-9CBF-CA230B9F22AC}"/>
                    </a:ext>
                  </a:extLst>
                </p:cNvPr>
                <p:cNvSpPr txBox="1"/>
                <p:nvPr/>
              </p:nvSpPr>
              <p:spPr>
                <a:xfrm>
                  <a:off x="437751" y="3723870"/>
                  <a:ext cx="45675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b="1" dirty="0"/>
                    <a:t>II</a:t>
                  </a:r>
                  <a:endParaRPr lang="en-GB" sz="1400" b="1" dirty="0"/>
                </a:p>
              </p:txBody>
            </p:sp>
            <p:sp>
              <p:nvSpPr>
                <p:cNvPr id="153" name="ZoneTexte 152">
                  <a:extLst>
                    <a:ext uri="{FF2B5EF4-FFF2-40B4-BE49-F238E27FC236}">
                      <a16:creationId xmlns:a16="http://schemas.microsoft.com/office/drawing/2014/main" id="{30BE08E9-8CAE-4FB9-8BDE-3772D75E691B}"/>
                    </a:ext>
                  </a:extLst>
                </p:cNvPr>
                <p:cNvSpPr txBox="1"/>
                <p:nvPr/>
              </p:nvSpPr>
              <p:spPr>
                <a:xfrm>
                  <a:off x="451355" y="7949106"/>
                  <a:ext cx="45675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b="1" dirty="0"/>
                    <a:t>IV</a:t>
                  </a:r>
                  <a:endParaRPr lang="en-GB" sz="1400" b="1" dirty="0"/>
                </a:p>
              </p:txBody>
            </p:sp>
          </p:grpSp>
        </p:grpSp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C121F4DE-4657-4D20-866E-3292262E8744}"/>
                </a:ext>
              </a:extLst>
            </p:cNvPr>
            <p:cNvGrpSpPr/>
            <p:nvPr/>
          </p:nvGrpSpPr>
          <p:grpSpPr>
            <a:xfrm>
              <a:off x="1633970" y="1358601"/>
              <a:ext cx="7340366" cy="5197103"/>
              <a:chOff x="1633970" y="1358601"/>
              <a:chExt cx="7340366" cy="5197103"/>
            </a:xfrm>
          </p:grpSpPr>
          <p:sp>
            <p:nvSpPr>
              <p:cNvPr id="134" name="ZoneTexte 133">
                <a:extLst>
                  <a:ext uri="{FF2B5EF4-FFF2-40B4-BE49-F238E27FC236}">
                    <a16:creationId xmlns:a16="http://schemas.microsoft.com/office/drawing/2014/main" id="{A4CE458B-CEB4-4591-8784-78A5F07654F1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1633970" y="5785389"/>
                <a:ext cx="829235" cy="7560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3600" dirty="0"/>
              </a:p>
            </p:txBody>
          </p:sp>
          <p:sp>
            <p:nvSpPr>
              <p:cNvPr id="154" name="ZoneTexte 153">
                <a:extLst>
                  <a:ext uri="{FF2B5EF4-FFF2-40B4-BE49-F238E27FC236}">
                    <a16:creationId xmlns:a16="http://schemas.microsoft.com/office/drawing/2014/main" id="{2D5A8D4D-9EBC-4212-ADD7-76C2DE9EA4B2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8145101" y="5788988"/>
                <a:ext cx="829235" cy="7560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3600" dirty="0"/>
              </a:p>
            </p:txBody>
          </p:sp>
          <p:sp>
            <p:nvSpPr>
              <p:cNvPr id="155" name="ZoneTexte 154">
                <a:extLst>
                  <a:ext uri="{FF2B5EF4-FFF2-40B4-BE49-F238E27FC236}">
                    <a16:creationId xmlns:a16="http://schemas.microsoft.com/office/drawing/2014/main" id="{3828D2EA-EF2F-4425-8087-D904A0808EA6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863246" y="5799704"/>
                <a:ext cx="829235" cy="7560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3600" dirty="0"/>
              </a:p>
            </p:txBody>
          </p:sp>
          <p:sp>
            <p:nvSpPr>
              <p:cNvPr id="156" name="ZoneTexte 155">
                <a:extLst>
                  <a:ext uri="{FF2B5EF4-FFF2-40B4-BE49-F238E27FC236}">
                    <a16:creationId xmlns:a16="http://schemas.microsoft.com/office/drawing/2014/main" id="{5AC33FFE-9A4F-4097-A42A-F8E141BD8A21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428917" y="5777470"/>
                <a:ext cx="829235" cy="7560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3600" dirty="0"/>
              </a:p>
            </p:txBody>
          </p:sp>
          <p:cxnSp>
            <p:nvCxnSpPr>
              <p:cNvPr id="157" name="Connecteur droit 156">
                <a:extLst>
                  <a:ext uri="{FF2B5EF4-FFF2-40B4-BE49-F238E27FC236}">
                    <a16:creationId xmlns:a16="http://schemas.microsoft.com/office/drawing/2014/main" id="{C5E67A1D-8DE4-4548-B705-1CFCE423FF19}"/>
                  </a:ext>
                </a:extLst>
              </p:cNvPr>
              <p:cNvCxnSpPr/>
              <p:nvPr/>
            </p:nvCxnSpPr>
            <p:spPr>
              <a:xfrm>
                <a:off x="3187408" y="2328262"/>
                <a:ext cx="0" cy="923614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Connecteur droit 157">
                <a:extLst>
                  <a:ext uri="{FF2B5EF4-FFF2-40B4-BE49-F238E27FC236}">
                    <a16:creationId xmlns:a16="http://schemas.microsoft.com/office/drawing/2014/main" id="{C3F4C82E-33BA-40EF-8473-884BE0ACFB98}"/>
                  </a:ext>
                </a:extLst>
              </p:cNvPr>
              <p:cNvCxnSpPr/>
              <p:nvPr/>
            </p:nvCxnSpPr>
            <p:spPr>
              <a:xfrm>
                <a:off x="2794021" y="2324957"/>
                <a:ext cx="786780" cy="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Ellipse 158">
                <a:extLst>
                  <a:ext uri="{FF2B5EF4-FFF2-40B4-BE49-F238E27FC236}">
                    <a16:creationId xmlns:a16="http://schemas.microsoft.com/office/drawing/2014/main" id="{0C901EA8-2155-4E21-837C-326DD6A9D252}"/>
                  </a:ext>
                </a:extLst>
              </p:cNvPr>
              <p:cNvSpPr/>
              <p:nvPr/>
            </p:nvSpPr>
            <p:spPr>
              <a:xfrm>
                <a:off x="3259529" y="1358601"/>
                <a:ext cx="627517" cy="62758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/>
              </a:p>
            </p:txBody>
          </p: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3FA61A80-C001-4FBA-96BE-07898B846B1E}"/>
                  </a:ext>
                </a:extLst>
              </p:cNvPr>
              <p:cNvSpPr/>
              <p:nvPr/>
            </p:nvSpPr>
            <p:spPr>
              <a:xfrm>
                <a:off x="2487772" y="1358601"/>
                <a:ext cx="627517" cy="627581"/>
              </a:xfrm>
              <a:prstGeom prst="rect">
                <a:avLst/>
              </a:prstGeom>
              <a:solidFill>
                <a:srgbClr val="E9DBF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 dirty="0"/>
              </a:p>
            </p:txBody>
          </p:sp>
          <p:cxnSp>
            <p:nvCxnSpPr>
              <p:cNvPr id="161" name="Connecteur droit 160">
                <a:extLst>
                  <a:ext uri="{FF2B5EF4-FFF2-40B4-BE49-F238E27FC236}">
                    <a16:creationId xmlns:a16="http://schemas.microsoft.com/office/drawing/2014/main" id="{DAA936D6-F5E0-4B91-AA2C-ADE15C7AD0E1}"/>
                  </a:ext>
                </a:extLst>
              </p:cNvPr>
              <p:cNvCxnSpPr/>
              <p:nvPr/>
            </p:nvCxnSpPr>
            <p:spPr>
              <a:xfrm>
                <a:off x="3573287" y="1986182"/>
                <a:ext cx="0" cy="34208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Connecteur droit 161">
                <a:extLst>
                  <a:ext uri="{FF2B5EF4-FFF2-40B4-BE49-F238E27FC236}">
                    <a16:creationId xmlns:a16="http://schemas.microsoft.com/office/drawing/2014/main" id="{80285FD8-22C9-4A8D-8A41-8B18CA0D200D}"/>
                  </a:ext>
                </a:extLst>
              </p:cNvPr>
              <p:cNvCxnSpPr/>
              <p:nvPr/>
            </p:nvCxnSpPr>
            <p:spPr>
              <a:xfrm>
                <a:off x="5998633" y="2358160"/>
                <a:ext cx="0" cy="923614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Connecteur droit 162">
                <a:extLst>
                  <a:ext uri="{FF2B5EF4-FFF2-40B4-BE49-F238E27FC236}">
                    <a16:creationId xmlns:a16="http://schemas.microsoft.com/office/drawing/2014/main" id="{882FBB1C-D680-45AE-9D8E-138C46ED59FB}"/>
                  </a:ext>
                </a:extLst>
              </p:cNvPr>
              <p:cNvCxnSpPr/>
              <p:nvPr/>
            </p:nvCxnSpPr>
            <p:spPr>
              <a:xfrm>
                <a:off x="5605246" y="2354855"/>
                <a:ext cx="786780" cy="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Ellipse 163">
                <a:extLst>
                  <a:ext uri="{FF2B5EF4-FFF2-40B4-BE49-F238E27FC236}">
                    <a16:creationId xmlns:a16="http://schemas.microsoft.com/office/drawing/2014/main" id="{46AE595B-11FF-448F-969A-7A10C4C0E7FC}"/>
                  </a:ext>
                </a:extLst>
              </p:cNvPr>
              <p:cNvSpPr/>
              <p:nvPr/>
            </p:nvSpPr>
            <p:spPr>
              <a:xfrm>
                <a:off x="6070754" y="1388499"/>
                <a:ext cx="627517" cy="627581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/>
              </a:p>
            </p:txBody>
          </p:sp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id="{3240C6E6-9226-417B-B7C2-2D75E2B4CAE3}"/>
                  </a:ext>
                </a:extLst>
              </p:cNvPr>
              <p:cNvSpPr/>
              <p:nvPr/>
            </p:nvSpPr>
            <p:spPr>
              <a:xfrm>
                <a:off x="5298997" y="1388499"/>
                <a:ext cx="627517" cy="62758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 dirty="0"/>
              </a:p>
            </p:txBody>
          </p:sp>
          <p:cxnSp>
            <p:nvCxnSpPr>
              <p:cNvPr id="166" name="Connecteur droit 165">
                <a:extLst>
                  <a:ext uri="{FF2B5EF4-FFF2-40B4-BE49-F238E27FC236}">
                    <a16:creationId xmlns:a16="http://schemas.microsoft.com/office/drawing/2014/main" id="{D4324B3A-9799-4A35-B391-FFD10A71DCAD}"/>
                  </a:ext>
                </a:extLst>
              </p:cNvPr>
              <p:cNvCxnSpPr/>
              <p:nvPr/>
            </p:nvCxnSpPr>
            <p:spPr>
              <a:xfrm>
                <a:off x="6384512" y="2016080"/>
                <a:ext cx="0" cy="34208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Connecteur droit 166">
                <a:extLst>
                  <a:ext uri="{FF2B5EF4-FFF2-40B4-BE49-F238E27FC236}">
                    <a16:creationId xmlns:a16="http://schemas.microsoft.com/office/drawing/2014/main" id="{1F28D091-9827-4CD1-BBFC-34927BD05D1F}"/>
                  </a:ext>
                </a:extLst>
              </p:cNvPr>
              <p:cNvCxnSpPr/>
              <p:nvPr/>
            </p:nvCxnSpPr>
            <p:spPr>
              <a:xfrm>
                <a:off x="2794021" y="1982877"/>
                <a:ext cx="0" cy="34208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Connecteur droit 167">
                <a:extLst>
                  <a:ext uri="{FF2B5EF4-FFF2-40B4-BE49-F238E27FC236}">
                    <a16:creationId xmlns:a16="http://schemas.microsoft.com/office/drawing/2014/main" id="{6D399EFF-EAE4-456E-B110-18E35873FA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19034" y="3251876"/>
                <a:ext cx="0" cy="345383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Connecteur droit 168">
                <a:extLst>
                  <a:ext uri="{FF2B5EF4-FFF2-40B4-BE49-F238E27FC236}">
                    <a16:creationId xmlns:a16="http://schemas.microsoft.com/office/drawing/2014/main" id="{BA8E128E-1743-42FB-A3F3-518EB7E840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6877" y="3259463"/>
                <a:ext cx="2700000" cy="0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Rectangle 169">
                <a:extLst>
                  <a:ext uri="{FF2B5EF4-FFF2-40B4-BE49-F238E27FC236}">
                    <a16:creationId xmlns:a16="http://schemas.microsoft.com/office/drawing/2014/main" id="{8DCD1B55-7DDC-4931-A96C-389230E918E3}"/>
                  </a:ext>
                </a:extLst>
              </p:cNvPr>
              <p:cNvSpPr/>
              <p:nvPr/>
            </p:nvSpPr>
            <p:spPr>
              <a:xfrm>
                <a:off x="2213118" y="3610134"/>
                <a:ext cx="627517" cy="62758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2560" dirty="0"/>
              </a:p>
            </p:txBody>
          </p:sp>
          <p:cxnSp>
            <p:nvCxnSpPr>
              <p:cNvPr id="171" name="Connecteur droit 170">
                <a:extLst>
                  <a:ext uri="{FF2B5EF4-FFF2-40B4-BE49-F238E27FC236}">
                    <a16:creationId xmlns:a16="http://schemas.microsoft.com/office/drawing/2014/main" id="{CE0EB646-ECD0-40B4-ABDE-8492178883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35735" y="3259463"/>
                <a:ext cx="0" cy="345383"/>
              </a:xfrm>
              <a:prstGeom prst="line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ZoneTexte 171">
                <a:extLst>
                  <a:ext uri="{FF2B5EF4-FFF2-40B4-BE49-F238E27FC236}">
                    <a16:creationId xmlns:a16="http://schemas.microsoft.com/office/drawing/2014/main" id="{ADBBD573-F524-4D71-B732-26CDACCC4AD9}"/>
                  </a:ext>
                </a:extLst>
              </p:cNvPr>
              <p:cNvSpPr txBox="1"/>
              <p:nvPr/>
            </p:nvSpPr>
            <p:spPr>
              <a:xfrm>
                <a:off x="2367985" y="3691059"/>
                <a:ext cx="2980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000" dirty="0"/>
                  <a:t>2</a:t>
                </a:r>
                <a:endParaRPr lang="fr-FR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96917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ZoneTexte 321">
            <a:extLst>
              <a:ext uri="{FF2B5EF4-FFF2-40B4-BE49-F238E27FC236}">
                <a16:creationId xmlns:a16="http://schemas.microsoft.com/office/drawing/2014/main" id="{EF5CDF2E-3B6D-48A3-9393-47FAAD82D8B0}"/>
              </a:ext>
            </a:extLst>
          </p:cNvPr>
          <p:cNvSpPr txBox="1"/>
          <p:nvPr/>
        </p:nvSpPr>
        <p:spPr>
          <a:xfrm>
            <a:off x="5650575" y="412976"/>
            <a:ext cx="150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Family E</a:t>
            </a:r>
          </a:p>
        </p:txBody>
      </p: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1AB1CE9E-8A50-4B9D-9B67-41FE0F6503BB}"/>
              </a:ext>
            </a:extLst>
          </p:cNvPr>
          <p:cNvGrpSpPr/>
          <p:nvPr/>
        </p:nvGrpSpPr>
        <p:grpSpPr>
          <a:xfrm>
            <a:off x="374758" y="1790128"/>
            <a:ext cx="11980780" cy="6829639"/>
            <a:chOff x="374758" y="1790128"/>
            <a:chExt cx="11980780" cy="6829639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7873A9BE-F086-4F39-88DE-B8290B8CCBC1}"/>
                </a:ext>
              </a:extLst>
            </p:cNvPr>
            <p:cNvGrpSpPr/>
            <p:nvPr/>
          </p:nvGrpSpPr>
          <p:grpSpPr>
            <a:xfrm>
              <a:off x="374758" y="1790128"/>
              <a:ext cx="11980780" cy="6829639"/>
              <a:chOff x="374758" y="1790128"/>
              <a:chExt cx="11980780" cy="6829639"/>
            </a:xfrm>
          </p:grpSpPr>
          <p:grpSp>
            <p:nvGrpSpPr>
              <p:cNvPr id="43" name="Groupe 42">
                <a:extLst>
                  <a:ext uri="{FF2B5EF4-FFF2-40B4-BE49-F238E27FC236}">
                    <a16:creationId xmlns:a16="http://schemas.microsoft.com/office/drawing/2014/main" id="{18D7AD28-235F-4725-BD04-7EC9417D8420}"/>
                  </a:ext>
                </a:extLst>
              </p:cNvPr>
              <p:cNvGrpSpPr/>
              <p:nvPr/>
            </p:nvGrpSpPr>
            <p:grpSpPr>
              <a:xfrm>
                <a:off x="374758" y="1790128"/>
                <a:ext cx="11980780" cy="6829639"/>
                <a:chOff x="374758" y="1790128"/>
                <a:chExt cx="11980780" cy="6829639"/>
              </a:xfrm>
            </p:grpSpPr>
            <p:grpSp>
              <p:nvGrpSpPr>
                <p:cNvPr id="33" name="Groupe 32">
                  <a:extLst>
                    <a:ext uri="{FF2B5EF4-FFF2-40B4-BE49-F238E27FC236}">
                      <a16:creationId xmlns:a16="http://schemas.microsoft.com/office/drawing/2014/main" id="{728DE224-BB9D-4E44-B4E3-762D763B14C9}"/>
                    </a:ext>
                  </a:extLst>
                </p:cNvPr>
                <p:cNvGrpSpPr/>
                <p:nvPr/>
              </p:nvGrpSpPr>
              <p:grpSpPr>
                <a:xfrm>
                  <a:off x="374758" y="1790128"/>
                  <a:ext cx="11980780" cy="6829639"/>
                  <a:chOff x="374758" y="1790128"/>
                  <a:chExt cx="11980780" cy="6829639"/>
                </a:xfrm>
              </p:grpSpPr>
              <p:grpSp>
                <p:nvGrpSpPr>
                  <p:cNvPr id="30" name="Groupe 29">
                    <a:extLst>
                      <a:ext uri="{FF2B5EF4-FFF2-40B4-BE49-F238E27FC236}">
                        <a16:creationId xmlns:a16="http://schemas.microsoft.com/office/drawing/2014/main" id="{7D65DC69-04BD-4A97-BCBF-DC97AEE9C36A}"/>
                      </a:ext>
                    </a:extLst>
                  </p:cNvPr>
                  <p:cNvGrpSpPr/>
                  <p:nvPr/>
                </p:nvGrpSpPr>
                <p:grpSpPr>
                  <a:xfrm>
                    <a:off x="374758" y="1790128"/>
                    <a:ext cx="11980780" cy="6829639"/>
                    <a:chOff x="374758" y="1790128"/>
                    <a:chExt cx="11980780" cy="6829639"/>
                  </a:xfrm>
                </p:grpSpPr>
                <p:grpSp>
                  <p:nvGrpSpPr>
                    <p:cNvPr id="28" name="Groupe 27">
                      <a:extLst>
                        <a:ext uri="{FF2B5EF4-FFF2-40B4-BE49-F238E27FC236}">
                          <a16:creationId xmlns:a16="http://schemas.microsoft.com/office/drawing/2014/main" id="{70D84B03-EDEE-46DD-B54D-BF526057E07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236669" y="1790128"/>
                      <a:ext cx="11118869" cy="6829639"/>
                      <a:chOff x="461969" y="1908847"/>
                      <a:chExt cx="11118869" cy="6829639"/>
                    </a:xfrm>
                  </p:grpSpPr>
                  <p:grpSp>
                    <p:nvGrpSpPr>
                      <p:cNvPr id="24" name="Groupe 23">
                        <a:extLst>
                          <a:ext uri="{FF2B5EF4-FFF2-40B4-BE49-F238E27FC236}">
                            <a16:creationId xmlns:a16="http://schemas.microsoft.com/office/drawing/2014/main" id="{CF2DFC73-88A7-4C12-AA71-83CAC5E51E0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61969" y="3130257"/>
                        <a:ext cx="11118869" cy="5608229"/>
                        <a:chOff x="299088" y="855000"/>
                        <a:chExt cx="11118869" cy="5608229"/>
                      </a:xfrm>
                    </p:grpSpPr>
                    <p:grpSp>
                      <p:nvGrpSpPr>
                        <p:cNvPr id="14" name="Groupe 13">
                          <a:extLst>
                            <a:ext uri="{FF2B5EF4-FFF2-40B4-BE49-F238E27FC236}">
                              <a16:creationId xmlns:a16="http://schemas.microsoft.com/office/drawing/2014/main" id="{FB7E1A2E-D960-4FDF-B922-9EBEE8BC3D1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99088" y="855000"/>
                          <a:ext cx="11118869" cy="5174618"/>
                          <a:chOff x="299088" y="855000"/>
                          <a:chExt cx="11118869" cy="5174618"/>
                        </a:xfrm>
                      </p:grpSpPr>
                      <p:grpSp>
                        <p:nvGrpSpPr>
                          <p:cNvPr id="7" name="Groupe 6">
                            <a:extLst>
                              <a:ext uri="{FF2B5EF4-FFF2-40B4-BE49-F238E27FC236}">
                                <a16:creationId xmlns:a16="http://schemas.microsoft.com/office/drawing/2014/main" id="{41D20304-7190-4C4C-9353-200E930937F4}"/>
                              </a:ext>
                            </a:extLst>
                          </p:cNvPr>
                          <p:cNvGrpSpPr>
                            <a:grpSpLocks noChangeAspect="1"/>
                          </p:cNvGrpSpPr>
                          <p:nvPr/>
                        </p:nvGrpSpPr>
                        <p:grpSpPr>
                          <a:xfrm>
                            <a:off x="299088" y="855000"/>
                            <a:ext cx="11118869" cy="5174618"/>
                            <a:chOff x="1421000" y="1297509"/>
                            <a:chExt cx="9384338" cy="4367383"/>
                          </a:xfrm>
                        </p:grpSpPr>
                        <p:grpSp>
                          <p:nvGrpSpPr>
                            <p:cNvPr id="242" name="Groupe 241">
                              <a:extLst>
                                <a:ext uri="{FF2B5EF4-FFF2-40B4-BE49-F238E27FC236}">
                                  <a16:creationId xmlns:a16="http://schemas.microsoft.com/office/drawing/2014/main" id="{E69AAA87-F5E5-4D28-98CA-E75E2751ECF8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421000" y="1988770"/>
                              <a:ext cx="5738369" cy="3657431"/>
                              <a:chOff x="-477641" y="1403854"/>
                              <a:chExt cx="8068869" cy="5142809"/>
                            </a:xfrm>
                          </p:grpSpPr>
                          <p:grpSp>
                            <p:nvGrpSpPr>
                              <p:cNvPr id="168" name="Groupe 167">
                                <a:extLst>
                                  <a:ext uri="{FF2B5EF4-FFF2-40B4-BE49-F238E27FC236}">
                                    <a16:creationId xmlns:a16="http://schemas.microsoft.com/office/drawing/2014/main" id="{D063610B-CA7F-4492-86B3-2C0D4AC2CBD3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-477641" y="3750084"/>
                                <a:ext cx="1472586" cy="2761406"/>
                                <a:chOff x="-477641" y="3750084"/>
                                <a:chExt cx="1472586" cy="2761406"/>
                              </a:xfrm>
                            </p:grpSpPr>
                            <p:sp>
                              <p:nvSpPr>
                                <p:cNvPr id="143" name="Ellipse 142">
                                  <a:extLst>
                                    <a:ext uri="{FF2B5EF4-FFF2-40B4-BE49-F238E27FC236}">
                                      <a16:creationId xmlns:a16="http://schemas.microsoft.com/office/drawing/2014/main" id="{1E0D37CB-F530-451C-939A-5E07DF75B1B9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-477640" y="5851031"/>
                                  <a:ext cx="660395" cy="660458"/>
                                </a:xfrm>
                                <a:prstGeom prst="ellipse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endParaRPr lang="fr-FR" sz="1600"/>
                                </a:p>
                              </p:txBody>
                            </p:sp>
                            <p:cxnSp>
                              <p:nvCxnSpPr>
                                <p:cNvPr id="144" name="Connecteur droit 143">
                                  <a:extLst>
                                    <a:ext uri="{FF2B5EF4-FFF2-40B4-BE49-F238E27FC236}">
                                      <a16:creationId xmlns:a16="http://schemas.microsoft.com/office/drawing/2014/main" id="{639D516A-7D62-4B75-81F4-94D84B61AE8E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-163252" y="5491031"/>
                                  <a:ext cx="0" cy="36000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147" name="Connecteur droit 146">
                                  <a:extLst>
                                    <a:ext uri="{FF2B5EF4-FFF2-40B4-BE49-F238E27FC236}">
                                      <a16:creationId xmlns:a16="http://schemas.microsoft.com/office/drawing/2014/main" id="{B165727E-1F32-43DC-BA61-4A22437CBFAC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250747" y="4771031"/>
                                  <a:ext cx="0" cy="72000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sp>
                              <p:nvSpPr>
                                <p:cNvPr id="148" name="Ellipse 147">
                                  <a:extLst>
                                    <a:ext uri="{FF2B5EF4-FFF2-40B4-BE49-F238E27FC236}">
                                      <a16:creationId xmlns:a16="http://schemas.microsoft.com/office/drawing/2014/main" id="{60AD16C8-1619-493A-B5CC-F1E875581972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334550" y="5851031"/>
                                  <a:ext cx="660395" cy="660459"/>
                                </a:xfrm>
                                <a:prstGeom prst="ellipse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endParaRPr lang="fr-FR" sz="1600"/>
                                </a:p>
                              </p:txBody>
                            </p:sp>
                            <p:cxnSp>
                              <p:nvCxnSpPr>
                                <p:cNvPr id="149" name="Connecteur droit 148">
                                  <a:extLst>
                                    <a:ext uri="{FF2B5EF4-FFF2-40B4-BE49-F238E27FC236}">
                                      <a16:creationId xmlns:a16="http://schemas.microsoft.com/office/drawing/2014/main" id="{D25E59DF-8AD3-4288-A1FB-5D08C9EAB014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648938" y="5491031"/>
                                  <a:ext cx="0" cy="36000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150" name="Connecteur droit 149">
                                  <a:extLst>
                                    <a:ext uri="{FF2B5EF4-FFF2-40B4-BE49-F238E27FC236}">
                                      <a16:creationId xmlns:a16="http://schemas.microsoft.com/office/drawing/2014/main" id="{F843D4C4-6A9F-4A9B-BEDA-69EEF45B2D34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-163252" y="5491031"/>
                                  <a:ext cx="828000" cy="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sp>
                              <p:nvSpPr>
                                <p:cNvPr id="151" name="Ellipse 150">
                                  <a:extLst>
                                    <a:ext uri="{FF2B5EF4-FFF2-40B4-BE49-F238E27FC236}">
                                      <a16:creationId xmlns:a16="http://schemas.microsoft.com/office/drawing/2014/main" id="{0D1D1766-742E-44EF-9ED6-569A23F35329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318739" y="3750084"/>
                                  <a:ext cx="660395" cy="660458"/>
                                </a:xfrm>
                                <a:prstGeom prst="ellips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endParaRPr lang="fr-FR" sz="1600" dirty="0"/>
                                </a:p>
                              </p:txBody>
                            </p:sp>
                            <p:sp>
                              <p:nvSpPr>
                                <p:cNvPr id="153" name="Rectangle 152">
                                  <a:extLst>
                                    <a:ext uri="{FF2B5EF4-FFF2-40B4-BE49-F238E27FC236}">
                                      <a16:creationId xmlns:a16="http://schemas.microsoft.com/office/drawing/2014/main" id="{D5386792-4BF7-450F-86C3-67EAF067333E}"/>
                                    </a:ext>
                                  </a:extLst>
                                </p:cNvPr>
                                <p:cNvSpPr/>
                                <p:nvPr/>
                              </p:nvSpPr>
                              <p:spPr>
                                <a:xfrm>
                                  <a:off x="-477641" y="3750571"/>
                                  <a:ext cx="660395" cy="660458"/>
                                </a:xfrm>
                                <a:prstGeom prst="rect">
                                  <a:avLst/>
                                </a:prstGeom>
                                <a:solidFill>
                                  <a:schemeClr val="bg1"/>
                                </a:solidFill>
                                <a:ln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2">
                                  <a:schemeClr val="accent1">
                                    <a:shade val="50000"/>
                                  </a:schemeClr>
                                </a:lnRef>
                                <a:fillRef idx="1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lt1"/>
                                </a:fontRef>
                              </p:style>
                              <p:txBody>
                                <a:bodyPr rtlCol="0" anchor="ctr"/>
                                <a:lstStyle/>
                                <a:p>
                                  <a:endParaRPr lang="fr-FR" sz="1600" dirty="0"/>
                                </a:p>
                              </p:txBody>
                            </p:sp>
                            <p:cxnSp>
                              <p:nvCxnSpPr>
                                <p:cNvPr id="155" name="Connecteur droit 154">
                                  <a:extLst>
                                    <a:ext uri="{FF2B5EF4-FFF2-40B4-BE49-F238E27FC236}">
                                      <a16:creationId xmlns:a16="http://schemas.microsoft.com/office/drawing/2014/main" id="{A7C0D8FC-AE7B-4EA2-9D86-60C581B5662D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-163252" y="4771031"/>
                                  <a:ext cx="828000" cy="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156" name="Connecteur droit 155">
                                  <a:extLst>
                                    <a:ext uri="{FF2B5EF4-FFF2-40B4-BE49-F238E27FC236}">
                                      <a16:creationId xmlns:a16="http://schemas.microsoft.com/office/drawing/2014/main" id="{6BA78F64-D7B3-4EA0-A33D-58FC0A95992C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-163252" y="4414145"/>
                                  <a:ext cx="0" cy="36000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157" name="Connecteur droit 156">
                                  <a:extLst>
                                    <a:ext uri="{FF2B5EF4-FFF2-40B4-BE49-F238E27FC236}">
                                      <a16:creationId xmlns:a16="http://schemas.microsoft.com/office/drawing/2014/main" id="{1D068E30-2DD7-4CEA-A4EB-494F523E34D3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664747" y="4395879"/>
                                  <a:ext cx="0" cy="360000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  <p:grpSp>
                            <p:nvGrpSpPr>
                              <p:cNvPr id="241" name="Groupe 240">
                                <a:extLst>
                                  <a:ext uri="{FF2B5EF4-FFF2-40B4-BE49-F238E27FC236}">
                                    <a16:creationId xmlns:a16="http://schemas.microsoft.com/office/drawing/2014/main" id="{A9962292-29FC-4212-BE49-C935FA4CC7D0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638843" y="1403854"/>
                                <a:ext cx="6952385" cy="5142809"/>
                                <a:chOff x="638843" y="1403854"/>
                                <a:chExt cx="6952385" cy="5142809"/>
                              </a:xfrm>
                            </p:grpSpPr>
                            <p:grpSp>
                              <p:nvGrpSpPr>
                                <p:cNvPr id="240" name="Groupe 239">
                                  <a:extLst>
                                    <a:ext uri="{FF2B5EF4-FFF2-40B4-BE49-F238E27FC236}">
                                      <a16:creationId xmlns:a16="http://schemas.microsoft.com/office/drawing/2014/main" id="{7A4E270F-74DF-4870-8838-E1216248261D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1567798" y="3720199"/>
                                  <a:ext cx="6023430" cy="2826464"/>
                                  <a:chOff x="1567798" y="3720199"/>
                                  <a:chExt cx="6023430" cy="2826464"/>
                                </a:xfrm>
                              </p:grpSpPr>
                              <p:sp>
                                <p:nvSpPr>
                                  <p:cNvPr id="207" name="Rectangle 206">
                                    <a:extLst>
                                      <a:ext uri="{FF2B5EF4-FFF2-40B4-BE49-F238E27FC236}">
                                        <a16:creationId xmlns:a16="http://schemas.microsoft.com/office/drawing/2014/main" id="{4E51D47D-7AB0-40F1-9934-A9A74C8028BA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6092943" y="5853659"/>
                                    <a:ext cx="660395" cy="660458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 dirty="0"/>
                                  </a:p>
                                </p:txBody>
                              </p:sp>
                              <p:grpSp>
                                <p:nvGrpSpPr>
                                  <p:cNvPr id="209" name="Groupe 208">
                                    <a:extLst>
                                      <a:ext uri="{FF2B5EF4-FFF2-40B4-BE49-F238E27FC236}">
                                        <a16:creationId xmlns:a16="http://schemas.microsoft.com/office/drawing/2014/main" id="{7E9EA4AC-7D13-4527-9247-4FFA9F1ABA95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1567798" y="3768476"/>
                                    <a:ext cx="1493759" cy="2778187"/>
                                    <a:chOff x="1894610" y="3765361"/>
                                    <a:chExt cx="1493759" cy="2778187"/>
                                  </a:xfrm>
                                </p:grpSpPr>
                                <p:sp>
                                  <p:nvSpPr>
                                    <p:cNvPr id="158" name="Ellipse 157">
                                      <a:extLst>
                                        <a:ext uri="{FF2B5EF4-FFF2-40B4-BE49-F238E27FC236}">
                                          <a16:creationId xmlns:a16="http://schemas.microsoft.com/office/drawing/2014/main" id="{F9D30EE4-1A6E-4806-AFE0-8A58612614EA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2727975" y="3765361"/>
                                      <a:ext cx="660394" cy="660458"/>
                                    </a:xfrm>
                                    <a:prstGeom prst="ellipse">
                                      <a:avLst/>
                                    </a:prstGeom>
                                    <a:solidFill>
                                      <a:schemeClr val="accent4">
                                        <a:lumMod val="20000"/>
                                        <a:lumOff val="80000"/>
                                      </a:schemeClr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/>
                                    </a:p>
                                  </p:txBody>
                                </p:sp>
                                <p:sp>
                                  <p:nvSpPr>
                                    <p:cNvPr id="167" name="Rectangle 166">
                                      <a:extLst>
                                        <a:ext uri="{FF2B5EF4-FFF2-40B4-BE49-F238E27FC236}">
                                          <a16:creationId xmlns:a16="http://schemas.microsoft.com/office/drawing/2014/main" id="{010F7B01-95BD-4D12-AEAB-283E22BBEE66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1894610" y="3788860"/>
                                      <a:ext cx="660395" cy="660459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 dirty="0"/>
                                    </a:p>
                                  </p:txBody>
                                </p:sp>
                                <p:cxnSp>
                                  <p:nvCxnSpPr>
                                    <p:cNvPr id="172" name="Connecteur droit 171">
                                      <a:extLst>
                                        <a:ext uri="{FF2B5EF4-FFF2-40B4-BE49-F238E27FC236}">
                                          <a16:creationId xmlns:a16="http://schemas.microsoft.com/office/drawing/2014/main" id="{A5ADB2C6-37DE-4D32-8B68-756DFF0A8791}"/>
                                        </a:ext>
                                      </a:extLst>
                                    </p:cNvPr>
                                    <p:cNvCxnSpPr/>
                                    <p:nvPr/>
                                  </p:nvCxnSpPr>
                                  <p:spPr>
                                    <a:xfrm>
                                      <a:off x="2621440" y="4809319"/>
                                      <a:ext cx="0" cy="1080000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cxnSp>
                                  <p:nvCxnSpPr>
                                    <p:cNvPr id="178" name="Connecteur droit 177">
                                      <a:extLst>
                                        <a:ext uri="{FF2B5EF4-FFF2-40B4-BE49-F238E27FC236}">
                                          <a16:creationId xmlns:a16="http://schemas.microsoft.com/office/drawing/2014/main" id="{50F31582-CC49-4367-89A6-68DD9B438F8B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</p:cNvCxnSpPr>
                                    <p:nvPr/>
                                  </p:nvCxnSpPr>
                                  <p:spPr>
                                    <a:xfrm>
                                      <a:off x="2207441" y="4809319"/>
                                      <a:ext cx="842860" cy="0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cxnSp>
                                  <p:nvCxnSpPr>
                                    <p:cNvPr id="179" name="Connecteur droit 178">
                                      <a:extLst>
                                        <a:ext uri="{FF2B5EF4-FFF2-40B4-BE49-F238E27FC236}">
                                          <a16:creationId xmlns:a16="http://schemas.microsoft.com/office/drawing/2014/main" id="{68A97C3E-7744-4DC2-B2E7-A518115AFFCB}"/>
                                        </a:ext>
                                      </a:extLst>
                                    </p:cNvPr>
                                    <p:cNvCxnSpPr/>
                                    <p:nvPr/>
                                  </p:nvCxnSpPr>
                                  <p:spPr>
                                    <a:xfrm>
                                      <a:off x="2223251" y="4449319"/>
                                      <a:ext cx="0" cy="360000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cxnSp>
                                  <p:nvCxnSpPr>
                                    <p:cNvPr id="180" name="Connecteur droit 179">
                                      <a:extLst>
                                        <a:ext uri="{FF2B5EF4-FFF2-40B4-BE49-F238E27FC236}">
                                          <a16:creationId xmlns:a16="http://schemas.microsoft.com/office/drawing/2014/main" id="{E29D5BE3-5E34-4374-BB9B-D17525DBE75F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  <a:stCxn id="158" idx="4"/>
                                    </p:cNvCxnSpPr>
                                    <p:nvPr/>
                                  </p:nvCxnSpPr>
                                  <p:spPr>
                                    <a:xfrm flipH="1">
                                      <a:off x="3056243" y="4425820"/>
                                      <a:ext cx="1930" cy="383499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sp>
                                  <p:nvSpPr>
                                    <p:cNvPr id="208" name="Rectangle 207">
                                      <a:extLst>
                                        <a:ext uri="{FF2B5EF4-FFF2-40B4-BE49-F238E27FC236}">
                                          <a16:creationId xmlns:a16="http://schemas.microsoft.com/office/drawing/2014/main" id="{1C9FFC87-21C1-447C-9054-19ABD0D35F58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2302378" y="5883089"/>
                                      <a:ext cx="660395" cy="660459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 dirty="0"/>
                                    </a:p>
                                  </p:txBody>
                                </p:sp>
                              </p:grpSp>
                              <p:grpSp>
                                <p:nvGrpSpPr>
                                  <p:cNvPr id="211" name="Groupe 210">
                                    <a:extLst>
                                      <a:ext uri="{FF2B5EF4-FFF2-40B4-BE49-F238E27FC236}">
                                        <a16:creationId xmlns:a16="http://schemas.microsoft.com/office/drawing/2014/main" id="{CF963873-75B9-4BDB-BADC-4A7D38F23F08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3881331" y="3720199"/>
                                    <a:ext cx="1638534" cy="2763454"/>
                                    <a:chOff x="4045697" y="3720199"/>
                                    <a:chExt cx="1638534" cy="2763454"/>
                                  </a:xfrm>
                                </p:grpSpPr>
                                <p:grpSp>
                                  <p:nvGrpSpPr>
                                    <p:cNvPr id="195" name="Groupe 194">
                                      <a:extLst>
                                        <a:ext uri="{FF2B5EF4-FFF2-40B4-BE49-F238E27FC236}">
                                          <a16:creationId xmlns:a16="http://schemas.microsoft.com/office/drawing/2014/main" id="{2F529BE2-4C0A-4B87-B0BF-D40B49C03435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4045697" y="3720199"/>
                                      <a:ext cx="1488394" cy="2763454"/>
                                      <a:chOff x="-13114" y="3720199"/>
                                      <a:chExt cx="1488394" cy="2763454"/>
                                    </a:xfrm>
                                  </p:grpSpPr>
                                  <p:sp>
                                    <p:nvSpPr>
                                      <p:cNvPr id="196" name="Ellipse 19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9FDD71B-4A7B-4FF9-8F04-16B1DCCE6866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-13114" y="5823194"/>
                                        <a:ext cx="660396" cy="660459"/>
                                      </a:xfrm>
                                      <a:prstGeom prst="ellipse">
                                        <a:avLst/>
                                      </a:prstGeom>
                                      <a:solidFill>
                                        <a:schemeClr val="bg2">
                                          <a:lumMod val="90000"/>
                                        </a:schemeClr>
                                      </a:solidFill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endParaRPr lang="fr-FR" sz="1600"/>
                                      </a:p>
                                    </p:txBody>
                                  </p:sp>
                                  <p:cxnSp>
                                    <p:nvCxnSpPr>
                                      <p:cNvPr id="197" name="Connecteur droit 19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89940B9A-B5E5-4656-BA41-41C63B14F726}"/>
                                          </a:ext>
                                        </a:extLst>
                                      </p:cNvPr>
                                      <p:cNvCxnSpPr>
                                        <a:cxnSpLocks/>
                                        <a:endCxn id="196" idx="0"/>
                                      </p:cNvCxnSpPr>
                                      <p:nvPr/>
                                    </p:nvCxnSpPr>
                                    <p:spPr>
                                      <a:xfrm>
                                        <a:off x="317084" y="5454430"/>
                                        <a:ext cx="0" cy="368764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198" name="Connecteur droit 197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E14F5CB8-ED90-47C2-8251-D2C7FBE4A4C4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731083" y="4740659"/>
                                        <a:ext cx="0" cy="72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00" name="Connecteur droit 19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FCEE817-E460-43EC-B44B-D256F8C93AF2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1295222" y="5463194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01" name="Connecteur droit 20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9CE30B2-E560-475B-A6F6-93683CAA640F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317083" y="5460659"/>
                                        <a:ext cx="982647" cy="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sp>
                                    <p:nvSpPr>
                                      <p:cNvPr id="202" name="Ellipse 20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EEE991C-C8B7-4EB1-9903-F0AE5476C372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814885" y="3778517"/>
                                        <a:ext cx="660395" cy="660459"/>
                                      </a:xfrm>
                                      <a:prstGeom prst="ellips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endParaRPr lang="fr-FR" sz="1600" dirty="0"/>
                                      </a:p>
                                    </p:txBody>
                                  </p:sp>
                                  <p:sp>
                                    <p:nvSpPr>
                                      <p:cNvPr id="203" name="Rectangle 20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8A52C1D7-9C0B-40AA-A268-3A04A0B0564E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2696" y="3720199"/>
                                        <a:ext cx="660395" cy="660458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endParaRPr lang="fr-FR" sz="1600" dirty="0"/>
                                      </a:p>
                                    </p:txBody>
                                  </p:sp>
                                  <p:cxnSp>
                                    <p:nvCxnSpPr>
                                      <p:cNvPr id="204" name="Connecteur droit 20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A1AF8B9-72AD-4B35-89A6-02BD1EDE47DF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317084" y="4733887"/>
                                        <a:ext cx="828000" cy="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05" name="Connecteur droit 20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3C2DC4A1-1E3E-4BC4-B960-2E521E9CFBC1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332894" y="4380659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06" name="Connecteur droit 20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823F1A6-F00B-4FE3-BD56-3AA3C066D3EC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1145084" y="4380659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</p:grpSp>
                                <p:sp>
                                  <p:nvSpPr>
                                    <p:cNvPr id="210" name="Rectangle 209">
                                      <a:extLst>
                                        <a:ext uri="{FF2B5EF4-FFF2-40B4-BE49-F238E27FC236}">
                                          <a16:creationId xmlns:a16="http://schemas.microsoft.com/office/drawing/2014/main" id="{E627C453-3421-4B61-98D1-0A774AE5A1C5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5023836" y="5814430"/>
                                      <a:ext cx="660395" cy="660458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2">
                                        <a:lumMod val="90000"/>
                                      </a:schemeClr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 dirty="0"/>
                                    </a:p>
                                  </p:txBody>
                                </p:sp>
                              </p:grpSp>
                              <p:grpSp>
                                <p:nvGrpSpPr>
                                  <p:cNvPr id="212" name="Groupe 211">
                                    <a:extLst>
                                      <a:ext uri="{FF2B5EF4-FFF2-40B4-BE49-F238E27FC236}">
                                        <a16:creationId xmlns:a16="http://schemas.microsoft.com/office/drawing/2014/main" id="{1362E409-3A87-4176-AD76-2326B2B267BA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6094746" y="3729366"/>
                                    <a:ext cx="1496482" cy="2781636"/>
                                    <a:chOff x="4270404" y="3735595"/>
                                    <a:chExt cx="1496482" cy="2781636"/>
                                  </a:xfrm>
                                </p:grpSpPr>
                                <p:grpSp>
                                  <p:nvGrpSpPr>
                                    <p:cNvPr id="213" name="Groupe 212">
                                      <a:extLst>
                                        <a:ext uri="{FF2B5EF4-FFF2-40B4-BE49-F238E27FC236}">
                                          <a16:creationId xmlns:a16="http://schemas.microsoft.com/office/drawing/2014/main" id="{78126A53-8EA2-47DA-BCE8-CACF7EDAAE4C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4270404" y="3735595"/>
                                      <a:ext cx="1496482" cy="2121178"/>
                                      <a:chOff x="211593" y="3735595"/>
                                      <a:chExt cx="1496482" cy="2121178"/>
                                    </a:xfrm>
                                  </p:grpSpPr>
                                  <p:cxnSp>
                                    <p:nvCxnSpPr>
                                      <p:cNvPr id="216" name="Connecteur droit 21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9DD1C39-DE87-4E51-B515-422640287CB0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525981" y="5496773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17" name="Connecteur droit 21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CD2EF3D-F3BC-4D7A-9542-339435728C8B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939981" y="4776773"/>
                                        <a:ext cx="0" cy="72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18" name="Connecteur droit 217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D7BBF14C-D1B1-4F41-9B35-3096F0539813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1353979" y="5490417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19" name="Connecteur droit 218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601E9F48-B43E-4E9B-988A-F904DAE81765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525981" y="5496773"/>
                                        <a:ext cx="828000" cy="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sp>
                                    <p:nvSpPr>
                                      <p:cNvPr id="220" name="Ellipse 219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606A5542-5514-407B-9BB0-B41630468D73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1047680" y="3735595"/>
                                        <a:ext cx="660395" cy="660457"/>
                                      </a:xfrm>
                                      <a:prstGeom prst="ellipse">
                                        <a:avLst/>
                                      </a:prstGeom>
                                      <a:solidFill>
                                        <a:schemeClr val="accent4">
                                          <a:lumMod val="20000"/>
                                          <a:lumOff val="80000"/>
                                        </a:schemeClr>
                                      </a:solidFill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endParaRPr lang="fr-FR" sz="1600" dirty="0"/>
                                      </a:p>
                                    </p:txBody>
                                  </p:sp>
                                  <p:sp>
                                    <p:nvSpPr>
                                      <p:cNvPr id="221" name="Rectangle 220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C02F453E-E2BA-409B-A5AF-2DEDEDF3EB70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211593" y="3756314"/>
                                        <a:ext cx="660395" cy="660458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2">
                                        <a:schemeClr val="accent1">
                                          <a:shade val="50000"/>
                                        </a:schemeClr>
                                      </a:lnRef>
                                      <a:fillRef idx="1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endParaRPr lang="fr-FR" sz="1600" dirty="0"/>
                                      </a:p>
                                    </p:txBody>
                                  </p:sp>
                                  <p:cxnSp>
                                    <p:nvCxnSpPr>
                                      <p:cNvPr id="222" name="Connecteur droit 221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1F84EB5B-64BA-4526-9A62-8AEC9F2F2C5E}"/>
                                          </a:ext>
                                        </a:extLst>
                                      </p:cNvPr>
                                      <p:cNvCxnSpPr>
                                        <a:cxnSpLocks/>
                                      </p:cNvCxnSpPr>
                                      <p:nvPr/>
                                    </p:nvCxnSpPr>
                                    <p:spPr>
                                      <a:xfrm flipV="1">
                                        <a:off x="525981" y="4776770"/>
                                        <a:ext cx="851896" cy="2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23" name="Connecteur droit 222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4088957-80F8-40E3-9C67-37173D4B1B0A}"/>
                                          </a:ext>
                                        </a:extLst>
                                      </p:cNvPr>
                                      <p:cNvCxnSpPr/>
                                      <p:nvPr/>
                                    </p:nvCxnSpPr>
                                    <p:spPr>
                                      <a:xfrm>
                                        <a:off x="541791" y="4416773"/>
                                        <a:ext cx="0" cy="360000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  <p:cxnSp>
                                    <p:nvCxnSpPr>
                                      <p:cNvPr id="224" name="Connecteur droit 223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57C487E6-0CE7-4730-B243-4EAA9313A040}"/>
                                          </a:ext>
                                        </a:extLst>
                                      </p:cNvPr>
                                      <p:cNvCxnSpPr>
                                        <a:cxnSpLocks/>
                                        <a:stCxn id="220" idx="4"/>
                                      </p:cNvCxnSpPr>
                                      <p:nvPr/>
                                    </p:nvCxnSpPr>
                                    <p:spPr>
                                      <a:xfrm flipH="1">
                                        <a:off x="1377877" y="4396053"/>
                                        <a:ext cx="1" cy="384514"/>
                                      </a:xfrm>
                                      <a:prstGeom prst="line">
                                        <a:avLst/>
                                      </a:prstGeom>
                                      <a:solidFill>
                                        <a:schemeClr val="tx1"/>
                                      </a:solidFill>
                                      <a:ln w="19050">
                                        <a:solidFill>
                                          <a:schemeClr val="tx1"/>
                                        </a:solidFill>
                                      </a:ln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0">
                                        <a:schemeClr val="accent1"/>
                                      </a:fillRef>
                                      <a:effectRef idx="0">
                                        <a:schemeClr val="accent1"/>
                                      </a:effectRef>
                                      <a:fontRef idx="minor">
                                        <a:schemeClr val="tx1"/>
                                      </a:fontRef>
                                    </p:style>
                                  </p:cxnSp>
                                </p:grpSp>
                                <p:sp>
                                  <p:nvSpPr>
                                    <p:cNvPr id="214" name="Rectangle 213">
                                      <a:extLst>
                                        <a:ext uri="{FF2B5EF4-FFF2-40B4-BE49-F238E27FC236}">
                                          <a16:creationId xmlns:a16="http://schemas.microsoft.com/office/drawing/2014/main" id="{6F3B99BD-8925-4F60-AA9D-4AB88EF049B0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5082593" y="5856773"/>
                                      <a:ext cx="660395" cy="660458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 dirty="0"/>
                                    </a:p>
                                  </p:txBody>
                                </p:sp>
                              </p:grpSp>
                            </p:grpSp>
                            <p:grpSp>
                              <p:nvGrpSpPr>
                                <p:cNvPr id="239" name="Groupe 238">
                                  <a:extLst>
                                    <a:ext uri="{FF2B5EF4-FFF2-40B4-BE49-F238E27FC236}">
                                      <a16:creationId xmlns:a16="http://schemas.microsoft.com/office/drawing/2014/main" id="{4F5DE2CE-2113-4439-9677-30CF75462CE0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638843" y="1403854"/>
                                  <a:ext cx="6622188" cy="2371231"/>
                                  <a:chOff x="638843" y="1403854"/>
                                  <a:chExt cx="6622188" cy="2371231"/>
                                </a:xfrm>
                              </p:grpSpPr>
                              <p:cxnSp>
                                <p:nvCxnSpPr>
                                  <p:cNvPr id="161" name="Connecteur droit 160">
                                    <a:extLst>
                                      <a:ext uri="{FF2B5EF4-FFF2-40B4-BE49-F238E27FC236}">
                                        <a16:creationId xmlns:a16="http://schemas.microsoft.com/office/drawing/2014/main" id="{965C40C8-4BD8-4416-9C17-D90C108B242F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648936" y="3390571"/>
                                    <a:ext cx="0" cy="384514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162" name="Connecteur droit 161">
                                    <a:extLst>
                                      <a:ext uri="{FF2B5EF4-FFF2-40B4-BE49-F238E27FC236}">
                                        <a16:creationId xmlns:a16="http://schemas.microsoft.com/office/drawing/2014/main" id="{AB47064D-B1D4-493F-BEE3-83F3D5A37E17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2723488" y="3390085"/>
                                    <a:ext cx="0" cy="384514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163" name="Connecteur droit 162">
                                    <a:extLst>
                                      <a:ext uri="{FF2B5EF4-FFF2-40B4-BE49-F238E27FC236}">
                                        <a16:creationId xmlns:a16="http://schemas.microsoft.com/office/drawing/2014/main" id="{A8D47943-6333-416F-981E-26CAF63A1EF5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5053456" y="3390571"/>
                                    <a:ext cx="0" cy="384514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164" name="Connecteur droit 163">
                                    <a:extLst>
                                      <a:ext uri="{FF2B5EF4-FFF2-40B4-BE49-F238E27FC236}">
                                        <a16:creationId xmlns:a16="http://schemas.microsoft.com/office/drawing/2014/main" id="{51DAF364-5432-4404-99F9-30B573212791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  <a:endCxn id="220" idx="0"/>
                                  </p:cNvCxnSpPr>
                                  <p:nvPr/>
                                </p:nvCxnSpPr>
                                <p:spPr>
                                  <a:xfrm>
                                    <a:off x="7261031" y="3378529"/>
                                    <a:ext cx="0" cy="350837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165" name="Connecteur droit 164">
                                    <a:extLst>
                                      <a:ext uri="{FF2B5EF4-FFF2-40B4-BE49-F238E27FC236}">
                                        <a16:creationId xmlns:a16="http://schemas.microsoft.com/office/drawing/2014/main" id="{8A6907EE-CFE0-44B0-AE35-0A57279E53FE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638843" y="3378529"/>
                                    <a:ext cx="6622188" cy="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25" name="Connecteur droit 224">
                                    <a:extLst>
                                      <a:ext uri="{FF2B5EF4-FFF2-40B4-BE49-F238E27FC236}">
                                        <a16:creationId xmlns:a16="http://schemas.microsoft.com/office/drawing/2014/main" id="{C4001E53-9327-4816-A23F-DBEFB45D0D44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4294205" y="2424314"/>
                                    <a:ext cx="0" cy="939923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26" name="Connecteur droit 225">
                                    <a:extLst>
                                      <a:ext uri="{FF2B5EF4-FFF2-40B4-BE49-F238E27FC236}">
                                        <a16:creationId xmlns:a16="http://schemas.microsoft.com/office/drawing/2014/main" id="{8E136E5F-CCA7-4268-B981-A07CDA4281EC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3880205" y="2420838"/>
                                    <a:ext cx="828000" cy="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grpSp>
                                <p:nvGrpSpPr>
                                  <p:cNvPr id="228" name="Groupe 227">
                                    <a:extLst>
                                      <a:ext uri="{FF2B5EF4-FFF2-40B4-BE49-F238E27FC236}">
                                        <a16:creationId xmlns:a16="http://schemas.microsoft.com/office/drawing/2014/main" id="{47FC5492-2C8C-4C82-9E05-1573C5D770C2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3557912" y="1403854"/>
                                    <a:ext cx="1472585" cy="1020459"/>
                                    <a:chOff x="211593" y="3756314"/>
                                    <a:chExt cx="1472585" cy="1020459"/>
                                  </a:xfrm>
                                </p:grpSpPr>
                                <p:sp>
                                  <p:nvSpPr>
                                    <p:cNvPr id="234" name="Ellipse 233">
                                      <a:extLst>
                                        <a:ext uri="{FF2B5EF4-FFF2-40B4-BE49-F238E27FC236}">
                                          <a16:creationId xmlns:a16="http://schemas.microsoft.com/office/drawing/2014/main" id="{818D249C-E25A-4681-A758-B369C432766C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1023783" y="3756314"/>
                                      <a:ext cx="660395" cy="660458"/>
                                    </a:xfrm>
                                    <a:prstGeom prst="ellipse">
                                      <a:avLst/>
                                    </a:prstGeom>
                                    <a:solidFill>
                                      <a:srgbClr val="D3E9F9"/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/>
                                    </a:p>
                                  </p:txBody>
                                </p:sp>
                                <p:sp>
                                  <p:nvSpPr>
                                    <p:cNvPr id="235" name="Rectangle 234">
                                      <a:extLst>
                                        <a:ext uri="{FF2B5EF4-FFF2-40B4-BE49-F238E27FC236}">
                                          <a16:creationId xmlns:a16="http://schemas.microsoft.com/office/drawing/2014/main" id="{FBA33035-B40E-4227-8BF5-839CD8512FB6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211593" y="3756314"/>
                                      <a:ext cx="660395" cy="660458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2">
                                      <a:schemeClr val="accent1">
                                        <a:shade val="50000"/>
                                      </a:schemeClr>
                                    </a:lnRef>
                                    <a:fillRef idx="1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endParaRPr lang="fr-FR" sz="1600" dirty="0"/>
                                    </a:p>
                                  </p:txBody>
                                </p:sp>
                                <p:cxnSp>
                                  <p:nvCxnSpPr>
                                    <p:cNvPr id="237" name="Connecteur droit 236">
                                      <a:extLst>
                                        <a:ext uri="{FF2B5EF4-FFF2-40B4-BE49-F238E27FC236}">
                                          <a16:creationId xmlns:a16="http://schemas.microsoft.com/office/drawing/2014/main" id="{CEDDF0EF-7338-419D-A735-B327C016C220}"/>
                                        </a:ext>
                                      </a:extLst>
                                    </p:cNvPr>
                                    <p:cNvCxnSpPr/>
                                    <p:nvPr/>
                                  </p:nvCxnSpPr>
                                  <p:spPr>
                                    <a:xfrm>
                                      <a:off x="541791" y="4416773"/>
                                      <a:ext cx="0" cy="360000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cxnSp>
                                  <p:nvCxnSpPr>
                                    <p:cNvPr id="238" name="Connecteur droit 237">
                                      <a:extLst>
                                        <a:ext uri="{FF2B5EF4-FFF2-40B4-BE49-F238E27FC236}">
                                          <a16:creationId xmlns:a16="http://schemas.microsoft.com/office/drawing/2014/main" id="{36C08D1D-179C-4824-9354-AF9EA02786B6}"/>
                                        </a:ext>
                                      </a:extLst>
                                    </p:cNvPr>
                                    <p:cNvCxnSpPr/>
                                    <p:nvPr/>
                                  </p:nvCxnSpPr>
                                  <p:spPr>
                                    <a:xfrm>
                                      <a:off x="1353981" y="4416773"/>
                                      <a:ext cx="0" cy="360000"/>
                                    </a:xfrm>
                                    <a:prstGeom prst="line">
                                      <a:avLst/>
                                    </a:prstGeom>
                                    <a:solidFill>
                                      <a:schemeClr val="tx1"/>
                                    </a:solidFill>
                                    <a:ln w="19050">
                                      <a:solidFill>
                                        <a:schemeClr val="tx1"/>
                                      </a:solidFill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</p:grpSp>
                            </p:grpSp>
                          </p:grpSp>
                        </p:grpSp>
                        <p:grpSp>
                          <p:nvGrpSpPr>
                            <p:cNvPr id="261" name="Groupe 260">
                              <a:extLst>
                                <a:ext uri="{FF2B5EF4-FFF2-40B4-BE49-F238E27FC236}">
                                  <a16:creationId xmlns:a16="http://schemas.microsoft.com/office/drawing/2014/main" id="{355CDCB9-1F38-4CE2-B1DC-C1410A82DACD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7521654" y="3686459"/>
                              <a:ext cx="1071908" cy="1493793"/>
                              <a:chOff x="2741956" y="3787905"/>
                              <a:chExt cx="1507237" cy="2100461"/>
                            </a:xfrm>
                          </p:grpSpPr>
                          <p:sp>
                            <p:nvSpPr>
                              <p:cNvPr id="287" name="Ellipse 286">
                                <a:extLst>
                                  <a:ext uri="{FF2B5EF4-FFF2-40B4-BE49-F238E27FC236}">
                                    <a16:creationId xmlns:a16="http://schemas.microsoft.com/office/drawing/2014/main" id="{79C380C3-70AC-42EB-AB9D-97EF81C3AC00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588798" y="3787905"/>
                                <a:ext cx="660395" cy="660458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tx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/>
                              </a:p>
                            </p:txBody>
                          </p:sp>
                          <p:sp>
                            <p:nvSpPr>
                              <p:cNvPr id="288" name="Rectangle 287">
                                <a:extLst>
                                  <a:ext uri="{FF2B5EF4-FFF2-40B4-BE49-F238E27FC236}">
                                    <a16:creationId xmlns:a16="http://schemas.microsoft.com/office/drawing/2014/main" id="{CB1288DF-C548-4B03-A4B8-7420B69E32E3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741956" y="3817063"/>
                                <a:ext cx="660394" cy="660459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 dirty="0"/>
                              </a:p>
                            </p:txBody>
                          </p:sp>
                          <p:cxnSp>
                            <p:nvCxnSpPr>
                              <p:cNvPr id="289" name="Connecteur droit 288">
                                <a:extLst>
                                  <a:ext uri="{FF2B5EF4-FFF2-40B4-BE49-F238E27FC236}">
                                    <a16:creationId xmlns:a16="http://schemas.microsoft.com/office/drawing/2014/main" id="{012549BE-508A-4CB7-B1EE-A62DD0749761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3490134" y="4832679"/>
                                <a:ext cx="1" cy="1055687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90" name="Connecteur droit 289">
                                <a:extLst>
                                  <a:ext uri="{FF2B5EF4-FFF2-40B4-BE49-F238E27FC236}">
                                    <a16:creationId xmlns:a16="http://schemas.microsoft.com/office/drawing/2014/main" id="{ABE46A56-3D67-4D40-A384-E6BFD75E2990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3076133" y="4832679"/>
                                <a:ext cx="828001" cy="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91" name="Connecteur droit 290">
                                <a:extLst>
                                  <a:ext uri="{FF2B5EF4-FFF2-40B4-BE49-F238E27FC236}">
                                    <a16:creationId xmlns:a16="http://schemas.microsoft.com/office/drawing/2014/main" id="{900A9848-D914-43DE-9335-31983780A073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3076133" y="4480911"/>
                                <a:ext cx="0" cy="3600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92" name="Connecteur droit 291">
                                <a:extLst>
                                  <a:ext uri="{FF2B5EF4-FFF2-40B4-BE49-F238E27FC236}">
                                    <a16:creationId xmlns:a16="http://schemas.microsoft.com/office/drawing/2014/main" id="{456BD984-9BFA-4C86-BDF7-0322E4A97D84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3904134" y="4448165"/>
                                <a:ext cx="0" cy="384514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282" name="Ellipse 281">
                              <a:extLst>
                                <a:ext uri="{FF2B5EF4-FFF2-40B4-BE49-F238E27FC236}">
                                  <a16:creationId xmlns:a16="http://schemas.microsoft.com/office/drawing/2014/main" id="{6897B780-A06C-4032-8E65-05FD05B91081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8850857" y="3686460"/>
                              <a:ext cx="469656" cy="469700"/>
                            </a:xfrm>
                            <a:prstGeom prst="ellipse">
                              <a:avLst/>
                            </a:prstGeom>
                            <a:solidFill>
                              <a:schemeClr val="tx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1600"/>
                            </a:p>
                          </p:txBody>
                        </p:sp>
                        <p:cxnSp>
                          <p:nvCxnSpPr>
                            <p:cNvPr id="249" name="Connecteur droit 248">
                              <a:extLst>
                                <a:ext uri="{FF2B5EF4-FFF2-40B4-BE49-F238E27FC236}">
                                  <a16:creationId xmlns:a16="http://schemas.microsoft.com/office/drawing/2014/main" id="{D928D748-E97D-4610-8915-7F72D987E507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8358733" y="3430438"/>
                              <a:ext cx="0" cy="256023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50" name="Connecteur droit 249">
                              <a:extLst>
                                <a:ext uri="{FF2B5EF4-FFF2-40B4-BE49-F238E27FC236}">
                                  <a16:creationId xmlns:a16="http://schemas.microsoft.com/office/drawing/2014/main" id="{495E254E-3CCC-44A2-AD19-5724CDFE8C45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9093773" y="3415574"/>
                              <a:ext cx="0" cy="281625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52" name="Connecteur droit 251">
                              <a:extLst>
                                <a:ext uri="{FF2B5EF4-FFF2-40B4-BE49-F238E27FC236}">
                                  <a16:creationId xmlns:a16="http://schemas.microsoft.com/office/drawing/2014/main" id="{8E62223A-5188-4550-9F20-F880D2536E6F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8348165" y="3428223"/>
                              <a:ext cx="1440000" cy="0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53" name="Connecteur droit 252">
                              <a:extLst>
                                <a:ext uri="{FF2B5EF4-FFF2-40B4-BE49-F238E27FC236}">
                                  <a16:creationId xmlns:a16="http://schemas.microsoft.com/office/drawing/2014/main" id="{31BFEA20-F72A-4604-8227-6537DB847E63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9093773" y="2712023"/>
                              <a:ext cx="0" cy="716199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cxnSp>
                          <p:nvCxnSpPr>
                            <p:cNvPr id="254" name="Connecteur droit 253">
                              <a:extLst>
                                <a:ext uri="{FF2B5EF4-FFF2-40B4-BE49-F238E27FC236}">
                                  <a16:creationId xmlns:a16="http://schemas.microsoft.com/office/drawing/2014/main" id="{C54C6E98-9C0A-4427-9C86-E4A565481886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>
                              <a:off x="8555479" y="2712023"/>
                              <a:ext cx="765035" cy="0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grpSp>
                          <p:nvGrpSpPr>
                            <p:cNvPr id="255" name="Groupe 254">
                              <a:extLst>
                                <a:ext uri="{FF2B5EF4-FFF2-40B4-BE49-F238E27FC236}">
                                  <a16:creationId xmlns:a16="http://schemas.microsoft.com/office/drawing/2014/main" id="{F57D45B6-63B8-4CF2-A5A6-0AFA9A76F275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8334361" y="1988770"/>
                              <a:ext cx="1215528" cy="725725"/>
                              <a:chOff x="211593" y="3756313"/>
                              <a:chExt cx="1709186" cy="1020460"/>
                            </a:xfrm>
                          </p:grpSpPr>
                          <p:sp>
                            <p:nvSpPr>
                              <p:cNvPr id="256" name="Ellipse 255">
                                <a:extLst>
                                  <a:ext uri="{FF2B5EF4-FFF2-40B4-BE49-F238E27FC236}">
                                    <a16:creationId xmlns:a16="http://schemas.microsoft.com/office/drawing/2014/main" id="{D277A413-3FB2-454F-8514-CAEBC0B651B1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260384" y="3756313"/>
                                <a:ext cx="660395" cy="660458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tx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/>
                              </a:p>
                            </p:txBody>
                          </p:sp>
                          <p:sp>
                            <p:nvSpPr>
                              <p:cNvPr id="257" name="Rectangle 256">
                                <a:extLst>
                                  <a:ext uri="{FF2B5EF4-FFF2-40B4-BE49-F238E27FC236}">
                                    <a16:creationId xmlns:a16="http://schemas.microsoft.com/office/drawing/2014/main" id="{0B627EAE-7267-4A37-A100-4F0E240E7C45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11593" y="3756314"/>
                                <a:ext cx="660395" cy="660458"/>
                              </a:xfrm>
                              <a:prstGeom prst="rect">
                                <a:avLst/>
                              </a:prstGeom>
                              <a:solidFill>
                                <a:srgbClr val="E9DBF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 dirty="0"/>
                              </a:p>
                            </p:txBody>
                          </p:sp>
                          <p:cxnSp>
                            <p:nvCxnSpPr>
                              <p:cNvPr id="258" name="Connecteur droit 257">
                                <a:extLst>
                                  <a:ext uri="{FF2B5EF4-FFF2-40B4-BE49-F238E27FC236}">
                                    <a16:creationId xmlns:a16="http://schemas.microsoft.com/office/drawing/2014/main" id="{87DCCE2E-5134-489D-89F6-B8DC80AB2059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541791" y="4416773"/>
                                <a:ext cx="0" cy="3600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259" name="Connecteur droit 258">
                                <a:extLst>
                                  <a:ext uri="{FF2B5EF4-FFF2-40B4-BE49-F238E27FC236}">
                                    <a16:creationId xmlns:a16="http://schemas.microsoft.com/office/drawing/2014/main" id="{5C9A0BFE-10D3-4FE0-85FB-8D2C42C91A34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590582" y="4416772"/>
                                <a:ext cx="0" cy="3600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305" name="Ellipse 304">
                              <a:extLst>
                                <a:ext uri="{FF2B5EF4-FFF2-40B4-BE49-F238E27FC236}">
                                  <a16:creationId xmlns:a16="http://schemas.microsoft.com/office/drawing/2014/main" id="{503B666A-601B-492F-896A-11EA46BDAC3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7818912" y="5169086"/>
                              <a:ext cx="469656" cy="469700"/>
                            </a:xfrm>
                            <a:prstGeom prst="ellipse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1600"/>
                            </a:p>
                          </p:txBody>
                        </p:sp>
                        <p:grpSp>
                          <p:nvGrpSpPr>
                            <p:cNvPr id="4" name="Groupe 3">
                              <a:extLst>
                                <a:ext uri="{FF2B5EF4-FFF2-40B4-BE49-F238E27FC236}">
                                  <a16:creationId xmlns:a16="http://schemas.microsoft.com/office/drawing/2014/main" id="{F4F5D749-97CE-47DD-9950-9E8D77930EF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9269146" y="3423792"/>
                              <a:ext cx="1536192" cy="2241100"/>
                              <a:chOff x="9767467" y="3411385"/>
                              <a:chExt cx="1536192" cy="2241100"/>
                            </a:xfrm>
                          </p:grpSpPr>
                          <p:cxnSp>
                            <p:nvCxnSpPr>
                              <p:cNvPr id="251" name="Connecteur droit 250">
                                <a:extLst>
                                  <a:ext uri="{FF2B5EF4-FFF2-40B4-BE49-F238E27FC236}">
                                    <a16:creationId xmlns:a16="http://schemas.microsoft.com/office/drawing/2014/main" id="{F3FB2C15-9287-4671-B7E7-E41FA7674CB6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0279939" y="3411385"/>
                                <a:ext cx="0" cy="273456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grpSp>
                            <p:nvGrpSpPr>
                              <p:cNvPr id="3" name="Groupe 2">
                                <a:extLst>
                                  <a:ext uri="{FF2B5EF4-FFF2-40B4-BE49-F238E27FC236}">
                                    <a16:creationId xmlns:a16="http://schemas.microsoft.com/office/drawing/2014/main" id="{329292A9-B605-495C-8B6E-E9B04E4216FB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9767467" y="3674731"/>
                                <a:ext cx="1536192" cy="1977754"/>
                                <a:chOff x="9767467" y="3674731"/>
                                <a:chExt cx="1536192" cy="1977754"/>
                              </a:xfrm>
                            </p:grpSpPr>
                            <p:grpSp>
                              <p:nvGrpSpPr>
                                <p:cNvPr id="264" name="Groupe 263">
                                  <a:extLst>
                                    <a:ext uri="{FF2B5EF4-FFF2-40B4-BE49-F238E27FC236}">
                                      <a16:creationId xmlns:a16="http://schemas.microsoft.com/office/drawing/2014/main" id="{08377076-0BEC-4591-9A4A-E17191125700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10019162" y="3674731"/>
                                  <a:ext cx="1049693" cy="1516259"/>
                                  <a:chOff x="543130" y="3756314"/>
                                  <a:chExt cx="1476000" cy="2132051"/>
                                </a:xfrm>
                              </p:grpSpPr>
                              <p:cxnSp>
                                <p:nvCxnSpPr>
                                  <p:cNvPr id="266" name="Connecteur droit 265">
                                    <a:extLst>
                                      <a:ext uri="{FF2B5EF4-FFF2-40B4-BE49-F238E27FC236}">
                                        <a16:creationId xmlns:a16="http://schemas.microsoft.com/office/drawing/2014/main" id="{5DA5EF1F-CD40-458D-AC81-113EB4889646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543130" y="5528365"/>
                                    <a:ext cx="0" cy="36000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67" name="Connecteur droit 266">
                                    <a:extLst>
                                      <a:ext uri="{FF2B5EF4-FFF2-40B4-BE49-F238E27FC236}">
                                        <a16:creationId xmlns:a16="http://schemas.microsoft.com/office/drawing/2014/main" id="{4220E3D9-DA07-4BC2-AB81-B9063B7AFCC3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1271518" y="4808364"/>
                                    <a:ext cx="0" cy="72000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68" name="Connecteur droit 267">
                                    <a:extLst>
                                      <a:ext uri="{FF2B5EF4-FFF2-40B4-BE49-F238E27FC236}">
                                        <a16:creationId xmlns:a16="http://schemas.microsoft.com/office/drawing/2014/main" id="{239A3E38-FBB2-4CAB-8002-BD233A6C5547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1269255" y="5521795"/>
                                    <a:ext cx="0" cy="36000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69" name="Connecteur droit 268">
                                    <a:extLst>
                                      <a:ext uri="{FF2B5EF4-FFF2-40B4-BE49-F238E27FC236}">
                                        <a16:creationId xmlns:a16="http://schemas.microsoft.com/office/drawing/2014/main" id="{19D8E5A4-03BF-43DD-AA75-E09C59584B79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543130" y="5528365"/>
                                    <a:ext cx="1476000" cy="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sp>
                                <p:nvSpPr>
                                  <p:cNvPr id="270" name="Ellipse 269">
                                    <a:extLst>
                                      <a:ext uri="{FF2B5EF4-FFF2-40B4-BE49-F238E27FC236}">
                                        <a16:creationId xmlns:a16="http://schemas.microsoft.com/office/drawing/2014/main" id="{3E1EC328-E5A3-479A-9496-6A1793DED0BF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1355319" y="3787905"/>
                                    <a:ext cx="660395" cy="660458"/>
                                  </a:xfrm>
                                  <a:prstGeom prst="ellipse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/>
                                  </a:p>
                                </p:txBody>
                              </p:sp>
                              <p:sp>
                                <p:nvSpPr>
                                  <p:cNvPr id="271" name="Rectangle 270">
                                    <a:extLst>
                                      <a:ext uri="{FF2B5EF4-FFF2-40B4-BE49-F238E27FC236}">
                                        <a16:creationId xmlns:a16="http://schemas.microsoft.com/office/drawing/2014/main" id="{A4735C6A-180A-4761-B81F-E4A0F33D45D5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566641" y="3756314"/>
                                    <a:ext cx="660395" cy="660458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 dirty="0"/>
                                  </a:p>
                                </p:txBody>
                              </p:sp>
                              <p:cxnSp>
                                <p:nvCxnSpPr>
                                  <p:cNvPr id="272" name="Connecteur droit 271">
                                    <a:extLst>
                                      <a:ext uri="{FF2B5EF4-FFF2-40B4-BE49-F238E27FC236}">
                                        <a16:creationId xmlns:a16="http://schemas.microsoft.com/office/drawing/2014/main" id="{C39B7094-17B5-4D98-97E9-FA3C73D47D68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913878" y="4808364"/>
                                    <a:ext cx="769028" cy="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73" name="Connecteur droit 272">
                                    <a:extLst>
                                      <a:ext uri="{FF2B5EF4-FFF2-40B4-BE49-F238E27FC236}">
                                        <a16:creationId xmlns:a16="http://schemas.microsoft.com/office/drawing/2014/main" id="{11BF8064-2630-4404-A4ED-2D4664783327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919905" y="4415817"/>
                                    <a:ext cx="0" cy="384514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  <p:cxnSp>
                                <p:nvCxnSpPr>
                                  <p:cNvPr id="274" name="Connecteur droit 273">
                                    <a:extLst>
                                      <a:ext uri="{FF2B5EF4-FFF2-40B4-BE49-F238E27FC236}">
                                        <a16:creationId xmlns:a16="http://schemas.microsoft.com/office/drawing/2014/main" id="{88AF6DF1-7F8A-4EE1-93AF-9C461090CBB7}"/>
                                      </a:ext>
                                    </a:extLst>
                                  </p:cNvPr>
                                  <p:cNvCxnSpPr/>
                                  <p:nvPr/>
                                </p:nvCxnSpPr>
                                <p:spPr>
                                  <a:xfrm>
                                    <a:off x="1685517" y="4448364"/>
                                    <a:ext cx="0" cy="360000"/>
                                  </a:xfrm>
                                  <a:prstGeom prst="line">
                                    <a:avLst/>
                                  </a:prstGeom>
                                  <a:solidFill>
                                    <a:schemeClr val="tx1"/>
                                  </a:solidFill>
                                  <a:ln w="19050"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  <p:grpSp>
                              <p:nvGrpSpPr>
                                <p:cNvPr id="2" name="Groupe 1">
                                  <a:extLst>
                                    <a:ext uri="{FF2B5EF4-FFF2-40B4-BE49-F238E27FC236}">
                                      <a16:creationId xmlns:a16="http://schemas.microsoft.com/office/drawing/2014/main" id="{BC5AF8B8-ABF9-4C01-92C6-1D3B8240BCA8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9767467" y="5168857"/>
                                  <a:ext cx="1536192" cy="483628"/>
                                  <a:chOff x="8627070" y="5157352"/>
                                  <a:chExt cx="1536192" cy="483628"/>
                                </a:xfrm>
                              </p:grpSpPr>
                              <p:sp>
                                <p:nvSpPr>
                                  <p:cNvPr id="306" name="Ellipse 305">
                                    <a:extLst>
                                      <a:ext uri="{FF2B5EF4-FFF2-40B4-BE49-F238E27FC236}">
                                        <a16:creationId xmlns:a16="http://schemas.microsoft.com/office/drawing/2014/main" id="{0C987D41-8262-4B66-8D01-D8EC1F18993C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8627070" y="5171280"/>
                                    <a:ext cx="469656" cy="469700"/>
                                  </a:xfrm>
                                  <a:prstGeom prst="ellipse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/>
                                  </a:p>
                                </p:txBody>
                              </p:sp>
                              <p:sp>
                                <p:nvSpPr>
                                  <p:cNvPr id="307" name="Ellipse 306">
                                    <a:extLst>
                                      <a:ext uri="{FF2B5EF4-FFF2-40B4-BE49-F238E27FC236}">
                                        <a16:creationId xmlns:a16="http://schemas.microsoft.com/office/drawing/2014/main" id="{22B8AE03-5D4F-4D52-90C7-799E58DA6115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9156323" y="5157352"/>
                                    <a:ext cx="469656" cy="469700"/>
                                  </a:xfrm>
                                  <a:prstGeom prst="ellipse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/>
                                  </a:p>
                                </p:txBody>
                              </p:sp>
                              <p:sp>
                                <p:nvSpPr>
                                  <p:cNvPr id="308" name="Ellipse 307">
                                    <a:extLst>
                                      <a:ext uri="{FF2B5EF4-FFF2-40B4-BE49-F238E27FC236}">
                                        <a16:creationId xmlns:a16="http://schemas.microsoft.com/office/drawing/2014/main" id="{48D7F737-8234-4ECA-A446-46E8D1D1EE39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9693606" y="5164656"/>
                                    <a:ext cx="469656" cy="469700"/>
                                  </a:xfrm>
                                  <a:prstGeom prst="ellipse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solidFill>
                                      <a:schemeClr val="tx1"/>
                                    </a:solidFill>
                                  </a:ln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endParaRPr lang="fr-FR" sz="1600"/>
                                  </a:p>
                                </p:txBody>
                              </p:sp>
                            </p:grpSp>
                            <p:cxnSp>
                              <p:nvCxnSpPr>
                                <p:cNvPr id="309" name="Connecteur droit 308">
                                  <a:extLst>
                                    <a:ext uri="{FF2B5EF4-FFF2-40B4-BE49-F238E27FC236}">
                                      <a16:creationId xmlns:a16="http://schemas.microsoft.com/office/drawing/2014/main" id="{E50827CC-758D-4505-997B-27F91ECC3675}"/>
                                    </a:ext>
                                  </a:extLst>
                                </p:cNvPr>
                                <p:cNvCxnSpPr/>
                                <p:nvPr/>
                              </p:nvCxnSpPr>
                              <p:spPr>
                                <a:xfrm>
                                  <a:off x="11066426" y="4934967"/>
                                  <a:ext cx="0" cy="256023"/>
                                </a:xfrm>
                                <a:prstGeom prst="line">
                                  <a:avLst/>
                                </a:prstGeom>
                                <a:solidFill>
                                  <a:schemeClr val="tx1"/>
                                </a:solidFill>
                                <a:ln w="19050">
                                  <a:solidFill>
                                    <a:schemeClr val="tx1"/>
                                  </a:solidFill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</p:grpSp>
                        </p:grpSp>
                        <p:grpSp>
                          <p:nvGrpSpPr>
                            <p:cNvPr id="323" name="Groupe 322">
                              <a:extLst>
                                <a:ext uri="{FF2B5EF4-FFF2-40B4-BE49-F238E27FC236}">
                                  <a16:creationId xmlns:a16="http://schemas.microsoft.com/office/drawing/2014/main" id="{8572D667-DF9F-40F2-8BE2-CC213D68734E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2534376" y="1297509"/>
                              <a:ext cx="6780684" cy="1160961"/>
                              <a:chOff x="1142302" y="1653598"/>
                              <a:chExt cx="10011221" cy="1714081"/>
                            </a:xfrm>
                          </p:grpSpPr>
                          <p:cxnSp>
                            <p:nvCxnSpPr>
                              <p:cNvPr id="313" name="Connecteur droit 312">
                                <a:extLst>
                                  <a:ext uri="{FF2B5EF4-FFF2-40B4-BE49-F238E27FC236}">
                                    <a16:creationId xmlns:a16="http://schemas.microsoft.com/office/drawing/2014/main" id="{7E16EAB1-C134-4918-B6A1-9E2C9C2220CD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4930329" y="2296198"/>
                                <a:ext cx="0" cy="3780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14" name="Connecteur droit 313">
                                <a:extLst>
                                  <a:ext uri="{FF2B5EF4-FFF2-40B4-BE49-F238E27FC236}">
                                    <a16:creationId xmlns:a16="http://schemas.microsoft.com/office/drawing/2014/main" id="{B5E0F292-BED3-40ED-9DE6-435AA3740EB9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1153523" y="2296197"/>
                                <a:ext cx="0" cy="3780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15" name="Connecteur droit 314">
                                <a:extLst>
                                  <a:ext uri="{FF2B5EF4-FFF2-40B4-BE49-F238E27FC236}">
                                    <a16:creationId xmlns:a16="http://schemas.microsoft.com/office/drawing/2014/main" id="{6611FF58-484F-470A-815A-50DF6CDA3F19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4087332" y="1653598"/>
                                <a:ext cx="0" cy="10206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16" name="Connecteur droit 315">
                                <a:extLst>
                                  <a:ext uri="{FF2B5EF4-FFF2-40B4-BE49-F238E27FC236}">
                                    <a16:creationId xmlns:a16="http://schemas.microsoft.com/office/drawing/2014/main" id="{4146C6D6-BFC6-44F3-A028-EB3F0634284E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0052293" y="1653598"/>
                                <a:ext cx="0" cy="10206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17" name="Connecteur droit 316">
                                <a:extLst>
                                  <a:ext uri="{FF2B5EF4-FFF2-40B4-BE49-F238E27FC236}">
                                    <a16:creationId xmlns:a16="http://schemas.microsoft.com/office/drawing/2014/main" id="{905078D3-2091-44BA-BB83-62FEF25529D6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489009" y="1653598"/>
                                <a:ext cx="8568000" cy="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318" name="Ellipse 317">
                                <a:extLst>
                                  <a:ext uri="{FF2B5EF4-FFF2-40B4-BE49-F238E27FC236}">
                                    <a16:creationId xmlns:a16="http://schemas.microsoft.com/office/drawing/2014/main" id="{836DDE4D-441F-48D0-B484-64C2A6635AF0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142302" y="2674198"/>
                                <a:ext cx="693415" cy="693481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/>
                              </a:p>
                            </p:txBody>
                          </p:sp>
                          <p:sp>
                            <p:nvSpPr>
                              <p:cNvPr id="319" name="Ellipse 318">
                                <a:extLst>
                                  <a:ext uri="{FF2B5EF4-FFF2-40B4-BE49-F238E27FC236}">
                                    <a16:creationId xmlns:a16="http://schemas.microsoft.com/office/drawing/2014/main" id="{CC3DED51-3681-444D-B188-4C870C131250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402599" y="2674197"/>
                                <a:ext cx="693415" cy="693481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/>
                              </a:p>
                            </p:txBody>
                          </p:sp>
                          <p:cxnSp>
                            <p:nvCxnSpPr>
                              <p:cNvPr id="320" name="Connecteur droit 319">
                                <a:extLst>
                                  <a:ext uri="{FF2B5EF4-FFF2-40B4-BE49-F238E27FC236}">
                                    <a16:creationId xmlns:a16="http://schemas.microsoft.com/office/drawing/2014/main" id="{322296B2-3FB4-4F39-ADAC-2FFE8E4A6CE8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2749306" y="1653598"/>
                                <a:ext cx="0" cy="10206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cxnSp>
                            <p:nvCxnSpPr>
                              <p:cNvPr id="321" name="Connecteur droit 320">
                                <a:extLst>
                                  <a:ext uri="{FF2B5EF4-FFF2-40B4-BE49-F238E27FC236}">
                                    <a16:creationId xmlns:a16="http://schemas.microsoft.com/office/drawing/2014/main" id="{A2C9543B-4E54-46D5-BCC9-46E19765F013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495811" y="1653598"/>
                                <a:ext cx="0" cy="1020600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cxnSp>
                          <p:nvCxnSpPr>
                            <p:cNvPr id="6" name="Connecteur droit avec flèche 5">
                              <a:extLst>
                                <a:ext uri="{FF2B5EF4-FFF2-40B4-BE49-F238E27FC236}">
                                  <a16:creationId xmlns:a16="http://schemas.microsoft.com/office/drawing/2014/main" id="{52E2D7AA-7743-4168-88F3-AF64013663D1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flipV="1">
                              <a:off x="1795477" y="4166842"/>
                              <a:ext cx="154778" cy="175869"/>
                            </a:xfrm>
                            <a:prstGeom prst="straightConnector1">
                              <a:avLst/>
                            </a:prstGeom>
                            <a:ln w="28575">
                              <a:solidFill>
                                <a:schemeClr val="tx1"/>
                              </a:solidFill>
                              <a:tailEnd type="triangle"/>
                            </a:ln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5" name="ZoneTexte 4">
                              <a:extLst>
                                <a:ext uri="{FF2B5EF4-FFF2-40B4-BE49-F238E27FC236}">
                                  <a16:creationId xmlns:a16="http://schemas.microsoft.com/office/drawing/2014/main" id="{059DA5C4-80F9-45A8-9566-85B2B35C90A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323148" y="4219754"/>
                              <a:ext cx="588852" cy="41454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PTC</a:t>
                              </a:r>
                            </a:p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(51)</a:t>
                              </a:r>
                            </a:p>
                          </p:txBody>
                        </p:sp>
                        <p:sp>
                          <p:nvSpPr>
                            <p:cNvPr id="115" name="ZoneTexte 114">
                              <a:extLst>
                                <a:ext uri="{FF2B5EF4-FFF2-40B4-BE49-F238E27FC236}">
                                  <a16:creationId xmlns:a16="http://schemas.microsoft.com/office/drawing/2014/main" id="{B3A5EC41-B3E6-4AF3-BBD7-5772AA6211A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051958" y="4214328"/>
                              <a:ext cx="588852" cy="41454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PTC</a:t>
                              </a:r>
                            </a:p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(36)</a:t>
                              </a:r>
                            </a:p>
                          </p:txBody>
                        </p:sp>
                        <p:sp>
                          <p:nvSpPr>
                            <p:cNvPr id="116" name="ZoneTexte 115">
                              <a:extLst>
                                <a:ext uri="{FF2B5EF4-FFF2-40B4-BE49-F238E27FC236}">
                                  <a16:creationId xmlns:a16="http://schemas.microsoft.com/office/drawing/2014/main" id="{981969C7-3903-4AA9-AE02-CEE6AD2BB07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9273815" y="2566191"/>
                              <a:ext cx="588852" cy="41454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PTC</a:t>
                              </a:r>
                            </a:p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(68)</a:t>
                              </a:r>
                            </a:p>
                          </p:txBody>
                        </p:sp>
                        <p:sp>
                          <p:nvSpPr>
                            <p:cNvPr id="117" name="ZoneTexte 116">
                              <a:extLst>
                                <a:ext uri="{FF2B5EF4-FFF2-40B4-BE49-F238E27FC236}">
                                  <a16:creationId xmlns:a16="http://schemas.microsoft.com/office/drawing/2014/main" id="{9E7532B1-DADA-4AD7-A87A-67C4FEDDA431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5309967" y="4310570"/>
                              <a:ext cx="588852" cy="41454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PTC</a:t>
                              </a:r>
                            </a:p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(54)</a:t>
                              </a:r>
                            </a:p>
                          </p:txBody>
                        </p:sp>
                        <p:sp>
                          <p:nvSpPr>
                            <p:cNvPr id="118" name="ZoneTexte 117">
                              <a:extLst>
                                <a:ext uri="{FF2B5EF4-FFF2-40B4-BE49-F238E27FC236}">
                                  <a16:creationId xmlns:a16="http://schemas.microsoft.com/office/drawing/2014/main" id="{C18A4AB4-36D9-41F0-B80B-F77BF6D36DD4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2220409" y="4144322"/>
                              <a:ext cx="938268" cy="58078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/>
                                <a:t>PTC (37) </a:t>
                              </a:r>
                            </a:p>
                            <a:p>
                              <a:pPr>
                                <a:lnSpc>
                                  <a:spcPct val="80000"/>
                                </a:lnSpc>
                              </a:pPr>
                              <a:r>
                                <a:rPr lang="fr-FR" sz="1600" dirty="0" err="1"/>
                                <a:t>Breast</a:t>
                              </a:r>
                              <a:r>
                                <a:rPr lang="fr-FR" sz="1600" dirty="0"/>
                                <a:t> cancer(43)</a:t>
                              </a:r>
                            </a:p>
                          </p:txBody>
                        </p:sp>
                      </p:grpSp>
                      <p:grpSp>
                        <p:nvGrpSpPr>
                          <p:cNvPr id="13" name="Groupe 12">
                            <a:extLst>
                              <a:ext uri="{FF2B5EF4-FFF2-40B4-BE49-F238E27FC236}">
                                <a16:creationId xmlns:a16="http://schemas.microsoft.com/office/drawing/2014/main" id="{16E4A2C9-69EF-44F3-954D-21A17C36C891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0145370" y="1353326"/>
                            <a:ext cx="1271552" cy="877218"/>
                            <a:chOff x="10145370" y="1353326"/>
                            <a:chExt cx="1271552" cy="877218"/>
                          </a:xfrm>
                        </p:grpSpPr>
                        <p:grpSp>
                          <p:nvGrpSpPr>
                            <p:cNvPr id="8" name="Groupe 7">
                              <a:extLst>
                                <a:ext uri="{FF2B5EF4-FFF2-40B4-BE49-F238E27FC236}">
                                  <a16:creationId xmlns:a16="http://schemas.microsoft.com/office/drawing/2014/main" id="{A1260649-7823-45A8-A6DB-A0E17F01023C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0145370" y="1353326"/>
                              <a:ext cx="564750" cy="859861"/>
                              <a:chOff x="10650680" y="1370683"/>
                              <a:chExt cx="564750" cy="859861"/>
                            </a:xfrm>
                          </p:grpSpPr>
                          <p:sp>
                            <p:nvSpPr>
                              <p:cNvPr id="120" name="Ellipse 119">
                                <a:extLst>
                                  <a:ext uri="{FF2B5EF4-FFF2-40B4-BE49-F238E27FC236}">
                                    <a16:creationId xmlns:a16="http://schemas.microsoft.com/office/drawing/2014/main" id="{1E339570-F45D-4EEA-8A88-198EC97A5DB1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0654824" y="1674027"/>
                                <a:ext cx="556463" cy="556517"/>
                              </a:xfrm>
                              <a:prstGeom prst="ellipse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endParaRPr lang="fr-FR" sz="1600"/>
                              </a:p>
                            </p:txBody>
                          </p:sp>
                          <p:cxnSp>
                            <p:nvCxnSpPr>
                              <p:cNvPr id="121" name="Connecteur droit 120">
                                <a:extLst>
                                  <a:ext uri="{FF2B5EF4-FFF2-40B4-BE49-F238E27FC236}">
                                    <a16:creationId xmlns:a16="http://schemas.microsoft.com/office/drawing/2014/main" id="{166542C4-3C9F-4775-B72A-50F92224490A}"/>
                                  </a:ext>
                                </a:extLst>
                              </p:cNvPr>
                              <p:cNvCxnSpPr/>
                              <p:nvPr/>
                            </p:nvCxnSpPr>
                            <p:spPr>
                              <a:xfrm>
                                <a:off x="10933055" y="1370683"/>
                                <a:ext cx="0" cy="303344"/>
                              </a:xfrm>
                              <a:prstGeom prst="line">
                                <a:avLst/>
                              </a:prstGeom>
                              <a:solidFill>
                                <a:schemeClr val="tx1"/>
                              </a:solidFill>
                              <a:ln w="19050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  <p:sp>
                            <p:nvSpPr>
                              <p:cNvPr id="122" name="ZoneTexte 121">
                                <a:extLst>
                                  <a:ext uri="{FF2B5EF4-FFF2-40B4-BE49-F238E27FC236}">
                                    <a16:creationId xmlns:a16="http://schemas.microsoft.com/office/drawing/2014/main" id="{98A7F7E8-8780-4247-8F8E-2AAA90FC994F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650680" y="1785289"/>
                                <a:ext cx="564750" cy="33855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ctr"/>
                                <a:r>
                                  <a:rPr lang="fr-FR" sz="1600" dirty="0"/>
                                  <a:t>8</a:t>
                                </a:r>
                              </a:p>
                            </p:txBody>
                          </p:sp>
                        </p:grpSp>
                        <p:cxnSp>
                          <p:nvCxnSpPr>
                            <p:cNvPr id="123" name="Connecteur droit 122">
                              <a:extLst>
                                <a:ext uri="{FF2B5EF4-FFF2-40B4-BE49-F238E27FC236}">
                                  <a16:creationId xmlns:a16="http://schemas.microsoft.com/office/drawing/2014/main" id="{11242DF1-A751-44E6-8EEE-C8A8F114F49B}"/>
                                </a:ext>
                              </a:extLst>
                            </p:cNvPr>
                            <p:cNvCxnSpPr/>
                            <p:nvPr/>
                          </p:nvCxnSpPr>
                          <p:spPr>
                            <a:xfrm>
                              <a:off x="11146679" y="1362005"/>
                              <a:ext cx="0" cy="324000"/>
                            </a:xfrm>
                            <a:prstGeom prst="line">
                              <a:avLst/>
                            </a:prstGeom>
                            <a:solidFill>
                              <a:schemeClr val="tx1"/>
                            </a:solidFill>
                            <a:ln w="190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124" name="Rectangle 123">
                              <a:extLst>
                                <a:ext uri="{FF2B5EF4-FFF2-40B4-BE49-F238E27FC236}">
                                  <a16:creationId xmlns:a16="http://schemas.microsoft.com/office/drawing/2014/main" id="{64806EB1-00F5-45E5-BEB4-CFFB65C9945C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10857512" y="1674027"/>
                              <a:ext cx="556463" cy="556517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endParaRPr lang="fr-FR" sz="1600" dirty="0"/>
                            </a:p>
                          </p:txBody>
                        </p:sp>
                        <p:sp>
                          <p:nvSpPr>
                            <p:cNvPr id="126" name="ZoneTexte 125">
                              <a:extLst>
                                <a:ext uri="{FF2B5EF4-FFF2-40B4-BE49-F238E27FC236}">
                                  <a16:creationId xmlns:a16="http://schemas.microsoft.com/office/drawing/2014/main" id="{85A7367A-F974-4F8C-8E7B-DE93A180AAF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0852172" y="1764623"/>
                              <a:ext cx="564750" cy="33855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fr-FR" sz="1600" dirty="0"/>
                                <a:t>4</a:t>
                              </a:r>
                            </a:p>
                          </p:txBody>
                        </p:sp>
                      </p:grpSp>
                    </p:grpSp>
                    <p:sp>
                      <p:nvSpPr>
                        <p:cNvPr id="133" name="ZoneTexte 132">
                          <a:extLst>
                            <a:ext uri="{FF2B5EF4-FFF2-40B4-BE49-F238E27FC236}">
                              <a16:creationId xmlns:a16="http://schemas.microsoft.com/office/drawing/2014/main" id="{3F49CD01-1F98-40B4-AEA0-FEA3A4AB208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467597" y="5972069"/>
                          <a:ext cx="1269667" cy="4911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Multinodular goitre</a:t>
                          </a:r>
                        </a:p>
                      </p:txBody>
                    </p:sp>
                    <p:sp>
                      <p:nvSpPr>
                        <p:cNvPr id="134" name="ZoneTexte 133">
                          <a:extLst>
                            <a:ext uri="{FF2B5EF4-FFF2-40B4-BE49-F238E27FC236}">
                              <a16:creationId xmlns:a16="http://schemas.microsoft.com/office/drawing/2014/main" id="{6F5EBFC7-C18E-44E1-A443-3838D6D2848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646077" y="5965743"/>
                          <a:ext cx="1269667" cy="4911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Multinodular goitre</a:t>
                          </a:r>
                        </a:p>
                      </p:txBody>
                    </p:sp>
                    <p:grpSp>
                      <p:nvGrpSpPr>
                        <p:cNvPr id="23" name="Groupe 22">
                          <a:extLst>
                            <a:ext uri="{FF2B5EF4-FFF2-40B4-BE49-F238E27FC236}">
                              <a16:creationId xmlns:a16="http://schemas.microsoft.com/office/drawing/2014/main" id="{BB67258E-4B8C-4F5D-AE85-5DD7B37260F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691974" y="1362005"/>
                          <a:ext cx="8463581" cy="3506617"/>
                          <a:chOff x="2691974" y="1362005"/>
                          <a:chExt cx="8463581" cy="3506617"/>
                        </a:xfrm>
                      </p:grpSpPr>
                      <p:cxnSp>
                        <p:nvCxnSpPr>
                          <p:cNvPr id="10" name="Connecteur droit 9">
                            <a:extLst>
                              <a:ext uri="{FF2B5EF4-FFF2-40B4-BE49-F238E27FC236}">
                                <a16:creationId xmlns:a16="http://schemas.microsoft.com/office/drawing/2014/main" id="{845C0F67-D07B-4F5E-8A73-B81868891D9F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4646077" y="1362005"/>
                            <a:ext cx="6509478" cy="0"/>
                          </a:xfrm>
                          <a:prstGeom prst="line">
                            <a:avLst/>
                          </a:prstGeom>
                          <a:ln w="19050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135" name="ZoneTexte 134">
                            <a:extLst>
                              <a:ext uri="{FF2B5EF4-FFF2-40B4-BE49-F238E27FC236}">
                                <a16:creationId xmlns:a16="http://schemas.microsoft.com/office/drawing/2014/main" id="{B6E5294D-5A25-4400-91C9-41ECC28B3E9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662133" y="2351967"/>
                            <a:ext cx="900758" cy="49116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>
                              <a:lnSpc>
                                <a:spcPct val="80000"/>
                              </a:lnSpc>
                            </a:pPr>
                            <a:r>
                              <a:rPr lang="en-GB" sz="1600" dirty="0"/>
                              <a:t>Thyroid Benign</a:t>
                            </a:r>
                          </a:p>
                        </p:txBody>
                      </p:sp>
                      <p:sp>
                        <p:nvSpPr>
                          <p:cNvPr id="136" name="ZoneTexte 135">
                            <a:extLst>
                              <a:ext uri="{FF2B5EF4-FFF2-40B4-BE49-F238E27FC236}">
                                <a16:creationId xmlns:a16="http://schemas.microsoft.com/office/drawing/2014/main" id="{BC1E6B9D-B645-4BF1-BB0D-5C8E1B31269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691974" y="4530068"/>
                            <a:ext cx="1302020" cy="33855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GB" sz="1600" dirty="0"/>
                              <a:t>Hyperthyroid</a:t>
                            </a:r>
                          </a:p>
                        </p:txBody>
                      </p:sp>
                    </p:grpSp>
                  </p:grpSp>
                  <p:grpSp>
                    <p:nvGrpSpPr>
                      <p:cNvPr id="27" name="Groupe 26">
                        <a:extLst>
                          <a:ext uri="{FF2B5EF4-FFF2-40B4-BE49-F238E27FC236}">
                            <a16:creationId xmlns:a16="http://schemas.microsoft.com/office/drawing/2014/main" id="{A8BDF640-2584-4E0C-B9BE-776E8C05290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537000" y="1908847"/>
                        <a:ext cx="7205161" cy="3434565"/>
                        <a:chOff x="3537000" y="1908847"/>
                        <a:chExt cx="7205161" cy="3434565"/>
                      </a:xfrm>
                    </p:grpSpPr>
                    <p:cxnSp>
                      <p:nvCxnSpPr>
                        <p:cNvPr id="160" name="Connecteur droit 159">
                          <a:extLst>
                            <a:ext uri="{FF2B5EF4-FFF2-40B4-BE49-F238E27FC236}">
                              <a16:creationId xmlns:a16="http://schemas.microsoft.com/office/drawing/2014/main" id="{9555D9E8-E65F-47E6-9B39-4D24A2BDE57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4833194" y="2791616"/>
                          <a:ext cx="0" cy="338641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6" name="Ellipse 165">
                          <a:extLst>
                            <a:ext uri="{FF2B5EF4-FFF2-40B4-BE49-F238E27FC236}">
                              <a16:creationId xmlns:a16="http://schemas.microsoft.com/office/drawing/2014/main" id="{6FCF7832-03D9-4B78-830E-5A310FEA940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903477" y="1925642"/>
                          <a:ext cx="556463" cy="556517"/>
                        </a:xfrm>
                        <a:prstGeom prst="ellipse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1600"/>
                        </a:p>
                      </p:txBody>
                    </p:sp>
                    <p:sp>
                      <p:nvSpPr>
                        <p:cNvPr id="169" name="Rectangle 168">
                          <a:extLst>
                            <a:ext uri="{FF2B5EF4-FFF2-40B4-BE49-F238E27FC236}">
                              <a16:creationId xmlns:a16="http://schemas.microsoft.com/office/drawing/2014/main" id="{96019B32-D720-4B9C-8F2D-034EF59FF68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84964" y="1908847"/>
                          <a:ext cx="556463" cy="556517"/>
                        </a:xfrm>
                        <a:prstGeom prst="rect">
                          <a:avLst/>
                        </a:prstGeom>
                        <a:solidFill>
                          <a:srgbClr val="E9DBF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1600" dirty="0"/>
                        </a:p>
                      </p:txBody>
                    </p:sp>
                    <p:cxnSp>
                      <p:nvCxnSpPr>
                        <p:cNvPr id="170" name="Connecteur droit 169">
                          <a:extLst>
                            <a:ext uri="{FF2B5EF4-FFF2-40B4-BE49-F238E27FC236}">
                              <a16:creationId xmlns:a16="http://schemas.microsoft.com/office/drawing/2014/main" id="{D572FA97-52C9-4A47-BFB8-50E574BB8BD6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4471676" y="2788559"/>
                          <a:ext cx="720000" cy="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71" name="Connecteur droit 170">
                          <a:extLst>
                            <a:ext uri="{FF2B5EF4-FFF2-40B4-BE49-F238E27FC236}">
                              <a16:creationId xmlns:a16="http://schemas.microsoft.com/office/drawing/2014/main" id="{DFDABD93-0029-4782-AADC-FE31BAAB78B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4477558" y="2464559"/>
                          <a:ext cx="0" cy="32400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73" name="Connecteur droit 172">
                          <a:extLst>
                            <a:ext uri="{FF2B5EF4-FFF2-40B4-BE49-F238E27FC236}">
                              <a16:creationId xmlns:a16="http://schemas.microsoft.com/office/drawing/2014/main" id="{43FCC9C6-1D07-4A87-8183-883ECE4B968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5181708" y="2485215"/>
                          <a:ext cx="1" cy="303344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74" name="Connecteur droit 173">
                          <a:extLst>
                            <a:ext uri="{FF2B5EF4-FFF2-40B4-BE49-F238E27FC236}">
                              <a16:creationId xmlns:a16="http://schemas.microsoft.com/office/drawing/2014/main" id="{F7C7705A-0084-4FD4-B220-DF4F47372556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0115415" y="2794671"/>
                          <a:ext cx="0" cy="82800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75" name="Ellipse 174">
                          <a:extLst>
                            <a:ext uri="{FF2B5EF4-FFF2-40B4-BE49-F238E27FC236}">
                              <a16:creationId xmlns:a16="http://schemas.microsoft.com/office/drawing/2014/main" id="{D1BCAD0E-C580-4202-A665-930B4FAC75E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0185698" y="1928698"/>
                          <a:ext cx="556463" cy="556517"/>
                        </a:xfrm>
                        <a:prstGeom prst="ellipse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1600"/>
                        </a:p>
                      </p:txBody>
                    </p:sp>
                    <p:sp>
                      <p:nvSpPr>
                        <p:cNvPr id="176" name="Rectangle 175">
                          <a:extLst>
                            <a:ext uri="{FF2B5EF4-FFF2-40B4-BE49-F238E27FC236}">
                              <a16:creationId xmlns:a16="http://schemas.microsoft.com/office/drawing/2014/main" id="{35E66EEA-EC11-4174-AC27-C2D48222BBA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467185" y="1911903"/>
                          <a:ext cx="556463" cy="556517"/>
                        </a:xfrm>
                        <a:prstGeom prst="rect">
                          <a:avLst/>
                        </a:prstGeom>
                        <a:solidFill>
                          <a:srgbClr val="E9DBF1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endParaRPr lang="fr-FR" sz="1600" dirty="0"/>
                        </a:p>
                      </p:txBody>
                    </p:sp>
                    <p:cxnSp>
                      <p:nvCxnSpPr>
                        <p:cNvPr id="177" name="Connecteur droit 176">
                          <a:extLst>
                            <a:ext uri="{FF2B5EF4-FFF2-40B4-BE49-F238E27FC236}">
                              <a16:creationId xmlns:a16="http://schemas.microsoft.com/office/drawing/2014/main" id="{1F06756C-BFF7-410E-93B6-E0B355C862C1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9753897" y="2791615"/>
                          <a:ext cx="720000" cy="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1" name="Connecteur droit 180">
                          <a:extLst>
                            <a:ext uri="{FF2B5EF4-FFF2-40B4-BE49-F238E27FC236}">
                              <a16:creationId xmlns:a16="http://schemas.microsoft.com/office/drawing/2014/main" id="{3BF92DC8-7483-463F-98D7-BA220E3B74B5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9759779" y="2467615"/>
                          <a:ext cx="0" cy="324000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2" name="Connecteur droit 181">
                          <a:extLst>
                            <a:ext uri="{FF2B5EF4-FFF2-40B4-BE49-F238E27FC236}">
                              <a16:creationId xmlns:a16="http://schemas.microsoft.com/office/drawing/2014/main" id="{1999D04E-15AA-4B8D-8D47-903598FE5A7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10463929" y="2488271"/>
                          <a:ext cx="1" cy="303344"/>
                        </a:xfrm>
                        <a:prstGeom prst="line">
                          <a:avLst/>
                        </a:prstGeom>
                        <a:solidFill>
                          <a:schemeClr val="tx1"/>
                        </a:solidFill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83" name="ZoneTexte 182">
                          <a:extLst>
                            <a:ext uri="{FF2B5EF4-FFF2-40B4-BE49-F238E27FC236}">
                              <a16:creationId xmlns:a16="http://schemas.microsoft.com/office/drawing/2014/main" id="{96CCF1AA-19C2-4CC3-8787-E5FED96BA48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023953" y="4630012"/>
                          <a:ext cx="996136" cy="7134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Prostate cancer</a:t>
                          </a:r>
                        </a:p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(72)</a:t>
                          </a:r>
                        </a:p>
                      </p:txBody>
                    </p:sp>
                    <p:sp>
                      <p:nvSpPr>
                        <p:cNvPr id="184" name="ZoneTexte 183">
                          <a:extLst>
                            <a:ext uri="{FF2B5EF4-FFF2-40B4-BE49-F238E27FC236}">
                              <a16:creationId xmlns:a16="http://schemas.microsoft.com/office/drawing/2014/main" id="{7A34054E-0C1C-4906-93A8-9DF516A5950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537000" y="2480030"/>
                          <a:ext cx="1072263" cy="4911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Prostate cancer</a:t>
                          </a:r>
                        </a:p>
                      </p:txBody>
                    </p:sp>
                    <p:sp>
                      <p:nvSpPr>
                        <p:cNvPr id="185" name="ZoneTexte 184">
                          <a:extLst>
                            <a:ext uri="{FF2B5EF4-FFF2-40B4-BE49-F238E27FC236}">
                              <a16:creationId xmlns:a16="http://schemas.microsoft.com/office/drawing/2014/main" id="{0831B897-2CAA-4B42-892D-03CA1D5A73C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981325" y="2481950"/>
                          <a:ext cx="895659" cy="49116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>
                            <a:lnSpc>
                              <a:spcPct val="80000"/>
                            </a:lnSpc>
                          </a:pPr>
                          <a:r>
                            <a:rPr lang="en-GB" sz="1600" dirty="0"/>
                            <a:t>Brain cancer</a:t>
                          </a:r>
                        </a:p>
                      </p:txBody>
                    </p:sp>
                  </p:grpSp>
                </p:grpSp>
                <p:grpSp>
                  <p:nvGrpSpPr>
                    <p:cNvPr id="29" name="Groupe 28">
                      <a:extLst>
                        <a:ext uri="{FF2B5EF4-FFF2-40B4-BE49-F238E27FC236}">
                          <a16:creationId xmlns:a16="http://schemas.microsoft.com/office/drawing/2014/main" id="{206B5F6A-1A3A-4C58-8D99-74639ED1604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4758" y="1945730"/>
                      <a:ext cx="458990" cy="6074049"/>
                      <a:chOff x="374758" y="1945730"/>
                      <a:chExt cx="458990" cy="6074049"/>
                    </a:xfrm>
                  </p:grpSpPr>
                  <p:grpSp>
                    <p:nvGrpSpPr>
                      <p:cNvPr id="25" name="Groupe 24">
                        <a:extLst>
                          <a:ext uri="{FF2B5EF4-FFF2-40B4-BE49-F238E27FC236}">
                            <a16:creationId xmlns:a16="http://schemas.microsoft.com/office/drawing/2014/main" id="{958588B9-8CCA-4150-B451-3CEB464430C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74758" y="1945730"/>
                        <a:ext cx="458990" cy="4281019"/>
                        <a:chOff x="95495" y="1782874"/>
                        <a:chExt cx="458990" cy="4281019"/>
                      </a:xfrm>
                    </p:grpSpPr>
                    <p:sp>
                      <p:nvSpPr>
                        <p:cNvPr id="152" name="ZoneTexte 151">
                          <a:extLst>
                            <a:ext uri="{FF2B5EF4-FFF2-40B4-BE49-F238E27FC236}">
                              <a16:creationId xmlns:a16="http://schemas.microsoft.com/office/drawing/2014/main" id="{CF726360-FACE-4433-8379-2F4AC8F414B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7735" y="5725339"/>
                          <a:ext cx="45675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600" b="1" dirty="0"/>
                            <a:t>III</a:t>
                          </a:r>
                        </a:p>
                      </p:txBody>
                    </p:sp>
                    <p:sp>
                      <p:nvSpPr>
                        <p:cNvPr id="154" name="ZoneTexte 153">
                          <a:extLst>
                            <a:ext uri="{FF2B5EF4-FFF2-40B4-BE49-F238E27FC236}">
                              <a16:creationId xmlns:a16="http://schemas.microsoft.com/office/drawing/2014/main" id="{65D1955B-F571-404E-8B6A-D312586ED83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5495" y="1782874"/>
                          <a:ext cx="45675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600" b="1" dirty="0"/>
                            <a:t>I</a:t>
                          </a:r>
                        </a:p>
                      </p:txBody>
                    </p:sp>
                    <p:sp>
                      <p:nvSpPr>
                        <p:cNvPr id="159" name="ZoneTexte 158">
                          <a:extLst>
                            <a:ext uri="{FF2B5EF4-FFF2-40B4-BE49-F238E27FC236}">
                              <a16:creationId xmlns:a16="http://schemas.microsoft.com/office/drawing/2014/main" id="{479C340E-6D7F-4DB0-9B64-F3BED6F116F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5495" y="3767314"/>
                          <a:ext cx="45675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600" b="1" dirty="0"/>
                            <a:t>II</a:t>
                          </a:r>
                        </a:p>
                      </p:txBody>
                    </p:sp>
                  </p:grpSp>
                  <p:sp>
                    <p:nvSpPr>
                      <p:cNvPr id="186" name="ZoneTexte 185">
                        <a:extLst>
                          <a:ext uri="{FF2B5EF4-FFF2-40B4-BE49-F238E27FC236}">
                            <a16:creationId xmlns:a16="http://schemas.microsoft.com/office/drawing/2014/main" id="{FD0998AF-F929-4AB9-AEDC-BFFA1C8CE79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4758" y="7681225"/>
                        <a:ext cx="456750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600" b="1" dirty="0"/>
                          <a:t>IV</a:t>
                        </a:r>
                      </a:p>
                    </p:txBody>
                  </p:sp>
                </p:grpSp>
              </p:grpSp>
              <p:grpSp>
                <p:nvGrpSpPr>
                  <p:cNvPr id="32" name="Groupe 31">
                    <a:extLst>
                      <a:ext uri="{FF2B5EF4-FFF2-40B4-BE49-F238E27FC236}">
                        <a16:creationId xmlns:a16="http://schemas.microsoft.com/office/drawing/2014/main" id="{417EF194-6090-4715-8F62-845E9BDD1BBD}"/>
                      </a:ext>
                    </a:extLst>
                  </p:cNvPr>
                  <p:cNvGrpSpPr/>
                  <p:nvPr/>
                </p:nvGrpSpPr>
                <p:grpSpPr>
                  <a:xfrm>
                    <a:off x="7492874" y="6346610"/>
                    <a:ext cx="2101221" cy="386015"/>
                    <a:chOff x="7492874" y="6346610"/>
                    <a:chExt cx="2101221" cy="386015"/>
                  </a:xfrm>
                </p:grpSpPr>
                <p:sp>
                  <p:nvSpPr>
                    <p:cNvPr id="199" name="ZoneTexte 198">
                      <a:extLst>
                        <a:ext uri="{FF2B5EF4-FFF2-40B4-BE49-F238E27FC236}">
                          <a16:creationId xmlns:a16="http://schemas.microsoft.com/office/drawing/2014/main" id="{B81B9114-0062-4866-875B-8890A23331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92874" y="6346610"/>
                      <a:ext cx="25567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6</a:t>
                      </a:r>
                    </a:p>
                  </p:txBody>
                </p:sp>
                <p:sp>
                  <p:nvSpPr>
                    <p:cNvPr id="215" name="ZoneTexte 214">
                      <a:extLst>
                        <a:ext uri="{FF2B5EF4-FFF2-40B4-BE49-F238E27FC236}">
                          <a16:creationId xmlns:a16="http://schemas.microsoft.com/office/drawing/2014/main" id="{E4449610-BDEA-4102-8EDC-11A8577D0FB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188605" y="6394071"/>
                      <a:ext cx="40549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600" dirty="0"/>
                        <a:t>7</a:t>
                      </a:r>
                    </a:p>
                  </p:txBody>
                </p:sp>
              </p:grpSp>
            </p:grpSp>
            <p:grpSp>
              <p:nvGrpSpPr>
                <p:cNvPr id="41" name="Groupe 40">
                  <a:extLst>
                    <a:ext uri="{FF2B5EF4-FFF2-40B4-BE49-F238E27FC236}">
                      <a16:creationId xmlns:a16="http://schemas.microsoft.com/office/drawing/2014/main" id="{D4EB5B56-293B-49B3-B109-8AC27DA2CF28}"/>
                    </a:ext>
                  </a:extLst>
                </p:cNvPr>
                <p:cNvGrpSpPr/>
                <p:nvPr/>
              </p:nvGrpSpPr>
              <p:grpSpPr>
                <a:xfrm>
                  <a:off x="1892239" y="4300834"/>
                  <a:ext cx="8661771" cy="3893423"/>
                  <a:chOff x="1892239" y="4300834"/>
                  <a:chExt cx="8661771" cy="3893423"/>
                </a:xfrm>
              </p:grpSpPr>
              <p:sp>
                <p:nvSpPr>
                  <p:cNvPr id="189" name="ZoneTexte 188">
                    <a:extLst>
                      <a:ext uri="{FF2B5EF4-FFF2-40B4-BE49-F238E27FC236}">
                        <a16:creationId xmlns:a16="http://schemas.microsoft.com/office/drawing/2014/main" id="{DD9682A0-BEF6-4C8E-BDCA-AFD81F8B79CA}"/>
                      </a:ext>
                    </a:extLst>
                  </p:cNvPr>
                  <p:cNvSpPr txBox="1"/>
                  <p:nvPr/>
                </p:nvSpPr>
                <p:spPr>
                  <a:xfrm>
                    <a:off x="5293407" y="4300834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1</a:t>
                    </a:r>
                  </a:p>
                </p:txBody>
              </p:sp>
              <p:sp>
                <p:nvSpPr>
                  <p:cNvPr id="191" name="ZoneTexte 190">
                    <a:extLst>
                      <a:ext uri="{FF2B5EF4-FFF2-40B4-BE49-F238E27FC236}">
                        <a16:creationId xmlns:a16="http://schemas.microsoft.com/office/drawing/2014/main" id="{8282E729-130F-4454-B5B0-EEBEEED8A635}"/>
                      </a:ext>
                    </a:extLst>
                  </p:cNvPr>
                  <p:cNvSpPr txBox="1"/>
                  <p:nvPr/>
                </p:nvSpPr>
                <p:spPr>
                  <a:xfrm>
                    <a:off x="10298333" y="4300834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2</a:t>
                    </a:r>
                  </a:p>
                </p:txBody>
              </p:sp>
              <p:sp>
                <p:nvSpPr>
                  <p:cNvPr id="192" name="ZoneTexte 191">
                    <a:extLst>
                      <a:ext uri="{FF2B5EF4-FFF2-40B4-BE49-F238E27FC236}">
                        <a16:creationId xmlns:a16="http://schemas.microsoft.com/office/drawing/2014/main" id="{D330C97E-4107-47B0-A84F-99D4A2816161}"/>
                      </a:ext>
                    </a:extLst>
                  </p:cNvPr>
                  <p:cNvSpPr txBox="1"/>
                  <p:nvPr/>
                </p:nvSpPr>
                <p:spPr>
                  <a:xfrm>
                    <a:off x="1892239" y="6401603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3</a:t>
                    </a:r>
                  </a:p>
                </p:txBody>
              </p:sp>
              <p:sp>
                <p:nvSpPr>
                  <p:cNvPr id="193" name="ZoneTexte 192">
                    <a:extLst>
                      <a:ext uri="{FF2B5EF4-FFF2-40B4-BE49-F238E27FC236}">
                        <a16:creationId xmlns:a16="http://schemas.microsoft.com/office/drawing/2014/main" id="{755D8718-7DBB-4761-80DB-F1C840B9C081}"/>
                      </a:ext>
                    </a:extLst>
                  </p:cNvPr>
                  <p:cNvSpPr txBox="1"/>
                  <p:nvPr/>
                </p:nvSpPr>
                <p:spPr>
                  <a:xfrm>
                    <a:off x="3622348" y="6383982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4</a:t>
                    </a:r>
                  </a:p>
                </p:txBody>
              </p:sp>
              <p:sp>
                <p:nvSpPr>
                  <p:cNvPr id="194" name="ZoneTexte 193">
                    <a:extLst>
                      <a:ext uri="{FF2B5EF4-FFF2-40B4-BE49-F238E27FC236}">
                        <a16:creationId xmlns:a16="http://schemas.microsoft.com/office/drawing/2014/main" id="{71960C33-8116-4FB9-B8E3-32EFF970E4E7}"/>
                      </a:ext>
                    </a:extLst>
                  </p:cNvPr>
                  <p:cNvSpPr txBox="1"/>
                  <p:nvPr/>
                </p:nvSpPr>
                <p:spPr>
                  <a:xfrm>
                    <a:off x="5606260" y="6378716"/>
                    <a:ext cx="25567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5</a:t>
                    </a:r>
                  </a:p>
                </p:txBody>
              </p:sp>
              <p:sp>
                <p:nvSpPr>
                  <p:cNvPr id="227" name="ZoneTexte 226">
                    <a:extLst>
                      <a:ext uri="{FF2B5EF4-FFF2-40B4-BE49-F238E27FC236}">
                        <a16:creationId xmlns:a16="http://schemas.microsoft.com/office/drawing/2014/main" id="{D6C03449-1295-4FC8-87A9-5D1601A48747}"/>
                      </a:ext>
                    </a:extLst>
                  </p:cNvPr>
                  <p:cNvSpPr txBox="1"/>
                  <p:nvPr/>
                </p:nvSpPr>
                <p:spPr>
                  <a:xfrm>
                    <a:off x="9985825" y="6399573"/>
                    <a:ext cx="40549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8</a:t>
                    </a:r>
                  </a:p>
                </p:txBody>
              </p:sp>
              <p:sp>
                <p:nvSpPr>
                  <p:cNvPr id="229" name="ZoneTexte 228">
                    <a:extLst>
                      <a:ext uri="{FF2B5EF4-FFF2-40B4-BE49-F238E27FC236}">
                        <a16:creationId xmlns:a16="http://schemas.microsoft.com/office/drawing/2014/main" id="{351C8790-CAF0-4BF7-9B50-F64EDBA89BAF}"/>
                      </a:ext>
                    </a:extLst>
                  </p:cNvPr>
                  <p:cNvSpPr txBox="1"/>
                  <p:nvPr/>
                </p:nvSpPr>
                <p:spPr>
                  <a:xfrm>
                    <a:off x="4637952" y="7855703"/>
                    <a:ext cx="40549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9</a:t>
                    </a:r>
                  </a:p>
                </p:txBody>
              </p:sp>
              <p:sp>
                <p:nvSpPr>
                  <p:cNvPr id="230" name="ZoneTexte 229">
                    <a:extLst>
                      <a:ext uri="{FF2B5EF4-FFF2-40B4-BE49-F238E27FC236}">
                        <a16:creationId xmlns:a16="http://schemas.microsoft.com/office/drawing/2014/main" id="{6A7A6735-AFFC-4921-9206-BEB5EBE7DD36}"/>
                      </a:ext>
                    </a:extLst>
                  </p:cNvPr>
                  <p:cNvSpPr txBox="1"/>
                  <p:nvPr/>
                </p:nvSpPr>
                <p:spPr>
                  <a:xfrm>
                    <a:off x="7486455" y="6682375"/>
                    <a:ext cx="130202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600" dirty="0"/>
                      <a:t>Hyperthyroid</a:t>
                    </a:r>
                  </a:p>
                </p:txBody>
              </p:sp>
              <p:sp>
                <p:nvSpPr>
                  <p:cNvPr id="231" name="ZoneTexte 230">
                    <a:extLst>
                      <a:ext uri="{FF2B5EF4-FFF2-40B4-BE49-F238E27FC236}">
                        <a16:creationId xmlns:a16="http://schemas.microsoft.com/office/drawing/2014/main" id="{14F65C4F-3F16-42D0-B173-E09729303CEE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491" y="7849418"/>
                    <a:ext cx="40549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600" dirty="0"/>
                      <a:t>10</a:t>
                    </a:r>
                  </a:p>
                </p:txBody>
              </p:sp>
            </p:grpSp>
          </p:grpSp>
          <p:sp>
            <p:nvSpPr>
              <p:cNvPr id="243" name="ZoneTexte 242">
                <a:extLst>
                  <a:ext uri="{FF2B5EF4-FFF2-40B4-BE49-F238E27FC236}">
                    <a16:creationId xmlns:a16="http://schemas.microsoft.com/office/drawing/2014/main" id="{12723345-FDD4-4003-A88B-E7D8D9F5D07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872669" y="5767671"/>
                <a:ext cx="626400" cy="6264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1600" dirty="0"/>
              </a:p>
            </p:txBody>
          </p:sp>
        </p:grp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DCCFEBB1-EBEF-4D9B-A7E1-90F06B9555D5}"/>
                </a:ext>
              </a:extLst>
            </p:cNvPr>
            <p:cNvGrpSpPr/>
            <p:nvPr/>
          </p:nvGrpSpPr>
          <p:grpSpPr>
            <a:xfrm>
              <a:off x="5573397" y="5797526"/>
              <a:ext cx="5063034" cy="635365"/>
              <a:chOff x="5573397" y="5797526"/>
              <a:chExt cx="5063034" cy="635365"/>
            </a:xfrm>
          </p:grpSpPr>
          <p:sp>
            <p:nvSpPr>
              <p:cNvPr id="187" name="ZoneTexte 186">
                <a:extLst>
                  <a:ext uri="{FF2B5EF4-FFF2-40B4-BE49-F238E27FC236}">
                    <a16:creationId xmlns:a16="http://schemas.microsoft.com/office/drawing/2014/main" id="{C5F77F12-C267-4710-A817-5B5B7EC05EC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573397" y="5797526"/>
                <a:ext cx="626400" cy="6264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1600" dirty="0"/>
              </a:p>
            </p:txBody>
          </p:sp>
          <p:sp>
            <p:nvSpPr>
              <p:cNvPr id="188" name="ZoneTexte 187">
                <a:extLst>
                  <a:ext uri="{FF2B5EF4-FFF2-40B4-BE49-F238E27FC236}">
                    <a16:creationId xmlns:a16="http://schemas.microsoft.com/office/drawing/2014/main" id="{3728F1CF-80BB-479C-B0AD-5D1C72CAC25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0010031" y="5806491"/>
                <a:ext cx="626400" cy="62640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fr-FR" sz="16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292050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6</TotalTime>
  <Words>147</Words>
  <Application>Microsoft Office PowerPoint</Application>
  <PresentationFormat>A3 (297 x 420 mm)</PresentationFormat>
  <Paragraphs>89</Paragraphs>
  <Slides>3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ygu ABBASOGLU</dc:creator>
  <cp:lastModifiedBy>Duygu ABBASOGLU</cp:lastModifiedBy>
  <cp:revision>40</cp:revision>
  <dcterms:created xsi:type="dcterms:W3CDTF">2025-02-05T16:18:47Z</dcterms:created>
  <dcterms:modified xsi:type="dcterms:W3CDTF">2025-06-06T09:15:40Z</dcterms:modified>
</cp:coreProperties>
</file>